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4"/>
  </p:sldMasterIdLst>
  <p:notesMasterIdLst>
    <p:notesMasterId r:id="rId9"/>
  </p:notesMasterIdLst>
  <p:sldIdLst>
    <p:sldId id="280" r:id="rId5"/>
    <p:sldId id="269" r:id="rId6"/>
    <p:sldId id="270" r:id="rId7"/>
    <p:sldId id="268" r:id="rId8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Pedro Granjo" initials="" lastIdx="2" clrIdx="0"/>
  <p:cmAuthor id="1" name="Pedro Mauritti Granjo" initials="PG" lastIdx="1" clrIdx="1">
    <p:extLst>
      <p:ext uri="{19B8F6BF-5375-455C-9EA6-DF929625EA0E}">
        <p15:presenceInfo xmlns:p15="http://schemas.microsoft.com/office/powerpoint/2012/main" userId="S::p.granjo@fct.unl.pt::cc7015fd-d343-4901-b4c6-21df2d4ac7a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2DC0B18-55E4-4365-BFA2-6CFA500E1748}" v="4" dt="2024-08-07T08:38:17.30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4" d="100"/>
          <a:sy n="124" d="100"/>
        </p:scale>
        <p:origin x="2118" y="-252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commentAuthors" Target="commentAuthor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edro Mauritti Granjo" userId="S::p.granjo@fct.unl.pt::cc7015fd-d343-4901-b4c6-21df2d4ac7a0" providerId="AD" clId="Web-{2AC45D12-2443-C181-34BB-E8053445C1E1}"/>
    <pc:docChg chg="delSld modSld">
      <pc:chgData name="Pedro Mauritti Granjo" userId="S::p.granjo@fct.unl.pt::cc7015fd-d343-4901-b4c6-21df2d4ac7a0" providerId="AD" clId="Web-{2AC45D12-2443-C181-34BB-E8053445C1E1}" dt="2023-03-31T17:57:38.812" v="181"/>
      <pc:docMkLst>
        <pc:docMk/>
      </pc:docMkLst>
      <pc:sldChg chg="del">
        <pc:chgData name="Pedro Mauritti Granjo" userId="S::p.granjo@fct.unl.pt::cc7015fd-d343-4901-b4c6-21df2d4ac7a0" providerId="AD" clId="Web-{2AC45D12-2443-C181-34BB-E8053445C1E1}" dt="2023-03-31T17:57:38.812" v="181"/>
        <pc:sldMkLst>
          <pc:docMk/>
          <pc:sldMk cId="0" sldId="267"/>
        </pc:sldMkLst>
      </pc:sldChg>
      <pc:sldChg chg="addSp modSp">
        <pc:chgData name="Pedro Mauritti Granjo" userId="S::p.granjo@fct.unl.pt::cc7015fd-d343-4901-b4c6-21df2d4ac7a0" providerId="AD" clId="Web-{2AC45D12-2443-C181-34BB-E8053445C1E1}" dt="2023-03-31T16:45:28.380" v="174" actId="1076"/>
        <pc:sldMkLst>
          <pc:docMk/>
          <pc:sldMk cId="2860821069" sldId="278"/>
        </pc:sldMkLst>
        <pc:spChg chg="add mod">
          <ac:chgData name="Pedro Mauritti Granjo" userId="S::p.granjo@fct.unl.pt::cc7015fd-d343-4901-b4c6-21df2d4ac7a0" providerId="AD" clId="Web-{2AC45D12-2443-C181-34BB-E8053445C1E1}" dt="2023-03-31T16:45:28.380" v="174" actId="1076"/>
          <ac:spMkLst>
            <pc:docMk/>
            <pc:sldMk cId="2860821069" sldId="278"/>
            <ac:spMk id="6" creationId="{12DA03D6-08FB-04E3-3596-597820281F85}"/>
          </ac:spMkLst>
        </pc:spChg>
        <pc:picChg chg="mod">
          <ac:chgData name="Pedro Mauritti Granjo" userId="S::p.granjo@fct.unl.pt::cc7015fd-d343-4901-b4c6-21df2d4ac7a0" providerId="AD" clId="Web-{2AC45D12-2443-C181-34BB-E8053445C1E1}" dt="2023-03-31T16:45:21.973" v="173" actId="1076"/>
          <ac:picMkLst>
            <pc:docMk/>
            <pc:sldMk cId="2860821069" sldId="278"/>
            <ac:picMk id="2" creationId="{19101E9C-9EE0-1590-DB68-A868FF2DEACB}"/>
          </ac:picMkLst>
        </pc:picChg>
      </pc:sldChg>
      <pc:sldChg chg="modSp">
        <pc:chgData name="Pedro Mauritti Granjo" userId="S::p.granjo@fct.unl.pt::cc7015fd-d343-4901-b4c6-21df2d4ac7a0" providerId="AD" clId="Web-{2AC45D12-2443-C181-34BB-E8053445C1E1}" dt="2023-03-31T16:46:29.882" v="180"/>
        <pc:sldMkLst>
          <pc:docMk/>
          <pc:sldMk cId="120033746" sldId="279"/>
        </pc:sldMkLst>
        <pc:spChg chg="mod">
          <ac:chgData name="Pedro Mauritti Granjo" userId="S::p.granjo@fct.unl.pt::cc7015fd-d343-4901-b4c6-21df2d4ac7a0" providerId="AD" clId="Web-{2AC45D12-2443-C181-34BB-E8053445C1E1}" dt="2023-03-31T16:42:52.140" v="85" actId="14100"/>
          <ac:spMkLst>
            <pc:docMk/>
            <pc:sldMk cId="120033746" sldId="279"/>
            <ac:spMk id="7" creationId="{CCA8EBAF-6819-ABAE-6141-40945D50709F}"/>
          </ac:spMkLst>
        </pc:spChg>
        <pc:graphicFrameChg chg="mod modGraphic">
          <ac:chgData name="Pedro Mauritti Granjo" userId="S::p.granjo@fct.unl.pt::cc7015fd-d343-4901-b4c6-21df2d4ac7a0" providerId="AD" clId="Web-{2AC45D12-2443-C181-34BB-E8053445C1E1}" dt="2023-03-31T16:46:29.882" v="180"/>
          <ac:graphicFrameMkLst>
            <pc:docMk/>
            <pc:sldMk cId="120033746" sldId="279"/>
            <ac:graphicFrameMk id="5" creationId="{90CA37FC-97AF-2170-4009-B24B8E3576CB}"/>
          </ac:graphicFrameMkLst>
        </pc:graphicFrameChg>
      </pc:sldChg>
    </pc:docChg>
  </pc:docChgLst>
  <pc:docChgLst>
    <pc:chgData name="Pedro Mauritti Granjo" userId="S::p.granjo@fct.unl.pt::cc7015fd-d343-4901-b4c6-21df2d4ac7a0" providerId="AD" clId="Web-{C2E149FB-04F3-CC7F-AAEA-590641B44450}"/>
    <pc:docChg chg="modSld">
      <pc:chgData name="Pedro Mauritti Granjo" userId="S::p.granjo@fct.unl.pt::cc7015fd-d343-4901-b4c6-21df2d4ac7a0" providerId="AD" clId="Web-{C2E149FB-04F3-CC7F-AAEA-590641B44450}" dt="2023-04-10T10:37:56.663" v="16" actId="1076"/>
      <pc:docMkLst>
        <pc:docMk/>
      </pc:docMkLst>
      <pc:sldChg chg="addSp delSp modSp">
        <pc:chgData name="Pedro Mauritti Granjo" userId="S::p.granjo@fct.unl.pt::cc7015fd-d343-4901-b4c6-21df2d4ac7a0" providerId="AD" clId="Web-{C2E149FB-04F3-CC7F-AAEA-590641B44450}" dt="2023-04-10T10:37:56.663" v="16" actId="1076"/>
        <pc:sldMkLst>
          <pc:docMk/>
          <pc:sldMk cId="2756113789" sldId="276"/>
        </pc:sldMkLst>
        <pc:spChg chg="mod">
          <ac:chgData name="Pedro Mauritti Granjo" userId="S::p.granjo@fct.unl.pt::cc7015fd-d343-4901-b4c6-21df2d4ac7a0" providerId="AD" clId="Web-{C2E149FB-04F3-CC7F-AAEA-590641B44450}" dt="2023-04-10T10:28:43.592" v="1" actId="1076"/>
          <ac:spMkLst>
            <pc:docMk/>
            <pc:sldMk cId="2756113789" sldId="276"/>
            <ac:spMk id="6" creationId="{1B3079FD-51CF-26B9-6E06-E4759DBA9CC8}"/>
          </ac:spMkLst>
        </pc:spChg>
        <pc:picChg chg="del">
          <ac:chgData name="Pedro Mauritti Granjo" userId="S::p.granjo@fct.unl.pt::cc7015fd-d343-4901-b4c6-21df2d4ac7a0" providerId="AD" clId="Web-{C2E149FB-04F3-CC7F-AAEA-590641B44450}" dt="2023-04-10T10:28:43.545" v="0"/>
          <ac:picMkLst>
            <pc:docMk/>
            <pc:sldMk cId="2756113789" sldId="276"/>
            <ac:picMk id="2" creationId="{B44CD487-1603-9C76-DD68-FA1C0442A0A3}"/>
          </ac:picMkLst>
        </pc:picChg>
        <pc:picChg chg="add del mod">
          <ac:chgData name="Pedro Mauritti Granjo" userId="S::p.granjo@fct.unl.pt::cc7015fd-d343-4901-b4c6-21df2d4ac7a0" providerId="AD" clId="Web-{C2E149FB-04F3-CC7F-AAEA-590641B44450}" dt="2023-04-10T10:37:32.256" v="8"/>
          <ac:picMkLst>
            <pc:docMk/>
            <pc:sldMk cId="2756113789" sldId="276"/>
            <ac:picMk id="3" creationId="{DC5656E5-C784-4CCE-41B2-666F5BFFAFDC}"/>
          </ac:picMkLst>
        </pc:picChg>
        <pc:picChg chg="add mod">
          <ac:chgData name="Pedro Mauritti Granjo" userId="S::p.granjo@fct.unl.pt::cc7015fd-d343-4901-b4c6-21df2d4ac7a0" providerId="AD" clId="Web-{C2E149FB-04F3-CC7F-AAEA-590641B44450}" dt="2023-04-10T10:37:56.663" v="16" actId="1076"/>
          <ac:picMkLst>
            <pc:docMk/>
            <pc:sldMk cId="2756113789" sldId="276"/>
            <ac:picMk id="5" creationId="{8312B0FD-7EF4-2CF5-9C8B-68AC7698A41E}"/>
          </ac:picMkLst>
        </pc:picChg>
      </pc:sldChg>
    </pc:docChg>
  </pc:docChgLst>
  <pc:docChgLst>
    <pc:chgData name="Pedro Mauritti Granjo" userId="S::p.granjo@fct.unl.pt::cc7015fd-d343-4901-b4c6-21df2d4ac7a0" providerId="AD" clId="Web-{F1BAA156-968E-E15D-C6AA-713B7BFCF559}"/>
    <pc:docChg chg="modSld">
      <pc:chgData name="Pedro Mauritti Granjo" userId="S::p.granjo@fct.unl.pt::cc7015fd-d343-4901-b4c6-21df2d4ac7a0" providerId="AD" clId="Web-{F1BAA156-968E-E15D-C6AA-713B7BFCF559}" dt="2023-04-14T11:04:33.494" v="4" actId="20577"/>
      <pc:docMkLst>
        <pc:docMk/>
      </pc:docMkLst>
      <pc:sldChg chg="modSp">
        <pc:chgData name="Pedro Mauritti Granjo" userId="S::p.granjo@fct.unl.pt::cc7015fd-d343-4901-b4c6-21df2d4ac7a0" providerId="AD" clId="Web-{F1BAA156-968E-E15D-C6AA-713B7BFCF559}" dt="2023-04-14T11:04:33.494" v="4" actId="20577"/>
        <pc:sldMkLst>
          <pc:docMk/>
          <pc:sldMk cId="0" sldId="269"/>
        </pc:sldMkLst>
        <pc:spChg chg="mod">
          <ac:chgData name="Pedro Mauritti Granjo" userId="S::p.granjo@fct.unl.pt::cc7015fd-d343-4901-b4c6-21df2d4ac7a0" providerId="AD" clId="Web-{F1BAA156-968E-E15D-C6AA-713B7BFCF559}" dt="2023-04-14T11:04:33.494" v="4" actId="20577"/>
          <ac:spMkLst>
            <pc:docMk/>
            <pc:sldMk cId="0" sldId="269"/>
            <ac:spMk id="4" creationId="{79DE6C02-1434-3F8D-8864-98C0D4B9495F}"/>
          </ac:spMkLst>
        </pc:spChg>
      </pc:sldChg>
    </pc:docChg>
  </pc:docChgLst>
  <pc:docChgLst>
    <pc:chgData name="Pedro Mauritti Granjo" userId="S::p.granjo@fct.unl.pt::cc7015fd-d343-4901-b4c6-21df2d4ac7a0" providerId="AD" clId="Web-{1559CFB2-3654-62B9-773B-3746A0D5A2AC}"/>
    <pc:docChg chg="delSld modSld">
      <pc:chgData name="Pedro Mauritti Granjo" userId="S::p.granjo@fct.unl.pt::cc7015fd-d343-4901-b4c6-21df2d4ac7a0" providerId="AD" clId="Web-{1559CFB2-3654-62B9-773B-3746A0D5A2AC}" dt="2023-08-07T18:14:52.756" v="10" actId="20577"/>
      <pc:docMkLst>
        <pc:docMk/>
      </pc:docMkLst>
      <pc:sldChg chg="modSp">
        <pc:chgData name="Pedro Mauritti Granjo" userId="S::p.granjo@fct.unl.pt::cc7015fd-d343-4901-b4c6-21df2d4ac7a0" providerId="AD" clId="Web-{1559CFB2-3654-62B9-773B-3746A0D5A2AC}" dt="2023-08-07T18:14:52.756" v="10" actId="20577"/>
        <pc:sldMkLst>
          <pc:docMk/>
          <pc:sldMk cId="0" sldId="268"/>
        </pc:sldMkLst>
        <pc:spChg chg="mod">
          <ac:chgData name="Pedro Mauritti Granjo" userId="S::p.granjo@fct.unl.pt::cc7015fd-d343-4901-b4c6-21df2d4ac7a0" providerId="AD" clId="Web-{1559CFB2-3654-62B9-773B-3746A0D5A2AC}" dt="2023-08-07T18:14:52.756" v="10" actId="20577"/>
          <ac:spMkLst>
            <pc:docMk/>
            <pc:sldMk cId="0" sldId="268"/>
            <ac:spMk id="4" creationId="{88BE49BC-7650-F1C7-8FD3-0BBABADD6A04}"/>
          </ac:spMkLst>
        </pc:spChg>
      </pc:sldChg>
      <pc:sldChg chg="modSp">
        <pc:chgData name="Pedro Mauritti Granjo" userId="S::p.granjo@fct.unl.pt::cc7015fd-d343-4901-b4c6-21df2d4ac7a0" providerId="AD" clId="Web-{1559CFB2-3654-62B9-773B-3746A0D5A2AC}" dt="2023-08-07T18:14:43.881" v="6" actId="20577"/>
        <pc:sldMkLst>
          <pc:docMk/>
          <pc:sldMk cId="0" sldId="269"/>
        </pc:sldMkLst>
        <pc:spChg chg="mod">
          <ac:chgData name="Pedro Mauritti Granjo" userId="S::p.granjo@fct.unl.pt::cc7015fd-d343-4901-b4c6-21df2d4ac7a0" providerId="AD" clId="Web-{1559CFB2-3654-62B9-773B-3746A0D5A2AC}" dt="2023-08-07T18:14:43.881" v="6" actId="20577"/>
          <ac:spMkLst>
            <pc:docMk/>
            <pc:sldMk cId="0" sldId="269"/>
            <ac:spMk id="4" creationId="{79DE6C02-1434-3F8D-8864-98C0D4B9495F}"/>
          </ac:spMkLst>
        </pc:spChg>
      </pc:sldChg>
      <pc:sldChg chg="modSp">
        <pc:chgData name="Pedro Mauritti Granjo" userId="S::p.granjo@fct.unl.pt::cc7015fd-d343-4901-b4c6-21df2d4ac7a0" providerId="AD" clId="Web-{1559CFB2-3654-62B9-773B-3746A0D5A2AC}" dt="2023-08-07T18:14:50.397" v="9" actId="20577"/>
        <pc:sldMkLst>
          <pc:docMk/>
          <pc:sldMk cId="3969417392" sldId="270"/>
        </pc:sldMkLst>
        <pc:spChg chg="mod">
          <ac:chgData name="Pedro Mauritti Granjo" userId="S::p.granjo@fct.unl.pt::cc7015fd-d343-4901-b4c6-21df2d4ac7a0" providerId="AD" clId="Web-{1559CFB2-3654-62B9-773B-3746A0D5A2AC}" dt="2023-08-07T18:14:50.397" v="9" actId="20577"/>
          <ac:spMkLst>
            <pc:docMk/>
            <pc:sldMk cId="3969417392" sldId="270"/>
            <ac:spMk id="3" creationId="{91024E88-419C-94D2-7F26-98D7B07B4005}"/>
          </ac:spMkLst>
        </pc:spChg>
      </pc:sldChg>
      <pc:sldChg chg="delSp del">
        <pc:chgData name="Pedro Mauritti Granjo" userId="S::p.granjo@fct.unl.pt::cc7015fd-d343-4901-b4c6-21df2d4ac7a0" providerId="AD" clId="Web-{1559CFB2-3654-62B9-773B-3746A0D5A2AC}" dt="2023-08-07T18:14:35.521" v="1"/>
        <pc:sldMkLst>
          <pc:docMk/>
          <pc:sldMk cId="746827180" sldId="274"/>
        </pc:sldMkLst>
        <pc:picChg chg="del">
          <ac:chgData name="Pedro Mauritti Granjo" userId="S::p.granjo@fct.unl.pt::cc7015fd-d343-4901-b4c6-21df2d4ac7a0" providerId="AD" clId="Web-{1559CFB2-3654-62B9-773B-3746A0D5A2AC}" dt="2023-08-07T18:14:34.318" v="0"/>
          <ac:picMkLst>
            <pc:docMk/>
            <pc:sldMk cId="746827180" sldId="274"/>
            <ac:picMk id="3" creationId="{573F61E3-FBFA-634C-E4AE-FD41349E113C}"/>
          </ac:picMkLst>
        </pc:picChg>
      </pc:sldChg>
      <pc:sldChg chg="modSp">
        <pc:chgData name="Pedro Mauritti Granjo" userId="S::p.granjo@fct.unl.pt::cc7015fd-d343-4901-b4c6-21df2d4ac7a0" providerId="AD" clId="Web-{1559CFB2-3654-62B9-773B-3746A0D5A2AC}" dt="2023-08-07T18:14:41.240" v="4" actId="20577"/>
        <pc:sldMkLst>
          <pc:docMk/>
          <pc:sldMk cId="2986738929" sldId="280"/>
        </pc:sldMkLst>
        <pc:spChg chg="mod">
          <ac:chgData name="Pedro Mauritti Granjo" userId="S::p.granjo@fct.unl.pt::cc7015fd-d343-4901-b4c6-21df2d4ac7a0" providerId="AD" clId="Web-{1559CFB2-3654-62B9-773B-3746A0D5A2AC}" dt="2023-08-07T18:14:41.240" v="4" actId="20577"/>
          <ac:spMkLst>
            <pc:docMk/>
            <pc:sldMk cId="2986738929" sldId="280"/>
            <ac:spMk id="3" creationId="{F75852C7-E70E-2BDC-0B24-DA113B485EC0}"/>
          </ac:spMkLst>
        </pc:spChg>
      </pc:sldChg>
    </pc:docChg>
  </pc:docChgLst>
  <pc:docChgLst>
    <pc:chgData name="Pedro Mauritti Granjo" userId="S::p.granjo@fct.unl.pt::cc7015fd-d343-4901-b4c6-21df2d4ac7a0" providerId="AD" clId="Web-{2A226F34-3111-83B1-CE02-DE00EEA9F32A}"/>
    <pc:docChg chg="addSld delSld modSld">
      <pc:chgData name="Pedro Mauritti Granjo" userId="S::p.granjo@fct.unl.pt::cc7015fd-d343-4901-b4c6-21df2d4ac7a0" providerId="AD" clId="Web-{2A226F34-3111-83B1-CE02-DE00EEA9F32A}" dt="2023-04-14T11:11:09.350" v="11"/>
      <pc:docMkLst>
        <pc:docMk/>
      </pc:docMkLst>
      <pc:sldChg chg="del">
        <pc:chgData name="Pedro Mauritti Granjo" userId="S::p.granjo@fct.unl.pt::cc7015fd-d343-4901-b4c6-21df2d4ac7a0" providerId="AD" clId="Web-{2A226F34-3111-83B1-CE02-DE00EEA9F32A}" dt="2023-04-14T11:11:09.350" v="11"/>
        <pc:sldMkLst>
          <pc:docMk/>
          <pc:sldMk cId="120033746" sldId="279"/>
        </pc:sldMkLst>
      </pc:sldChg>
      <pc:sldChg chg="addSp delSp modSp">
        <pc:chgData name="Pedro Mauritti Granjo" userId="S::p.granjo@fct.unl.pt::cc7015fd-d343-4901-b4c6-21df2d4ac7a0" providerId="AD" clId="Web-{2A226F34-3111-83B1-CE02-DE00EEA9F32A}" dt="2023-04-14T11:11:06.475" v="9"/>
        <pc:sldMkLst>
          <pc:docMk/>
          <pc:sldMk cId="3746764528" sldId="281"/>
        </pc:sldMkLst>
        <pc:graphicFrameChg chg="add del mod">
          <ac:chgData name="Pedro Mauritti Granjo" userId="S::p.granjo@fct.unl.pt::cc7015fd-d343-4901-b4c6-21df2d4ac7a0" providerId="AD" clId="Web-{2A226F34-3111-83B1-CE02-DE00EEA9F32A}" dt="2023-04-14T11:10:53.975" v="1"/>
          <ac:graphicFrameMkLst>
            <pc:docMk/>
            <pc:sldMk cId="3746764528" sldId="281"/>
            <ac:graphicFrameMk id="3" creationId="{87201219-4B66-795D-C784-D9DC3EE3512E}"/>
          </ac:graphicFrameMkLst>
        </pc:graphicFrameChg>
        <pc:graphicFrameChg chg="mod modGraphic">
          <ac:chgData name="Pedro Mauritti Granjo" userId="S::p.granjo@fct.unl.pt::cc7015fd-d343-4901-b4c6-21df2d4ac7a0" providerId="AD" clId="Web-{2A226F34-3111-83B1-CE02-DE00EEA9F32A}" dt="2023-04-14T11:11:06.475" v="9"/>
          <ac:graphicFrameMkLst>
            <pc:docMk/>
            <pc:sldMk cId="3746764528" sldId="281"/>
            <ac:graphicFrameMk id="5" creationId="{90CA37FC-97AF-2170-4009-B24B8E3576CB}"/>
          </ac:graphicFrameMkLst>
        </pc:graphicFrameChg>
      </pc:sldChg>
      <pc:sldChg chg="add del">
        <pc:chgData name="Pedro Mauritti Granjo" userId="S::p.granjo@fct.unl.pt::cc7015fd-d343-4901-b4c6-21df2d4ac7a0" providerId="AD" clId="Web-{2A226F34-3111-83B1-CE02-DE00EEA9F32A}" dt="2023-04-14T11:11:08.209" v="10"/>
        <pc:sldMkLst>
          <pc:docMk/>
          <pc:sldMk cId="1729418080" sldId="282"/>
        </pc:sldMkLst>
      </pc:sldChg>
    </pc:docChg>
  </pc:docChgLst>
  <pc:docChgLst>
    <pc:chgData name="Pedro Mauritti Granjo" userId="S::p.granjo@fct.unl.pt::cc7015fd-d343-4901-b4c6-21df2d4ac7a0" providerId="AD" clId="Web-{EF25B902-EC7A-6C0A-6537-F5FAC6BDC597}"/>
    <pc:docChg chg="addSld modSld">
      <pc:chgData name="Pedro Mauritti Granjo" userId="S::p.granjo@fct.unl.pt::cc7015fd-d343-4901-b4c6-21df2d4ac7a0" providerId="AD" clId="Web-{EF25B902-EC7A-6C0A-6537-F5FAC6BDC597}" dt="2023-03-10T20:31:49.790" v="44" actId="20577"/>
      <pc:docMkLst>
        <pc:docMk/>
      </pc:docMkLst>
      <pc:sldChg chg="modSp">
        <pc:chgData name="Pedro Mauritti Granjo" userId="S::p.granjo@fct.unl.pt::cc7015fd-d343-4901-b4c6-21df2d4ac7a0" providerId="AD" clId="Web-{EF25B902-EC7A-6C0A-6537-F5FAC6BDC597}" dt="2023-03-10T20:29:47.755" v="1" actId="20577"/>
        <pc:sldMkLst>
          <pc:docMk/>
          <pc:sldMk cId="0" sldId="256"/>
        </pc:sldMkLst>
        <pc:spChg chg="mod">
          <ac:chgData name="Pedro Mauritti Granjo" userId="S::p.granjo@fct.unl.pt::cc7015fd-d343-4901-b4c6-21df2d4ac7a0" providerId="AD" clId="Web-{EF25B902-EC7A-6C0A-6537-F5FAC6BDC597}" dt="2023-03-10T20:29:47.755" v="1" actId="20577"/>
          <ac:spMkLst>
            <pc:docMk/>
            <pc:sldMk cId="0" sldId="256"/>
            <ac:spMk id="54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EF25B902-EC7A-6C0A-6537-F5FAC6BDC597}" dt="2023-03-10T20:29:51.286" v="3" actId="20577"/>
        <pc:sldMkLst>
          <pc:docMk/>
          <pc:sldMk cId="0" sldId="257"/>
        </pc:sldMkLst>
        <pc:spChg chg="mod">
          <ac:chgData name="Pedro Mauritti Granjo" userId="S::p.granjo@fct.unl.pt::cc7015fd-d343-4901-b4c6-21df2d4ac7a0" providerId="AD" clId="Web-{EF25B902-EC7A-6C0A-6537-F5FAC6BDC597}" dt="2023-03-10T20:29:51.286" v="3" actId="20577"/>
          <ac:spMkLst>
            <pc:docMk/>
            <pc:sldMk cId="0" sldId="257"/>
            <ac:spMk id="62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EF25B902-EC7A-6C0A-6537-F5FAC6BDC597}" dt="2023-03-10T20:29:55.787" v="5" actId="20577"/>
        <pc:sldMkLst>
          <pc:docMk/>
          <pc:sldMk cId="0" sldId="258"/>
        </pc:sldMkLst>
        <pc:spChg chg="mod">
          <ac:chgData name="Pedro Mauritti Granjo" userId="S::p.granjo@fct.unl.pt::cc7015fd-d343-4901-b4c6-21df2d4ac7a0" providerId="AD" clId="Web-{EF25B902-EC7A-6C0A-6537-F5FAC6BDC597}" dt="2023-03-10T20:29:55.787" v="5" actId="20577"/>
          <ac:spMkLst>
            <pc:docMk/>
            <pc:sldMk cId="0" sldId="258"/>
            <ac:spMk id="68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EF25B902-EC7A-6C0A-6537-F5FAC6BDC597}" dt="2023-03-10T20:30:00.037" v="8" actId="20577"/>
        <pc:sldMkLst>
          <pc:docMk/>
          <pc:sldMk cId="0" sldId="259"/>
        </pc:sldMkLst>
        <pc:spChg chg="mod">
          <ac:chgData name="Pedro Mauritti Granjo" userId="S::p.granjo@fct.unl.pt::cc7015fd-d343-4901-b4c6-21df2d4ac7a0" providerId="AD" clId="Web-{EF25B902-EC7A-6C0A-6537-F5FAC6BDC597}" dt="2023-03-10T20:30:00.037" v="8" actId="20577"/>
          <ac:spMkLst>
            <pc:docMk/>
            <pc:sldMk cId="0" sldId="259"/>
            <ac:spMk id="74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EF25B902-EC7A-6C0A-6537-F5FAC6BDC597}" dt="2023-03-10T20:30:03.490" v="11" actId="20577"/>
        <pc:sldMkLst>
          <pc:docMk/>
          <pc:sldMk cId="0" sldId="260"/>
        </pc:sldMkLst>
        <pc:spChg chg="mod">
          <ac:chgData name="Pedro Mauritti Granjo" userId="S::p.granjo@fct.unl.pt::cc7015fd-d343-4901-b4c6-21df2d4ac7a0" providerId="AD" clId="Web-{EF25B902-EC7A-6C0A-6537-F5FAC6BDC597}" dt="2023-03-10T20:30:03.490" v="11" actId="20577"/>
          <ac:spMkLst>
            <pc:docMk/>
            <pc:sldMk cId="0" sldId="260"/>
            <ac:spMk id="80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EF25B902-EC7A-6C0A-6537-F5FAC6BDC597}" dt="2023-03-10T20:30:07.318" v="12" actId="20577"/>
        <pc:sldMkLst>
          <pc:docMk/>
          <pc:sldMk cId="0" sldId="261"/>
        </pc:sldMkLst>
        <pc:spChg chg="mod">
          <ac:chgData name="Pedro Mauritti Granjo" userId="S::p.granjo@fct.unl.pt::cc7015fd-d343-4901-b4c6-21df2d4ac7a0" providerId="AD" clId="Web-{EF25B902-EC7A-6C0A-6537-F5FAC6BDC597}" dt="2023-03-10T20:30:07.318" v="12" actId="20577"/>
          <ac:spMkLst>
            <pc:docMk/>
            <pc:sldMk cId="0" sldId="261"/>
            <ac:spMk id="86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EF25B902-EC7A-6C0A-6537-F5FAC6BDC597}" dt="2023-03-10T20:30:12.693" v="14" actId="20577"/>
        <pc:sldMkLst>
          <pc:docMk/>
          <pc:sldMk cId="0" sldId="262"/>
        </pc:sldMkLst>
        <pc:spChg chg="mod">
          <ac:chgData name="Pedro Mauritti Granjo" userId="S::p.granjo@fct.unl.pt::cc7015fd-d343-4901-b4c6-21df2d4ac7a0" providerId="AD" clId="Web-{EF25B902-EC7A-6C0A-6537-F5FAC6BDC597}" dt="2023-03-10T20:30:12.693" v="14" actId="20577"/>
          <ac:spMkLst>
            <pc:docMk/>
            <pc:sldMk cId="0" sldId="262"/>
            <ac:spMk id="92" creationId="{00000000-0000-0000-0000-000000000000}"/>
          </ac:spMkLst>
        </pc:spChg>
      </pc:sldChg>
      <pc:sldChg chg="addSp delSp modSp new">
        <pc:chgData name="Pedro Mauritti Granjo" userId="S::p.granjo@fct.unl.pt::cc7015fd-d343-4901-b4c6-21df2d4ac7a0" providerId="AD" clId="Web-{EF25B902-EC7A-6C0A-6537-F5FAC6BDC597}" dt="2023-03-10T20:31:49.790" v="44" actId="20577"/>
        <pc:sldMkLst>
          <pc:docMk/>
          <pc:sldMk cId="746827180" sldId="274"/>
        </pc:sldMkLst>
        <pc:spChg chg="del">
          <ac:chgData name="Pedro Mauritti Granjo" userId="S::p.granjo@fct.unl.pt::cc7015fd-d343-4901-b4c6-21df2d4ac7a0" providerId="AD" clId="Web-{EF25B902-EC7A-6C0A-6537-F5FAC6BDC597}" dt="2023-03-10T20:31:03.054" v="16"/>
          <ac:spMkLst>
            <pc:docMk/>
            <pc:sldMk cId="746827180" sldId="274"/>
            <ac:spMk id="2" creationId="{5D79A4A6-B16F-3890-B0CD-A5927090AB24}"/>
          </ac:spMkLst>
        </pc:spChg>
        <pc:spChg chg="add mod">
          <ac:chgData name="Pedro Mauritti Granjo" userId="S::p.granjo@fct.unl.pt::cc7015fd-d343-4901-b4c6-21df2d4ac7a0" providerId="AD" clId="Web-{EF25B902-EC7A-6C0A-6537-F5FAC6BDC597}" dt="2023-03-10T20:31:49.790" v="44" actId="20577"/>
          <ac:spMkLst>
            <pc:docMk/>
            <pc:sldMk cId="746827180" sldId="274"/>
            <ac:spMk id="5" creationId="{72C59114-022A-42B5-7CE6-EE8E0DBDE43E}"/>
          </ac:spMkLst>
        </pc:spChg>
        <pc:picChg chg="add mod">
          <ac:chgData name="Pedro Mauritti Granjo" userId="S::p.granjo@fct.unl.pt::cc7015fd-d343-4901-b4c6-21df2d4ac7a0" providerId="AD" clId="Web-{EF25B902-EC7A-6C0A-6537-F5FAC6BDC597}" dt="2023-03-10T20:31:21.758" v="21" actId="14100"/>
          <ac:picMkLst>
            <pc:docMk/>
            <pc:sldMk cId="746827180" sldId="274"/>
            <ac:picMk id="3" creationId="{573F61E3-FBFA-634C-E4AE-FD41349E113C}"/>
          </ac:picMkLst>
        </pc:picChg>
      </pc:sldChg>
    </pc:docChg>
  </pc:docChgLst>
  <pc:docChgLst>
    <pc:chgData name="Pedro Mauritti Granjo" userId="S::p.granjo@fct.unl.pt::cc7015fd-d343-4901-b4c6-21df2d4ac7a0" providerId="AD" clId="Web-{277014A3-405C-7D53-AD00-4B167DDEB1C4}"/>
    <pc:docChg chg="modSld">
      <pc:chgData name="Pedro Mauritti Granjo" userId="S::p.granjo@fct.unl.pt::cc7015fd-d343-4901-b4c6-21df2d4ac7a0" providerId="AD" clId="Web-{277014A3-405C-7D53-AD00-4B167DDEB1C4}" dt="2023-04-04T13:32:41.579" v="57" actId="1076"/>
      <pc:docMkLst>
        <pc:docMk/>
      </pc:docMkLst>
      <pc:sldChg chg="addSp delSp modSp">
        <pc:chgData name="Pedro Mauritti Granjo" userId="S::p.granjo@fct.unl.pt::cc7015fd-d343-4901-b4c6-21df2d4ac7a0" providerId="AD" clId="Web-{277014A3-405C-7D53-AD00-4B167DDEB1C4}" dt="2023-04-04T13:32:41.579" v="57" actId="1076"/>
        <pc:sldMkLst>
          <pc:docMk/>
          <pc:sldMk cId="0" sldId="263"/>
        </pc:sldMkLst>
        <pc:spChg chg="del">
          <ac:chgData name="Pedro Mauritti Granjo" userId="S::p.granjo@fct.unl.pt::cc7015fd-d343-4901-b4c6-21df2d4ac7a0" providerId="AD" clId="Web-{277014A3-405C-7D53-AD00-4B167DDEB1C4}" dt="2023-04-04T13:32:15.453" v="44"/>
          <ac:spMkLst>
            <pc:docMk/>
            <pc:sldMk cId="0" sldId="263"/>
            <ac:spMk id="101" creationId="{00000000-0000-0000-0000-000000000000}"/>
          </ac:spMkLst>
        </pc:spChg>
        <pc:spChg chg="del">
          <ac:chgData name="Pedro Mauritti Granjo" userId="S::p.granjo@fct.unl.pt::cc7015fd-d343-4901-b4c6-21df2d4ac7a0" providerId="AD" clId="Web-{277014A3-405C-7D53-AD00-4B167DDEB1C4}" dt="2023-04-04T13:32:14.500" v="43"/>
          <ac:spMkLst>
            <pc:docMk/>
            <pc:sldMk cId="0" sldId="263"/>
            <ac:spMk id="102" creationId="{00000000-0000-0000-0000-000000000000}"/>
          </ac:spMkLst>
        </pc:spChg>
        <pc:spChg chg="del">
          <ac:chgData name="Pedro Mauritti Granjo" userId="S::p.granjo@fct.unl.pt::cc7015fd-d343-4901-b4c6-21df2d4ac7a0" providerId="AD" clId="Web-{277014A3-405C-7D53-AD00-4B167DDEB1C4}" dt="2023-04-04T13:32:13.765" v="42"/>
          <ac:spMkLst>
            <pc:docMk/>
            <pc:sldMk cId="0" sldId="263"/>
            <ac:spMk id="103" creationId="{00000000-0000-0000-0000-000000000000}"/>
          </ac:spMkLst>
        </pc:spChg>
        <pc:spChg chg="del">
          <ac:chgData name="Pedro Mauritti Granjo" userId="S::p.granjo@fct.unl.pt::cc7015fd-d343-4901-b4c6-21df2d4ac7a0" providerId="AD" clId="Web-{277014A3-405C-7D53-AD00-4B167DDEB1C4}" dt="2023-04-04T13:32:16.469" v="45"/>
          <ac:spMkLst>
            <pc:docMk/>
            <pc:sldMk cId="0" sldId="263"/>
            <ac:spMk id="104" creationId="{00000000-0000-0000-0000-000000000000}"/>
          </ac:spMkLst>
        </pc:spChg>
        <pc:spChg chg="del">
          <ac:chgData name="Pedro Mauritti Granjo" userId="S::p.granjo@fct.unl.pt::cc7015fd-d343-4901-b4c6-21df2d4ac7a0" providerId="AD" clId="Web-{277014A3-405C-7D53-AD00-4B167DDEB1C4}" dt="2023-04-04T13:32:17.328" v="46"/>
          <ac:spMkLst>
            <pc:docMk/>
            <pc:sldMk cId="0" sldId="263"/>
            <ac:spMk id="105" creationId="{00000000-0000-0000-0000-000000000000}"/>
          </ac:spMkLst>
        </pc:spChg>
        <pc:picChg chg="add mod">
          <ac:chgData name="Pedro Mauritti Granjo" userId="S::p.granjo@fct.unl.pt::cc7015fd-d343-4901-b4c6-21df2d4ac7a0" providerId="AD" clId="Web-{277014A3-405C-7D53-AD00-4B167DDEB1C4}" dt="2023-04-04T13:32:41.579" v="57" actId="1076"/>
          <ac:picMkLst>
            <pc:docMk/>
            <pc:sldMk cId="0" sldId="263"/>
            <ac:picMk id="2" creationId="{A5952691-402F-822D-E489-86CB866DFA14}"/>
          </ac:picMkLst>
        </pc:picChg>
        <pc:picChg chg="del">
          <ac:chgData name="Pedro Mauritti Granjo" userId="S::p.granjo@fct.unl.pt::cc7015fd-d343-4901-b4c6-21df2d4ac7a0" providerId="AD" clId="Web-{277014A3-405C-7D53-AD00-4B167DDEB1C4}" dt="2023-04-04T13:32:12.500" v="41"/>
          <ac:picMkLst>
            <pc:docMk/>
            <pc:sldMk cId="0" sldId="263"/>
            <ac:picMk id="99" creationId="{00000000-0000-0000-0000-000000000000}"/>
          </ac:picMkLst>
        </pc:picChg>
      </pc:sldChg>
      <pc:sldChg chg="modSp">
        <pc:chgData name="Pedro Mauritti Granjo" userId="S::p.granjo@fct.unl.pt::cc7015fd-d343-4901-b4c6-21df2d4ac7a0" providerId="AD" clId="Web-{277014A3-405C-7D53-AD00-4B167DDEB1C4}" dt="2023-04-04T11:30:42.462" v="40" actId="20577"/>
        <pc:sldMkLst>
          <pc:docMk/>
          <pc:sldMk cId="120033746" sldId="279"/>
        </pc:sldMkLst>
        <pc:spChg chg="mod">
          <ac:chgData name="Pedro Mauritti Granjo" userId="S::p.granjo@fct.unl.pt::cc7015fd-d343-4901-b4c6-21df2d4ac7a0" providerId="AD" clId="Web-{277014A3-405C-7D53-AD00-4B167DDEB1C4}" dt="2023-04-04T11:30:42.462" v="40" actId="20577"/>
          <ac:spMkLst>
            <pc:docMk/>
            <pc:sldMk cId="120033746" sldId="279"/>
            <ac:spMk id="7" creationId="{CCA8EBAF-6819-ABAE-6141-40945D50709F}"/>
          </ac:spMkLst>
        </pc:spChg>
        <pc:graphicFrameChg chg="mod modGraphic">
          <ac:chgData name="Pedro Mauritti Granjo" userId="S::p.granjo@fct.unl.pt::cc7015fd-d343-4901-b4c6-21df2d4ac7a0" providerId="AD" clId="Web-{277014A3-405C-7D53-AD00-4B167DDEB1C4}" dt="2023-04-04T11:29:36.132" v="17"/>
          <ac:graphicFrameMkLst>
            <pc:docMk/>
            <pc:sldMk cId="120033746" sldId="279"/>
            <ac:graphicFrameMk id="5" creationId="{90CA37FC-97AF-2170-4009-B24B8E3576CB}"/>
          </ac:graphicFrameMkLst>
        </pc:graphicFrameChg>
      </pc:sldChg>
    </pc:docChg>
  </pc:docChgLst>
  <pc:docChgLst>
    <pc:chgData name="Pedro Mauritti Granjo" userId="S::p.granjo@fct.unl.pt::cc7015fd-d343-4901-b4c6-21df2d4ac7a0" providerId="AD" clId="Web-{695C9A4E-3A2C-6B05-65B5-0D90E6257BC7}"/>
    <pc:docChg chg="modSld">
      <pc:chgData name="Pedro Mauritti Granjo" userId="S::p.granjo@fct.unl.pt::cc7015fd-d343-4901-b4c6-21df2d4ac7a0" providerId="AD" clId="Web-{695C9A4E-3A2C-6B05-65B5-0D90E6257BC7}" dt="2023-03-29T15:32:28.227" v="9"/>
      <pc:docMkLst>
        <pc:docMk/>
      </pc:docMkLst>
      <pc:sldChg chg="addCm">
        <pc:chgData name="Pedro Mauritti Granjo" userId="S::p.granjo@fct.unl.pt::cc7015fd-d343-4901-b4c6-21df2d4ac7a0" providerId="AD" clId="Web-{695C9A4E-3A2C-6B05-65B5-0D90E6257BC7}" dt="2023-03-29T13:36:48.816" v="0"/>
        <pc:sldMkLst>
          <pc:docMk/>
          <pc:sldMk cId="0" sldId="257"/>
        </pc:sldMkLst>
      </pc:sldChg>
      <pc:sldChg chg="modSp">
        <pc:chgData name="Pedro Mauritti Granjo" userId="S::p.granjo@fct.unl.pt::cc7015fd-d343-4901-b4c6-21df2d4ac7a0" providerId="AD" clId="Web-{695C9A4E-3A2C-6B05-65B5-0D90E6257BC7}" dt="2023-03-29T15:32:28.227" v="9"/>
        <pc:sldMkLst>
          <pc:docMk/>
          <pc:sldMk cId="4168802406" sldId="275"/>
        </pc:sldMkLst>
        <pc:spChg chg="mod">
          <ac:chgData name="Pedro Mauritti Granjo" userId="S::p.granjo@fct.unl.pt::cc7015fd-d343-4901-b4c6-21df2d4ac7a0" providerId="AD" clId="Web-{695C9A4E-3A2C-6B05-65B5-0D90E6257BC7}" dt="2023-03-29T15:32:16.320" v="3" actId="20577"/>
          <ac:spMkLst>
            <pc:docMk/>
            <pc:sldMk cId="4168802406" sldId="275"/>
            <ac:spMk id="8" creationId="{526865A6-50A8-2890-32FE-FB20E7B2BF05}"/>
          </ac:spMkLst>
        </pc:spChg>
        <pc:spChg chg="mod">
          <ac:chgData name="Pedro Mauritti Granjo" userId="S::p.granjo@fct.unl.pt::cc7015fd-d343-4901-b4c6-21df2d4ac7a0" providerId="AD" clId="Web-{695C9A4E-3A2C-6B05-65B5-0D90E6257BC7}" dt="2023-03-29T15:32:13.617" v="1" actId="20577"/>
          <ac:spMkLst>
            <pc:docMk/>
            <pc:sldMk cId="4168802406" sldId="275"/>
            <ac:spMk id="9" creationId="{5F01B3A1-636F-1C4E-40DF-4DB8AB9EF0E5}"/>
          </ac:spMkLst>
        </pc:spChg>
        <pc:graphicFrameChg chg="mod modGraphic">
          <ac:chgData name="Pedro Mauritti Granjo" userId="S::p.granjo@fct.unl.pt::cc7015fd-d343-4901-b4c6-21df2d4ac7a0" providerId="AD" clId="Web-{695C9A4E-3A2C-6B05-65B5-0D90E6257BC7}" dt="2023-03-29T15:32:28.227" v="9"/>
          <ac:graphicFrameMkLst>
            <pc:docMk/>
            <pc:sldMk cId="4168802406" sldId="275"/>
            <ac:graphicFrameMk id="4" creationId="{6219EE75-22EE-98E7-6DBC-AB1724A09DAE}"/>
          </ac:graphicFrameMkLst>
        </pc:graphicFrameChg>
      </pc:sldChg>
    </pc:docChg>
  </pc:docChgLst>
  <pc:docChgLst>
    <pc:chgData name="Pedro Mauritti Granjo" userId="S::p.granjo@fct.unl.pt::cc7015fd-d343-4901-b4c6-21df2d4ac7a0" providerId="AD" clId="Web-{77D30D4A-2A1C-4856-39BA-6417DC89E8AD}"/>
    <pc:docChg chg="addSld modSld">
      <pc:chgData name="Pedro Mauritti Granjo" userId="S::p.granjo@fct.unl.pt::cc7015fd-d343-4901-b4c6-21df2d4ac7a0" providerId="AD" clId="Web-{77D30D4A-2A1C-4856-39BA-6417DC89E8AD}" dt="2023-03-31T16:35:20.911" v="1450" actId="1076"/>
      <pc:docMkLst>
        <pc:docMk/>
      </pc:docMkLst>
      <pc:sldChg chg="addSp delSp modSp">
        <pc:chgData name="Pedro Mauritti Granjo" userId="S::p.granjo@fct.unl.pt::cc7015fd-d343-4901-b4c6-21df2d4ac7a0" providerId="AD" clId="Web-{77D30D4A-2A1C-4856-39BA-6417DC89E8AD}" dt="2023-03-31T16:27:33.231" v="1407" actId="14100"/>
        <pc:sldMkLst>
          <pc:docMk/>
          <pc:sldMk cId="0" sldId="257"/>
        </pc:sldMkLst>
        <pc:spChg chg="mod">
          <ac:chgData name="Pedro Mauritti Granjo" userId="S::p.granjo@fct.unl.pt::cc7015fd-d343-4901-b4c6-21df2d4ac7a0" providerId="AD" clId="Web-{77D30D4A-2A1C-4856-39BA-6417DC89E8AD}" dt="2023-03-31T16:27:33.231" v="1407" actId="14100"/>
          <ac:spMkLst>
            <pc:docMk/>
            <pc:sldMk cId="0" sldId="257"/>
            <ac:spMk id="62" creationId="{00000000-0000-0000-0000-000000000000}"/>
          </ac:spMkLst>
        </pc:spChg>
        <pc:picChg chg="add mod">
          <ac:chgData name="Pedro Mauritti Granjo" userId="S::p.granjo@fct.unl.pt::cc7015fd-d343-4901-b4c6-21df2d4ac7a0" providerId="AD" clId="Web-{77D30D4A-2A1C-4856-39BA-6417DC89E8AD}" dt="2023-03-31T16:27:27.465" v="1405" actId="1076"/>
          <ac:picMkLst>
            <pc:docMk/>
            <pc:sldMk cId="0" sldId="257"/>
            <ac:picMk id="2" creationId="{57BE5229-86FA-BE63-2996-3173BE55BA93}"/>
          </ac:picMkLst>
        </pc:picChg>
        <pc:picChg chg="del">
          <ac:chgData name="Pedro Mauritti Granjo" userId="S::p.granjo@fct.unl.pt::cc7015fd-d343-4901-b4c6-21df2d4ac7a0" providerId="AD" clId="Web-{77D30D4A-2A1C-4856-39BA-6417DC89E8AD}" dt="2023-03-31T16:27:22.043" v="1402"/>
          <ac:picMkLst>
            <pc:docMk/>
            <pc:sldMk cId="0" sldId="257"/>
            <ac:picMk id="8" creationId="{BDBA9D66-7715-C381-BC60-B058CC9908BA}"/>
          </ac:picMkLst>
        </pc:picChg>
      </pc:sldChg>
      <pc:sldChg chg="modSp">
        <pc:chgData name="Pedro Mauritti Granjo" userId="S::p.granjo@fct.unl.pt::cc7015fd-d343-4901-b4c6-21df2d4ac7a0" providerId="AD" clId="Web-{77D30D4A-2A1C-4856-39BA-6417DC89E8AD}" dt="2023-03-31T15:33:23.683" v="1393"/>
        <pc:sldMkLst>
          <pc:docMk/>
          <pc:sldMk cId="4168802406" sldId="275"/>
        </pc:sldMkLst>
        <pc:spChg chg="mod">
          <ac:chgData name="Pedro Mauritti Granjo" userId="S::p.granjo@fct.unl.pt::cc7015fd-d343-4901-b4c6-21df2d4ac7a0" providerId="AD" clId="Web-{77D30D4A-2A1C-4856-39BA-6417DC89E8AD}" dt="2023-03-31T15:32:59.011" v="1345" actId="1076"/>
          <ac:spMkLst>
            <pc:docMk/>
            <pc:sldMk cId="4168802406" sldId="275"/>
            <ac:spMk id="3" creationId="{9D9CEDA6-6D47-0BEF-C0CE-9CA89CAA2FA1}"/>
          </ac:spMkLst>
        </pc:spChg>
        <pc:graphicFrameChg chg="mod modGraphic">
          <ac:chgData name="Pedro Mauritti Granjo" userId="S::p.granjo@fct.unl.pt::cc7015fd-d343-4901-b4c6-21df2d4ac7a0" providerId="AD" clId="Web-{77D30D4A-2A1C-4856-39BA-6417DC89E8AD}" dt="2023-03-31T15:33:23.683" v="1393"/>
          <ac:graphicFrameMkLst>
            <pc:docMk/>
            <pc:sldMk cId="4168802406" sldId="275"/>
            <ac:graphicFrameMk id="4" creationId="{6219EE75-22EE-98E7-6DBC-AB1724A09DAE}"/>
          </ac:graphicFrameMkLst>
        </pc:graphicFrameChg>
      </pc:sldChg>
      <pc:sldChg chg="addSp delSp modSp new">
        <pc:chgData name="Pedro Mauritti Granjo" userId="S::p.granjo@fct.unl.pt::cc7015fd-d343-4901-b4c6-21df2d4ac7a0" providerId="AD" clId="Web-{77D30D4A-2A1C-4856-39BA-6417DC89E8AD}" dt="2023-03-31T16:35:20.911" v="1450" actId="1076"/>
        <pc:sldMkLst>
          <pc:docMk/>
          <pc:sldMk cId="2860821069" sldId="278"/>
        </pc:sldMkLst>
        <pc:spChg chg="del">
          <ac:chgData name="Pedro Mauritti Granjo" userId="S::p.granjo@fct.unl.pt::cc7015fd-d343-4901-b4c6-21df2d4ac7a0" providerId="AD" clId="Web-{77D30D4A-2A1C-4856-39BA-6417DC89E8AD}" dt="2023-03-31T14:32:01.003" v="1"/>
          <ac:spMkLst>
            <pc:docMk/>
            <pc:sldMk cId="2860821069" sldId="278"/>
            <ac:spMk id="2" creationId="{DB530C43-D6DF-B742-5010-224CF7FEE40C}"/>
          </ac:spMkLst>
        </pc:spChg>
        <pc:spChg chg="add del mod">
          <ac:chgData name="Pedro Mauritti Granjo" userId="S::p.granjo@fct.unl.pt::cc7015fd-d343-4901-b4c6-21df2d4ac7a0" providerId="AD" clId="Web-{77D30D4A-2A1C-4856-39BA-6417DC89E8AD}" dt="2023-03-31T16:28:08.794" v="1411"/>
          <ac:spMkLst>
            <pc:docMk/>
            <pc:sldMk cId="2860821069" sldId="278"/>
            <ac:spMk id="5" creationId="{F8B3D8AC-D1A9-4D3D-52DE-82FE5EE71C82}"/>
          </ac:spMkLst>
        </pc:spChg>
        <pc:graphicFrameChg chg="add del mod modGraphic">
          <ac:chgData name="Pedro Mauritti Granjo" userId="S::p.granjo@fct.unl.pt::cc7015fd-d343-4901-b4c6-21df2d4ac7a0" providerId="AD" clId="Web-{77D30D4A-2A1C-4856-39BA-6417DC89E8AD}" dt="2023-03-31T16:28:05.075" v="1410"/>
          <ac:graphicFrameMkLst>
            <pc:docMk/>
            <pc:sldMk cId="2860821069" sldId="278"/>
            <ac:graphicFrameMk id="3" creationId="{6208F81F-619B-147C-C70B-C63FBB271533}"/>
          </ac:graphicFrameMkLst>
        </pc:graphicFrameChg>
        <pc:picChg chg="add mod">
          <ac:chgData name="Pedro Mauritti Granjo" userId="S::p.granjo@fct.unl.pt::cc7015fd-d343-4901-b4c6-21df2d4ac7a0" providerId="AD" clId="Web-{77D30D4A-2A1C-4856-39BA-6417DC89E8AD}" dt="2023-03-31T16:35:20.911" v="1450" actId="1076"/>
          <ac:picMkLst>
            <pc:docMk/>
            <pc:sldMk cId="2860821069" sldId="278"/>
            <ac:picMk id="2" creationId="{19101E9C-9EE0-1590-DB68-A868FF2DEACB}"/>
          </ac:picMkLst>
        </pc:picChg>
      </pc:sldChg>
      <pc:sldChg chg="addSp delSp modSp new">
        <pc:chgData name="Pedro Mauritti Granjo" userId="S::p.granjo@fct.unl.pt::cc7015fd-d343-4901-b4c6-21df2d4ac7a0" providerId="AD" clId="Web-{77D30D4A-2A1C-4856-39BA-6417DC89E8AD}" dt="2023-03-31T16:34:02.081" v="1444"/>
        <pc:sldMkLst>
          <pc:docMk/>
          <pc:sldMk cId="120033746" sldId="279"/>
        </pc:sldMkLst>
        <pc:spChg chg="del">
          <ac:chgData name="Pedro Mauritti Granjo" userId="S::p.granjo@fct.unl.pt::cc7015fd-d343-4901-b4c6-21df2d4ac7a0" providerId="AD" clId="Web-{77D30D4A-2A1C-4856-39BA-6417DC89E8AD}" dt="2023-03-31T16:26:56.792" v="1395"/>
          <ac:spMkLst>
            <pc:docMk/>
            <pc:sldMk cId="120033746" sldId="279"/>
            <ac:spMk id="2" creationId="{6281D3C1-1DAA-7D4B-83B0-D3679F373B68}"/>
          </ac:spMkLst>
        </pc:spChg>
        <pc:spChg chg="add">
          <ac:chgData name="Pedro Mauritti Granjo" userId="S::p.granjo@fct.unl.pt::cc7015fd-d343-4901-b4c6-21df2d4ac7a0" providerId="AD" clId="Web-{77D30D4A-2A1C-4856-39BA-6417DC89E8AD}" dt="2023-03-31T16:27:51.809" v="1409"/>
          <ac:spMkLst>
            <pc:docMk/>
            <pc:sldMk cId="120033746" sldId="279"/>
            <ac:spMk id="7" creationId="{CCA8EBAF-6819-ABAE-6141-40945D50709F}"/>
          </ac:spMkLst>
        </pc:spChg>
        <pc:graphicFrameChg chg="add mod modGraphic">
          <ac:chgData name="Pedro Mauritti Granjo" userId="S::p.granjo@fct.unl.pt::cc7015fd-d343-4901-b4c6-21df2d4ac7a0" providerId="AD" clId="Web-{77D30D4A-2A1C-4856-39BA-6417DC89E8AD}" dt="2023-03-31T16:34:02.081" v="1444"/>
          <ac:graphicFrameMkLst>
            <pc:docMk/>
            <pc:sldMk cId="120033746" sldId="279"/>
            <ac:graphicFrameMk id="5" creationId="{90CA37FC-97AF-2170-4009-B24B8E3576CB}"/>
          </ac:graphicFrameMkLst>
        </pc:graphicFrameChg>
        <pc:picChg chg="add del mod">
          <ac:chgData name="Pedro Mauritti Granjo" userId="S::p.granjo@fct.unl.pt::cc7015fd-d343-4901-b4c6-21df2d4ac7a0" providerId="AD" clId="Web-{77D30D4A-2A1C-4856-39BA-6417DC89E8AD}" dt="2023-03-31T16:27:16.730" v="1401"/>
          <ac:picMkLst>
            <pc:docMk/>
            <pc:sldMk cId="120033746" sldId="279"/>
            <ac:picMk id="3" creationId="{93E7BE29-0CB6-3551-70D1-F8CF3E495D8E}"/>
          </ac:picMkLst>
        </pc:picChg>
      </pc:sldChg>
    </pc:docChg>
  </pc:docChgLst>
  <pc:docChgLst>
    <pc:chgData name="Pedro Mauritti Granjo" userId="S::p.granjo@fct.unl.pt::cc7015fd-d343-4901-b4c6-21df2d4ac7a0" providerId="AD" clId="Web-{F441B621-06BB-E0DF-E1FD-4F3C8F7BA68F}"/>
    <pc:docChg chg="modSld">
      <pc:chgData name="Pedro Mauritti Granjo" userId="S::p.granjo@fct.unl.pt::cc7015fd-d343-4901-b4c6-21df2d4ac7a0" providerId="AD" clId="Web-{F441B621-06BB-E0DF-E1FD-4F3C8F7BA68F}" dt="2023-04-18T13:04:12.846" v="374" actId="20577"/>
      <pc:docMkLst>
        <pc:docMk/>
      </pc:docMkLst>
      <pc:sldChg chg="addSp modSp">
        <pc:chgData name="Pedro Mauritti Granjo" userId="S::p.granjo@fct.unl.pt::cc7015fd-d343-4901-b4c6-21df2d4ac7a0" providerId="AD" clId="Web-{F441B621-06BB-E0DF-E1FD-4F3C8F7BA68F}" dt="2023-04-18T12:59:09.289" v="276" actId="20577"/>
        <pc:sldMkLst>
          <pc:docMk/>
          <pc:sldMk cId="0" sldId="268"/>
        </pc:sldMkLst>
        <pc:spChg chg="add mod">
          <ac:chgData name="Pedro Mauritti Granjo" userId="S::p.granjo@fct.unl.pt::cc7015fd-d343-4901-b4c6-21df2d4ac7a0" providerId="AD" clId="Web-{F441B621-06BB-E0DF-E1FD-4F3C8F7BA68F}" dt="2023-04-18T12:59:09.289" v="276" actId="20577"/>
          <ac:spMkLst>
            <pc:docMk/>
            <pc:sldMk cId="0" sldId="268"/>
            <ac:spMk id="4" creationId="{88BE49BC-7650-F1C7-8FD3-0BBABADD6A04}"/>
          </ac:spMkLst>
        </pc:spChg>
        <pc:spChg chg="mod">
          <ac:chgData name="Pedro Mauritti Granjo" userId="S::p.granjo@fct.unl.pt::cc7015fd-d343-4901-b4c6-21df2d4ac7a0" providerId="AD" clId="Web-{F441B621-06BB-E0DF-E1FD-4F3C8F7BA68F}" dt="2023-04-18T12:58:13.662" v="265" actId="20577"/>
          <ac:spMkLst>
            <pc:docMk/>
            <pc:sldMk cId="0" sldId="268"/>
            <ac:spMk id="133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F441B621-06BB-E0DF-E1FD-4F3C8F7BA68F}" dt="2023-04-18T13:04:12.846" v="374" actId="20577"/>
        <pc:sldMkLst>
          <pc:docMk/>
          <pc:sldMk cId="0" sldId="269"/>
        </pc:sldMkLst>
        <pc:spChg chg="mod">
          <ac:chgData name="Pedro Mauritti Granjo" userId="S::p.granjo@fct.unl.pt::cc7015fd-d343-4901-b4c6-21df2d4ac7a0" providerId="AD" clId="Web-{F441B621-06BB-E0DF-E1FD-4F3C8F7BA68F}" dt="2023-04-18T13:04:12.846" v="374" actId="20577"/>
          <ac:spMkLst>
            <pc:docMk/>
            <pc:sldMk cId="0" sldId="269"/>
            <ac:spMk id="4" creationId="{79DE6C02-1434-3F8D-8864-98C0D4B9495F}"/>
          </ac:spMkLst>
        </pc:spChg>
      </pc:sldChg>
      <pc:sldChg chg="addSp modSp">
        <pc:chgData name="Pedro Mauritti Granjo" userId="S::p.granjo@fct.unl.pt::cc7015fd-d343-4901-b4c6-21df2d4ac7a0" providerId="AD" clId="Web-{F441B621-06BB-E0DF-E1FD-4F3C8F7BA68F}" dt="2023-04-18T13:03:38.767" v="365" actId="20577"/>
        <pc:sldMkLst>
          <pc:docMk/>
          <pc:sldMk cId="3969417392" sldId="270"/>
        </pc:sldMkLst>
        <pc:spChg chg="add mod">
          <ac:chgData name="Pedro Mauritti Granjo" userId="S::p.granjo@fct.unl.pt::cc7015fd-d343-4901-b4c6-21df2d4ac7a0" providerId="AD" clId="Web-{F441B621-06BB-E0DF-E1FD-4F3C8F7BA68F}" dt="2023-04-18T13:03:38.767" v="365" actId="20577"/>
          <ac:spMkLst>
            <pc:docMk/>
            <pc:sldMk cId="3969417392" sldId="270"/>
            <ac:spMk id="3" creationId="{91024E88-419C-94D2-7F26-98D7B07B4005}"/>
          </ac:spMkLst>
        </pc:spChg>
      </pc:sldChg>
      <pc:sldChg chg="modSp">
        <pc:chgData name="Pedro Mauritti Granjo" userId="S::p.granjo@fct.unl.pt::cc7015fd-d343-4901-b4c6-21df2d4ac7a0" providerId="AD" clId="Web-{F441B621-06BB-E0DF-E1FD-4F3C8F7BA68F}" dt="2023-04-18T12:55:11.047" v="256" actId="20577"/>
        <pc:sldMkLst>
          <pc:docMk/>
          <pc:sldMk cId="746827180" sldId="274"/>
        </pc:sldMkLst>
        <pc:spChg chg="mod">
          <ac:chgData name="Pedro Mauritti Granjo" userId="S::p.granjo@fct.unl.pt::cc7015fd-d343-4901-b4c6-21df2d4ac7a0" providerId="AD" clId="Web-{F441B621-06BB-E0DF-E1FD-4F3C8F7BA68F}" dt="2023-04-18T12:55:11.047" v="256" actId="20577"/>
          <ac:spMkLst>
            <pc:docMk/>
            <pc:sldMk cId="746827180" sldId="274"/>
            <ac:spMk id="5" creationId="{72C59114-022A-42B5-7CE6-EE8E0DBDE43E}"/>
          </ac:spMkLst>
        </pc:spChg>
      </pc:sldChg>
      <pc:sldChg chg="addSp modSp">
        <pc:chgData name="Pedro Mauritti Granjo" userId="S::p.granjo@fct.unl.pt::cc7015fd-d343-4901-b4c6-21df2d4ac7a0" providerId="AD" clId="Web-{F441B621-06BB-E0DF-E1FD-4F3C8F7BA68F}" dt="2023-04-18T12:55:18.657" v="258" actId="20577"/>
        <pc:sldMkLst>
          <pc:docMk/>
          <pc:sldMk cId="2986738929" sldId="280"/>
        </pc:sldMkLst>
        <pc:spChg chg="add mod">
          <ac:chgData name="Pedro Mauritti Granjo" userId="S::p.granjo@fct.unl.pt::cc7015fd-d343-4901-b4c6-21df2d4ac7a0" providerId="AD" clId="Web-{F441B621-06BB-E0DF-E1FD-4F3C8F7BA68F}" dt="2023-04-18T12:55:18.657" v="258" actId="20577"/>
          <ac:spMkLst>
            <pc:docMk/>
            <pc:sldMk cId="2986738929" sldId="280"/>
            <ac:spMk id="3" creationId="{F75852C7-E70E-2BDC-0B24-DA113B485EC0}"/>
          </ac:spMkLst>
        </pc:spChg>
      </pc:sldChg>
    </pc:docChg>
  </pc:docChgLst>
  <pc:docChgLst>
    <pc:chgData name="Pedro Mauritti Granjo" userId="S::p.granjo@fct.unl.pt::cc7015fd-d343-4901-b4c6-21df2d4ac7a0" providerId="AD" clId="Web-{B25653F9-F3C4-1EF9-CCAF-79B84595B73F}"/>
    <pc:docChg chg="modSld">
      <pc:chgData name="Pedro Mauritti Granjo" userId="S::p.granjo@fct.unl.pt::cc7015fd-d343-4901-b4c6-21df2d4ac7a0" providerId="AD" clId="Web-{B25653F9-F3C4-1EF9-CCAF-79B84595B73F}" dt="2023-04-18T08:47:58.372" v="3" actId="1076"/>
      <pc:docMkLst>
        <pc:docMk/>
      </pc:docMkLst>
      <pc:sldChg chg="modSp">
        <pc:chgData name="Pedro Mauritti Granjo" userId="S::p.granjo@fct.unl.pt::cc7015fd-d343-4901-b4c6-21df2d4ac7a0" providerId="AD" clId="Web-{B25653F9-F3C4-1EF9-CCAF-79B84595B73F}" dt="2023-04-18T08:47:58.372" v="3" actId="1076"/>
        <pc:sldMkLst>
          <pc:docMk/>
          <pc:sldMk cId="3969417392" sldId="270"/>
        </pc:sldMkLst>
        <pc:picChg chg="mod">
          <ac:chgData name="Pedro Mauritti Granjo" userId="S::p.granjo@fct.unl.pt::cc7015fd-d343-4901-b4c6-21df2d4ac7a0" providerId="AD" clId="Web-{B25653F9-F3C4-1EF9-CCAF-79B84595B73F}" dt="2023-04-18T08:47:58.372" v="3" actId="1076"/>
          <ac:picMkLst>
            <pc:docMk/>
            <pc:sldMk cId="3969417392" sldId="270"/>
            <ac:picMk id="5" creationId="{526E8A0C-232F-73E9-C49D-3261022F65FE}"/>
          </ac:picMkLst>
        </pc:picChg>
      </pc:sldChg>
    </pc:docChg>
  </pc:docChgLst>
  <pc:docChgLst>
    <pc:chgData name="Pedro Mauritti Granjo" userId="S::p.granjo@fct.unl.pt::cc7015fd-d343-4901-b4c6-21df2d4ac7a0" providerId="AD" clId="Web-{F963EB40-0B7E-0384-F4EB-7C8695CD5E04}"/>
    <pc:docChg chg="modSld sldOrd">
      <pc:chgData name="Pedro Mauritti Granjo" userId="S::p.granjo@fct.unl.pt::cc7015fd-d343-4901-b4c6-21df2d4ac7a0" providerId="AD" clId="Web-{F963EB40-0B7E-0384-F4EB-7C8695CD5E04}" dt="2023-04-06T16:58:18.733" v="38" actId="20577"/>
      <pc:docMkLst>
        <pc:docMk/>
      </pc:docMkLst>
      <pc:sldChg chg="modSp">
        <pc:chgData name="Pedro Mauritti Granjo" userId="S::p.granjo@fct.unl.pt::cc7015fd-d343-4901-b4c6-21df2d4ac7a0" providerId="AD" clId="Web-{F963EB40-0B7E-0384-F4EB-7C8695CD5E04}" dt="2023-04-06T16:56:05.120" v="29" actId="20577"/>
        <pc:sldMkLst>
          <pc:docMk/>
          <pc:sldMk cId="0" sldId="258"/>
        </pc:sldMkLst>
        <pc:spChg chg="mod">
          <ac:chgData name="Pedro Mauritti Granjo" userId="S::p.granjo@fct.unl.pt::cc7015fd-d343-4901-b4c6-21df2d4ac7a0" providerId="AD" clId="Web-{F963EB40-0B7E-0384-F4EB-7C8695CD5E04}" dt="2023-04-06T16:56:05.120" v="29" actId="20577"/>
          <ac:spMkLst>
            <pc:docMk/>
            <pc:sldMk cId="0" sldId="258"/>
            <ac:spMk id="68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F963EB40-0B7E-0384-F4EB-7C8695CD5E04}" dt="2023-04-06T16:56:08.589" v="30" actId="20577"/>
        <pc:sldMkLst>
          <pc:docMk/>
          <pc:sldMk cId="0" sldId="259"/>
        </pc:sldMkLst>
        <pc:spChg chg="mod">
          <ac:chgData name="Pedro Mauritti Granjo" userId="S::p.granjo@fct.unl.pt::cc7015fd-d343-4901-b4c6-21df2d4ac7a0" providerId="AD" clId="Web-{F963EB40-0B7E-0384-F4EB-7C8695CD5E04}" dt="2023-04-06T16:56:08.589" v="30" actId="20577"/>
          <ac:spMkLst>
            <pc:docMk/>
            <pc:sldMk cId="0" sldId="259"/>
            <ac:spMk id="74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F963EB40-0B7E-0384-F4EB-7C8695CD5E04}" dt="2023-04-06T16:56:11.448" v="31" actId="20577"/>
        <pc:sldMkLst>
          <pc:docMk/>
          <pc:sldMk cId="0" sldId="260"/>
        </pc:sldMkLst>
        <pc:spChg chg="mod">
          <ac:chgData name="Pedro Mauritti Granjo" userId="S::p.granjo@fct.unl.pt::cc7015fd-d343-4901-b4c6-21df2d4ac7a0" providerId="AD" clId="Web-{F963EB40-0B7E-0384-F4EB-7C8695CD5E04}" dt="2023-04-06T16:56:11.448" v="31" actId="20577"/>
          <ac:spMkLst>
            <pc:docMk/>
            <pc:sldMk cId="0" sldId="260"/>
            <ac:spMk id="80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F963EB40-0B7E-0384-F4EB-7C8695CD5E04}" dt="2023-04-06T16:56:16.808" v="32" actId="20577"/>
        <pc:sldMkLst>
          <pc:docMk/>
          <pc:sldMk cId="0" sldId="261"/>
        </pc:sldMkLst>
        <pc:spChg chg="mod">
          <ac:chgData name="Pedro Mauritti Granjo" userId="S::p.granjo@fct.unl.pt::cc7015fd-d343-4901-b4c6-21df2d4ac7a0" providerId="AD" clId="Web-{F963EB40-0B7E-0384-F4EB-7C8695CD5E04}" dt="2023-04-06T16:56:16.808" v="32" actId="20577"/>
          <ac:spMkLst>
            <pc:docMk/>
            <pc:sldMk cId="0" sldId="261"/>
            <ac:spMk id="86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F963EB40-0B7E-0384-F4EB-7C8695CD5E04}" dt="2023-04-06T16:56:20.277" v="34" actId="20577"/>
        <pc:sldMkLst>
          <pc:docMk/>
          <pc:sldMk cId="0" sldId="262"/>
        </pc:sldMkLst>
        <pc:spChg chg="mod">
          <ac:chgData name="Pedro Mauritti Granjo" userId="S::p.granjo@fct.unl.pt::cc7015fd-d343-4901-b4c6-21df2d4ac7a0" providerId="AD" clId="Web-{F963EB40-0B7E-0384-F4EB-7C8695CD5E04}" dt="2023-04-06T16:56:20.277" v="34" actId="20577"/>
          <ac:spMkLst>
            <pc:docMk/>
            <pc:sldMk cId="0" sldId="262"/>
            <ac:spMk id="92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F963EB40-0B7E-0384-F4EB-7C8695CD5E04}" dt="2023-04-06T16:57:36.279" v="36" actId="20577"/>
        <pc:sldMkLst>
          <pc:docMk/>
          <pc:sldMk cId="0" sldId="263"/>
        </pc:sldMkLst>
        <pc:spChg chg="mod">
          <ac:chgData name="Pedro Mauritti Granjo" userId="S::p.granjo@fct.unl.pt::cc7015fd-d343-4901-b4c6-21df2d4ac7a0" providerId="AD" clId="Web-{F963EB40-0B7E-0384-F4EB-7C8695CD5E04}" dt="2023-04-06T16:57:36.279" v="36" actId="20577"/>
          <ac:spMkLst>
            <pc:docMk/>
            <pc:sldMk cId="0" sldId="263"/>
            <ac:spMk id="106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F963EB40-0B7E-0384-F4EB-7C8695CD5E04}" dt="2023-04-06T16:58:18.733" v="38" actId="20577"/>
        <pc:sldMkLst>
          <pc:docMk/>
          <pc:sldMk cId="0" sldId="264"/>
        </pc:sldMkLst>
        <pc:spChg chg="mod">
          <ac:chgData name="Pedro Mauritti Granjo" userId="S::p.granjo@fct.unl.pt::cc7015fd-d343-4901-b4c6-21df2d4ac7a0" providerId="AD" clId="Web-{F963EB40-0B7E-0384-F4EB-7C8695CD5E04}" dt="2023-04-06T16:58:18.733" v="38" actId="20577"/>
          <ac:spMkLst>
            <pc:docMk/>
            <pc:sldMk cId="0" sldId="264"/>
            <ac:spMk id="111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F963EB40-0B7E-0384-F4EB-7C8695CD5E04}" dt="2023-04-06T15:59:48.049" v="23" actId="20577"/>
        <pc:sldMkLst>
          <pc:docMk/>
          <pc:sldMk cId="0" sldId="265"/>
        </pc:sldMkLst>
        <pc:spChg chg="mod">
          <ac:chgData name="Pedro Mauritti Granjo" userId="S::p.granjo@fct.unl.pt::cc7015fd-d343-4901-b4c6-21df2d4ac7a0" providerId="AD" clId="Web-{F963EB40-0B7E-0384-F4EB-7C8695CD5E04}" dt="2023-04-06T15:59:44.018" v="20" actId="20577"/>
          <ac:spMkLst>
            <pc:docMk/>
            <pc:sldMk cId="0" sldId="265"/>
            <ac:spMk id="12" creationId="{9E909165-C357-0C1C-2904-8F2CB8FD4693}"/>
          </ac:spMkLst>
        </pc:spChg>
        <pc:spChg chg="mod">
          <ac:chgData name="Pedro Mauritti Granjo" userId="S::p.granjo@fct.unl.pt::cc7015fd-d343-4901-b4c6-21df2d4ac7a0" providerId="AD" clId="Web-{F963EB40-0B7E-0384-F4EB-7C8695CD5E04}" dt="2023-04-06T15:59:48.049" v="23" actId="20577"/>
          <ac:spMkLst>
            <pc:docMk/>
            <pc:sldMk cId="0" sldId="265"/>
            <ac:spMk id="13" creationId="{15016E03-F499-0DF4-0378-318F527D3105}"/>
          </ac:spMkLst>
        </pc:spChg>
        <pc:spChg chg="mod">
          <ac:chgData name="Pedro Mauritti Granjo" userId="S::p.granjo@fct.unl.pt::cc7015fd-d343-4901-b4c6-21df2d4ac7a0" providerId="AD" clId="Web-{F963EB40-0B7E-0384-F4EB-7C8695CD5E04}" dt="2023-04-06T15:59:34.252" v="11" actId="20577"/>
          <ac:spMkLst>
            <pc:docMk/>
            <pc:sldMk cId="0" sldId="265"/>
            <ac:spMk id="14" creationId="{8573265A-5C29-2DEB-AA56-0CBFC456B35F}"/>
          </ac:spMkLst>
        </pc:spChg>
        <pc:spChg chg="mod">
          <ac:chgData name="Pedro Mauritti Granjo" userId="S::p.granjo@fct.unl.pt::cc7015fd-d343-4901-b4c6-21df2d4ac7a0" providerId="AD" clId="Web-{F963EB40-0B7E-0384-F4EB-7C8695CD5E04}" dt="2023-04-06T15:59:39.971" v="16" actId="20577"/>
          <ac:spMkLst>
            <pc:docMk/>
            <pc:sldMk cId="0" sldId="265"/>
            <ac:spMk id="15" creationId="{26459B29-9D7A-8D3A-10E5-8ACCC64C384B}"/>
          </ac:spMkLst>
        </pc:spChg>
        <pc:spChg chg="mod">
          <ac:chgData name="Pedro Mauritti Granjo" userId="S::p.granjo@fct.unl.pt::cc7015fd-d343-4901-b4c6-21df2d4ac7a0" providerId="AD" clId="Web-{F963EB40-0B7E-0384-F4EB-7C8695CD5E04}" dt="2023-04-06T15:59:27.924" v="7" actId="20577"/>
          <ac:spMkLst>
            <pc:docMk/>
            <pc:sldMk cId="0" sldId="265"/>
            <ac:spMk id="17" creationId="{B7778D37-0677-1422-E2CF-14EBABF7C88B}"/>
          </ac:spMkLst>
        </pc:spChg>
        <pc:spChg chg="mod">
          <ac:chgData name="Pedro Mauritti Granjo" userId="S::p.granjo@fct.unl.pt::cc7015fd-d343-4901-b4c6-21df2d4ac7a0" providerId="AD" clId="Web-{F963EB40-0B7E-0384-F4EB-7C8695CD5E04}" dt="2023-04-06T15:59:19.642" v="3" actId="20577"/>
          <ac:spMkLst>
            <pc:docMk/>
            <pc:sldMk cId="0" sldId="265"/>
            <ac:spMk id="18" creationId="{3A583798-034C-C5E4-F380-D27ABEA01DF2}"/>
          </ac:spMkLst>
        </pc:spChg>
      </pc:sldChg>
      <pc:sldChg chg="ord">
        <pc:chgData name="Pedro Mauritti Granjo" userId="S::p.granjo@fct.unl.pt::cc7015fd-d343-4901-b4c6-21df2d4ac7a0" providerId="AD" clId="Web-{F963EB40-0B7E-0384-F4EB-7C8695CD5E04}" dt="2023-04-06T16:06:16.471" v="28"/>
        <pc:sldMkLst>
          <pc:docMk/>
          <pc:sldMk cId="0" sldId="269"/>
        </pc:sldMkLst>
      </pc:sldChg>
      <pc:sldChg chg="ord">
        <pc:chgData name="Pedro Mauritti Granjo" userId="S::p.granjo@fct.unl.pt::cc7015fd-d343-4901-b4c6-21df2d4ac7a0" providerId="AD" clId="Web-{F963EB40-0B7E-0384-F4EB-7C8695CD5E04}" dt="2023-04-06T16:06:11.236" v="27"/>
        <pc:sldMkLst>
          <pc:docMk/>
          <pc:sldMk cId="3969417392" sldId="270"/>
        </pc:sldMkLst>
      </pc:sldChg>
      <pc:sldChg chg="modSp">
        <pc:chgData name="Pedro Mauritti Granjo" userId="S::p.granjo@fct.unl.pt::cc7015fd-d343-4901-b4c6-21df2d4ac7a0" providerId="AD" clId="Web-{F963EB40-0B7E-0384-F4EB-7C8695CD5E04}" dt="2023-04-06T16:01:01.412" v="25" actId="20577"/>
        <pc:sldMkLst>
          <pc:docMk/>
          <pc:sldMk cId="2860821069" sldId="278"/>
        </pc:sldMkLst>
        <pc:spChg chg="mod">
          <ac:chgData name="Pedro Mauritti Granjo" userId="S::p.granjo@fct.unl.pt::cc7015fd-d343-4901-b4c6-21df2d4ac7a0" providerId="AD" clId="Web-{F963EB40-0B7E-0384-F4EB-7C8695CD5E04}" dt="2023-04-06T16:01:01.412" v="25" actId="20577"/>
          <ac:spMkLst>
            <pc:docMk/>
            <pc:sldMk cId="2860821069" sldId="278"/>
            <ac:spMk id="6" creationId="{12DA03D6-08FB-04E3-3596-597820281F85}"/>
          </ac:spMkLst>
        </pc:spChg>
      </pc:sldChg>
    </pc:docChg>
  </pc:docChgLst>
  <pc:docChgLst>
    <pc:chgData name="Pedro Mauritti Granjo" userId="S::p.granjo@fct.unl.pt::cc7015fd-d343-4901-b4c6-21df2d4ac7a0" providerId="AD" clId="Web-{7E158F90-1521-DEF8-1AF6-8D81C961392D}"/>
    <pc:docChg chg="addSld delSld modSld">
      <pc:chgData name="Pedro Mauritti Granjo" userId="S::p.granjo@fct.unl.pt::cc7015fd-d343-4901-b4c6-21df2d4ac7a0" providerId="AD" clId="Web-{7E158F90-1521-DEF8-1AF6-8D81C961392D}" dt="2023-04-10T17:32:05.544" v="108"/>
      <pc:docMkLst>
        <pc:docMk/>
      </pc:docMkLst>
      <pc:sldChg chg="addSp delSp modSp delCm">
        <pc:chgData name="Pedro Mauritti Granjo" userId="S::p.granjo@fct.unl.pt::cc7015fd-d343-4901-b4c6-21df2d4ac7a0" providerId="AD" clId="Web-{7E158F90-1521-DEF8-1AF6-8D81C961392D}" dt="2023-04-10T17:32:05.544" v="108"/>
        <pc:sldMkLst>
          <pc:docMk/>
          <pc:sldMk cId="0" sldId="257"/>
        </pc:sldMkLst>
        <pc:picChg chg="del mod">
          <ac:chgData name="Pedro Mauritti Granjo" userId="S::p.granjo@fct.unl.pt::cc7015fd-d343-4901-b4c6-21df2d4ac7a0" providerId="AD" clId="Web-{7E158F90-1521-DEF8-1AF6-8D81C961392D}" dt="2023-04-10T11:16:28.212" v="10"/>
          <ac:picMkLst>
            <pc:docMk/>
            <pc:sldMk cId="0" sldId="257"/>
            <ac:picMk id="2" creationId="{57BE5229-86FA-BE63-2996-3173BE55BA93}"/>
          </ac:picMkLst>
        </pc:picChg>
        <pc:picChg chg="add mod">
          <ac:chgData name="Pedro Mauritti Granjo" userId="S::p.granjo@fct.unl.pt::cc7015fd-d343-4901-b4c6-21df2d4ac7a0" providerId="AD" clId="Web-{7E158F90-1521-DEF8-1AF6-8D81C961392D}" dt="2023-04-10T11:16:51.776" v="15" actId="1076"/>
          <ac:picMkLst>
            <pc:docMk/>
            <pc:sldMk cId="0" sldId="257"/>
            <ac:picMk id="3" creationId="{5DDC308A-06F6-6186-22BC-5977B30E3AF4}"/>
          </ac:picMkLst>
        </pc:picChg>
      </pc:sldChg>
      <pc:sldChg chg="addSp delSp modSp">
        <pc:chgData name="Pedro Mauritti Granjo" userId="S::p.granjo@fct.unl.pt::cc7015fd-d343-4901-b4c6-21df2d4ac7a0" providerId="AD" clId="Web-{7E158F90-1521-DEF8-1AF6-8D81C961392D}" dt="2023-04-10T14:01:20.230" v="39" actId="1076"/>
        <pc:sldMkLst>
          <pc:docMk/>
          <pc:sldMk cId="0" sldId="258"/>
        </pc:sldMkLst>
        <pc:picChg chg="add mod ord">
          <ac:chgData name="Pedro Mauritti Granjo" userId="S::p.granjo@fct.unl.pt::cc7015fd-d343-4901-b4c6-21df2d4ac7a0" providerId="AD" clId="Web-{7E158F90-1521-DEF8-1AF6-8D81C961392D}" dt="2023-04-10T14:01:20.230" v="39" actId="1076"/>
          <ac:picMkLst>
            <pc:docMk/>
            <pc:sldMk cId="0" sldId="258"/>
            <ac:picMk id="2" creationId="{536AD823-C67F-162A-02CA-CE8CB2A6FBCC}"/>
          </ac:picMkLst>
        </pc:picChg>
        <pc:picChg chg="del">
          <ac:chgData name="Pedro Mauritti Granjo" userId="S::p.granjo@fct.unl.pt::cc7015fd-d343-4901-b4c6-21df2d4ac7a0" providerId="AD" clId="Web-{7E158F90-1521-DEF8-1AF6-8D81C961392D}" dt="2023-04-10T14:00:56.166" v="30"/>
          <ac:picMkLst>
            <pc:docMk/>
            <pc:sldMk cId="0" sldId="258"/>
            <ac:picMk id="6" creationId="{DFA50E87-E767-D55F-8A7A-B9C3ADEDD55B}"/>
          </ac:picMkLst>
        </pc:picChg>
      </pc:sldChg>
      <pc:sldChg chg="addSp delSp modSp">
        <pc:chgData name="Pedro Mauritti Granjo" userId="S::p.granjo@fct.unl.pt::cc7015fd-d343-4901-b4c6-21df2d4ac7a0" providerId="AD" clId="Web-{7E158F90-1521-DEF8-1AF6-8D81C961392D}" dt="2023-04-10T17:23:11.802" v="78" actId="14100"/>
        <pc:sldMkLst>
          <pc:docMk/>
          <pc:sldMk cId="0" sldId="259"/>
        </pc:sldMkLst>
        <pc:spChg chg="mod">
          <ac:chgData name="Pedro Mauritti Granjo" userId="S::p.granjo@fct.unl.pt::cc7015fd-d343-4901-b4c6-21df2d4ac7a0" providerId="AD" clId="Web-{7E158F90-1521-DEF8-1AF6-8D81C961392D}" dt="2023-04-10T17:23:11.802" v="78" actId="14100"/>
          <ac:spMkLst>
            <pc:docMk/>
            <pc:sldMk cId="0" sldId="259"/>
            <ac:spMk id="74" creationId="{00000000-0000-0000-0000-000000000000}"/>
          </ac:spMkLst>
        </pc:spChg>
        <pc:picChg chg="add del mod">
          <ac:chgData name="Pedro Mauritti Granjo" userId="S::p.granjo@fct.unl.pt::cc7015fd-d343-4901-b4c6-21df2d4ac7a0" providerId="AD" clId="Web-{7E158F90-1521-DEF8-1AF6-8D81C961392D}" dt="2023-04-10T17:20:54.203" v="58"/>
          <ac:picMkLst>
            <pc:docMk/>
            <pc:sldMk cId="0" sldId="259"/>
            <ac:picMk id="2" creationId="{E27BA186-4302-95F9-AAE8-5C51E376DF09}"/>
          </ac:picMkLst>
        </pc:picChg>
        <pc:picChg chg="add mod">
          <ac:chgData name="Pedro Mauritti Granjo" userId="S::p.granjo@fct.unl.pt::cc7015fd-d343-4901-b4c6-21df2d4ac7a0" providerId="AD" clId="Web-{7E158F90-1521-DEF8-1AF6-8D81C961392D}" dt="2023-04-10T17:21:02.875" v="64" actId="14100"/>
          <ac:picMkLst>
            <pc:docMk/>
            <pc:sldMk cId="0" sldId="259"/>
            <ac:picMk id="3" creationId="{838991EB-BAB0-4236-8B3E-43CB22F7FDF4}"/>
          </ac:picMkLst>
        </pc:picChg>
        <pc:picChg chg="del">
          <ac:chgData name="Pedro Mauritti Granjo" userId="S::p.granjo@fct.unl.pt::cc7015fd-d343-4901-b4c6-21df2d4ac7a0" providerId="AD" clId="Web-{7E158F90-1521-DEF8-1AF6-8D81C961392D}" dt="2023-04-10T13:55:15.764" v="16"/>
          <ac:picMkLst>
            <pc:docMk/>
            <pc:sldMk cId="0" sldId="259"/>
            <ac:picMk id="4" creationId="{C4165B28-8764-70E2-7BDE-88849914D3BA}"/>
          </ac:picMkLst>
        </pc:picChg>
      </pc:sldChg>
      <pc:sldChg chg="addSp delSp modSp">
        <pc:chgData name="Pedro Mauritti Granjo" userId="S::p.granjo@fct.unl.pt::cc7015fd-d343-4901-b4c6-21df2d4ac7a0" providerId="AD" clId="Web-{7E158F90-1521-DEF8-1AF6-8D81C961392D}" dt="2023-04-10T17:23:02.865" v="77" actId="1076"/>
        <pc:sldMkLst>
          <pc:docMk/>
          <pc:sldMk cId="0" sldId="261"/>
        </pc:sldMkLst>
        <pc:spChg chg="mod">
          <ac:chgData name="Pedro Mauritti Granjo" userId="S::p.granjo@fct.unl.pt::cc7015fd-d343-4901-b4c6-21df2d4ac7a0" providerId="AD" clId="Web-{7E158F90-1521-DEF8-1AF6-8D81C961392D}" dt="2023-04-10T17:23:02.865" v="77" actId="1076"/>
          <ac:spMkLst>
            <pc:docMk/>
            <pc:sldMk cId="0" sldId="261"/>
            <ac:spMk id="86" creationId="{00000000-0000-0000-0000-000000000000}"/>
          </ac:spMkLst>
        </pc:spChg>
        <pc:picChg chg="add mod">
          <ac:chgData name="Pedro Mauritti Granjo" userId="S::p.granjo@fct.unl.pt::cc7015fd-d343-4901-b4c6-21df2d4ac7a0" providerId="AD" clId="Web-{7E158F90-1521-DEF8-1AF6-8D81C961392D}" dt="2023-04-10T17:22:57.692" v="76" actId="1076"/>
          <ac:picMkLst>
            <pc:docMk/>
            <pc:sldMk cId="0" sldId="261"/>
            <ac:picMk id="2" creationId="{1B8A8E55-56E8-3DD3-0408-AF6D0A85A482}"/>
          </ac:picMkLst>
        </pc:picChg>
        <pc:picChg chg="add del">
          <ac:chgData name="Pedro Mauritti Granjo" userId="S::p.granjo@fct.unl.pt::cc7015fd-d343-4901-b4c6-21df2d4ac7a0" providerId="AD" clId="Web-{7E158F90-1521-DEF8-1AF6-8D81C961392D}" dt="2023-04-10T17:22:54.052" v="69"/>
          <ac:picMkLst>
            <pc:docMk/>
            <pc:sldMk cId="0" sldId="261"/>
            <ac:picMk id="87" creationId="{00000000-0000-0000-0000-000000000000}"/>
          </ac:picMkLst>
        </pc:picChg>
      </pc:sldChg>
      <pc:sldChg chg="addSp delSp modSp">
        <pc:chgData name="Pedro Mauritti Granjo" userId="S::p.granjo@fct.unl.pt::cc7015fd-d343-4901-b4c6-21df2d4ac7a0" providerId="AD" clId="Web-{7E158F90-1521-DEF8-1AF6-8D81C961392D}" dt="2023-04-10T17:23:55.632" v="86" actId="1076"/>
        <pc:sldMkLst>
          <pc:docMk/>
          <pc:sldMk cId="0" sldId="262"/>
        </pc:sldMkLst>
        <pc:spChg chg="mod">
          <ac:chgData name="Pedro Mauritti Granjo" userId="S::p.granjo@fct.unl.pt::cc7015fd-d343-4901-b4c6-21df2d4ac7a0" providerId="AD" clId="Web-{7E158F90-1521-DEF8-1AF6-8D81C961392D}" dt="2023-04-10T17:23:55.632" v="86" actId="1076"/>
          <ac:spMkLst>
            <pc:docMk/>
            <pc:sldMk cId="0" sldId="262"/>
            <ac:spMk id="92" creationId="{00000000-0000-0000-0000-000000000000}"/>
          </ac:spMkLst>
        </pc:spChg>
        <pc:picChg chg="add mod">
          <ac:chgData name="Pedro Mauritti Granjo" userId="S::p.granjo@fct.unl.pt::cc7015fd-d343-4901-b4c6-21df2d4ac7a0" providerId="AD" clId="Web-{7E158F90-1521-DEF8-1AF6-8D81C961392D}" dt="2023-04-10T17:23:52.913" v="85" actId="1076"/>
          <ac:picMkLst>
            <pc:docMk/>
            <pc:sldMk cId="0" sldId="262"/>
            <ac:picMk id="2" creationId="{28697035-465E-9A2F-6AA2-A7F343F14D7D}"/>
          </ac:picMkLst>
        </pc:picChg>
        <pc:picChg chg="del">
          <ac:chgData name="Pedro Mauritti Granjo" userId="S::p.granjo@fct.unl.pt::cc7015fd-d343-4901-b4c6-21df2d4ac7a0" providerId="AD" clId="Web-{7E158F90-1521-DEF8-1AF6-8D81C961392D}" dt="2023-04-10T17:23:19.209" v="79"/>
          <ac:picMkLst>
            <pc:docMk/>
            <pc:sldMk cId="0" sldId="262"/>
            <ac:picMk id="3" creationId="{43B25BA1-B752-3E01-ED2D-6FFAD55F49BA}"/>
          </ac:picMkLst>
        </pc:picChg>
      </pc:sldChg>
      <pc:sldChg chg="addSp delSp modSp">
        <pc:chgData name="Pedro Mauritti Granjo" userId="S::p.granjo@fct.unl.pt::cc7015fd-d343-4901-b4c6-21df2d4ac7a0" providerId="AD" clId="Web-{7E158F90-1521-DEF8-1AF6-8D81C961392D}" dt="2023-04-10T17:24:44.916" v="97" actId="14100"/>
        <pc:sldMkLst>
          <pc:docMk/>
          <pc:sldMk cId="0" sldId="268"/>
        </pc:sldMkLst>
        <pc:spChg chg="mod">
          <ac:chgData name="Pedro Mauritti Granjo" userId="S::p.granjo@fct.unl.pt::cc7015fd-d343-4901-b4c6-21df2d4ac7a0" providerId="AD" clId="Web-{7E158F90-1521-DEF8-1AF6-8D81C961392D}" dt="2023-04-10T17:24:44.916" v="97" actId="14100"/>
          <ac:spMkLst>
            <pc:docMk/>
            <pc:sldMk cId="0" sldId="268"/>
            <ac:spMk id="133" creationId="{00000000-0000-0000-0000-000000000000}"/>
          </ac:spMkLst>
        </pc:spChg>
        <pc:picChg chg="add mod">
          <ac:chgData name="Pedro Mauritti Granjo" userId="S::p.granjo@fct.unl.pt::cc7015fd-d343-4901-b4c6-21df2d4ac7a0" providerId="AD" clId="Web-{7E158F90-1521-DEF8-1AF6-8D81C961392D}" dt="2023-04-10T17:24:39.072" v="94" actId="1076"/>
          <ac:picMkLst>
            <pc:docMk/>
            <pc:sldMk cId="0" sldId="268"/>
            <ac:picMk id="2" creationId="{BB6E25D3-AA72-29F1-B0CD-A4188339AF33}"/>
          </ac:picMkLst>
        </pc:picChg>
        <pc:picChg chg="del">
          <ac:chgData name="Pedro Mauritti Granjo" userId="S::p.granjo@fct.unl.pt::cc7015fd-d343-4901-b4c6-21df2d4ac7a0" providerId="AD" clId="Web-{7E158F90-1521-DEF8-1AF6-8D81C961392D}" dt="2023-04-10T17:24:36.103" v="90"/>
          <ac:picMkLst>
            <pc:docMk/>
            <pc:sldMk cId="0" sldId="268"/>
            <ac:picMk id="134" creationId="{00000000-0000-0000-0000-000000000000}"/>
          </ac:picMkLst>
        </pc:picChg>
      </pc:sldChg>
      <pc:sldChg chg="addSp delSp modSp">
        <pc:chgData name="Pedro Mauritti Granjo" userId="S::p.granjo@fct.unl.pt::cc7015fd-d343-4901-b4c6-21df2d4ac7a0" providerId="AD" clId="Web-{7E158F90-1521-DEF8-1AF6-8D81C961392D}" dt="2023-04-10T17:31:39.542" v="107" actId="1076"/>
        <pc:sldMkLst>
          <pc:docMk/>
          <pc:sldMk cId="0" sldId="269"/>
        </pc:sldMkLst>
        <pc:picChg chg="add mod">
          <ac:chgData name="Pedro Mauritti Granjo" userId="S::p.granjo@fct.unl.pt::cc7015fd-d343-4901-b4c6-21df2d4ac7a0" providerId="AD" clId="Web-{7E158F90-1521-DEF8-1AF6-8D81C961392D}" dt="2023-04-10T17:31:39.542" v="107" actId="1076"/>
          <ac:picMkLst>
            <pc:docMk/>
            <pc:sldMk cId="0" sldId="269"/>
            <ac:picMk id="2" creationId="{A7FEDB74-F47E-AF04-B389-B979C5F955BA}"/>
          </ac:picMkLst>
        </pc:picChg>
        <pc:picChg chg="del">
          <ac:chgData name="Pedro Mauritti Granjo" userId="S::p.granjo@fct.unl.pt::cc7015fd-d343-4901-b4c6-21df2d4ac7a0" providerId="AD" clId="Web-{7E158F90-1521-DEF8-1AF6-8D81C961392D}" dt="2023-04-10T17:24:03.179" v="87"/>
          <ac:picMkLst>
            <pc:docMk/>
            <pc:sldMk cId="0" sldId="269"/>
            <ac:picMk id="3" creationId="{4694CD79-4D8C-DD3E-898A-13B0217B1149}"/>
          </ac:picMkLst>
        </pc:picChg>
      </pc:sldChg>
      <pc:sldChg chg="add del">
        <pc:chgData name="Pedro Mauritti Granjo" userId="S::p.granjo@fct.unl.pt::cc7015fd-d343-4901-b4c6-21df2d4ac7a0" providerId="AD" clId="Web-{7E158F90-1521-DEF8-1AF6-8D81C961392D}" dt="2023-04-10T17:24:07.383" v="89"/>
        <pc:sldMkLst>
          <pc:docMk/>
          <pc:sldMk cId="3969417392" sldId="270"/>
        </pc:sldMkLst>
      </pc:sldChg>
      <pc:sldChg chg="addSp delSp modSp">
        <pc:chgData name="Pedro Mauritti Granjo" userId="S::p.granjo@fct.unl.pt::cc7015fd-d343-4901-b4c6-21df2d4ac7a0" providerId="AD" clId="Web-{7E158F90-1521-DEF8-1AF6-8D81C961392D}" dt="2023-04-10T10:01:45.882" v="8" actId="1076"/>
        <pc:sldMkLst>
          <pc:docMk/>
          <pc:sldMk cId="2756113789" sldId="276"/>
        </pc:sldMkLst>
        <pc:picChg chg="add mod">
          <ac:chgData name="Pedro Mauritti Granjo" userId="S::p.granjo@fct.unl.pt::cc7015fd-d343-4901-b4c6-21df2d4ac7a0" providerId="AD" clId="Web-{7E158F90-1521-DEF8-1AF6-8D81C961392D}" dt="2023-04-10T10:01:45.882" v="8" actId="1076"/>
          <ac:picMkLst>
            <pc:docMk/>
            <pc:sldMk cId="2756113789" sldId="276"/>
            <ac:picMk id="2" creationId="{B44CD487-1603-9C76-DD68-FA1C0442A0A3}"/>
          </ac:picMkLst>
        </pc:picChg>
        <pc:picChg chg="del">
          <ac:chgData name="Pedro Mauritti Granjo" userId="S::p.granjo@fct.unl.pt::cc7015fd-d343-4901-b4c6-21df2d4ac7a0" providerId="AD" clId="Web-{7E158F90-1521-DEF8-1AF6-8D81C961392D}" dt="2023-04-10T10:01:32.288" v="0"/>
          <ac:picMkLst>
            <pc:docMk/>
            <pc:sldMk cId="2756113789" sldId="276"/>
            <ac:picMk id="4" creationId="{92A97926-EA02-D064-965B-88B7DCDE693C}"/>
          </ac:picMkLst>
        </pc:picChg>
      </pc:sldChg>
    </pc:docChg>
  </pc:docChgLst>
  <pc:docChgLst>
    <pc:chgData clId="Web-{AF7CB4B2-F607-7683-9CD9-0507A4C90672}"/>
    <pc:docChg chg="addSld">
      <pc:chgData name="" userId="" providerId="" clId="Web-{AF7CB4B2-F607-7683-9CD9-0507A4C90672}" dt="2023-04-14T11:05:39.305" v="0"/>
      <pc:docMkLst>
        <pc:docMk/>
      </pc:docMkLst>
      <pc:sldChg chg="add">
        <pc:chgData name="" userId="" providerId="" clId="Web-{AF7CB4B2-F607-7683-9CD9-0507A4C90672}" dt="2023-04-14T11:05:39.305" v="0"/>
        <pc:sldMkLst>
          <pc:docMk/>
          <pc:sldMk cId="3746764528" sldId="281"/>
        </pc:sldMkLst>
      </pc:sldChg>
    </pc:docChg>
  </pc:docChgLst>
  <pc:docChgLst>
    <pc:chgData name="Pedro Mauritti Granjo" userId="S::p.granjo@fct.unl.pt::cc7015fd-d343-4901-b4c6-21df2d4ac7a0" providerId="AD" clId="Web-{4962CAC6-2498-CEAE-E456-174DF8766741}"/>
    <pc:docChg chg="addSld delSld modSld sldOrd">
      <pc:chgData name="Pedro Mauritti Granjo" userId="S::p.granjo@fct.unl.pt::cc7015fd-d343-4901-b4c6-21df2d4ac7a0" providerId="AD" clId="Web-{4962CAC6-2498-CEAE-E456-174DF8766741}" dt="2023-04-13T16:00:12.272" v="391" actId="20577"/>
      <pc:docMkLst>
        <pc:docMk/>
      </pc:docMkLst>
      <pc:sldChg chg="addSp delSp modSp">
        <pc:chgData name="Pedro Mauritti Granjo" userId="S::p.granjo@fct.unl.pt::cc7015fd-d343-4901-b4c6-21df2d4ac7a0" providerId="AD" clId="Web-{4962CAC6-2498-CEAE-E456-174DF8766741}" dt="2023-04-13T15:41:50.454" v="375" actId="1076"/>
        <pc:sldMkLst>
          <pc:docMk/>
          <pc:sldMk cId="0" sldId="257"/>
        </pc:sldMkLst>
        <pc:spChg chg="mod">
          <ac:chgData name="Pedro Mauritti Granjo" userId="S::p.granjo@fct.unl.pt::cc7015fd-d343-4901-b4c6-21df2d4ac7a0" providerId="AD" clId="Web-{4962CAC6-2498-CEAE-E456-174DF8766741}" dt="2023-04-13T15:29:44.116" v="358" actId="20577"/>
          <ac:spMkLst>
            <pc:docMk/>
            <pc:sldMk cId="0" sldId="257"/>
            <ac:spMk id="62" creationId="{00000000-0000-0000-0000-000000000000}"/>
          </ac:spMkLst>
        </pc:spChg>
        <pc:picChg chg="add del mod">
          <ac:chgData name="Pedro Mauritti Granjo" userId="S::p.granjo@fct.unl.pt::cc7015fd-d343-4901-b4c6-21df2d4ac7a0" providerId="AD" clId="Web-{4962CAC6-2498-CEAE-E456-174DF8766741}" dt="2023-04-13T15:41:22.499" v="369"/>
          <ac:picMkLst>
            <pc:docMk/>
            <pc:sldMk cId="0" sldId="257"/>
            <ac:picMk id="2" creationId="{5A90BA40-394D-E701-8058-0C26411D4884}"/>
          </ac:picMkLst>
        </pc:picChg>
        <pc:picChg chg="del">
          <ac:chgData name="Pedro Mauritti Granjo" userId="S::p.granjo@fct.unl.pt::cc7015fd-d343-4901-b4c6-21df2d4ac7a0" providerId="AD" clId="Web-{4962CAC6-2498-CEAE-E456-174DF8766741}" dt="2023-04-13T15:29:18.287" v="346"/>
          <ac:picMkLst>
            <pc:docMk/>
            <pc:sldMk cId="0" sldId="257"/>
            <ac:picMk id="3" creationId="{5DDC308A-06F6-6186-22BC-5977B30E3AF4}"/>
          </ac:picMkLst>
        </pc:picChg>
        <pc:picChg chg="add mod">
          <ac:chgData name="Pedro Mauritti Granjo" userId="S::p.granjo@fct.unl.pt::cc7015fd-d343-4901-b4c6-21df2d4ac7a0" providerId="AD" clId="Web-{4962CAC6-2498-CEAE-E456-174DF8766741}" dt="2023-04-13T15:41:50.454" v="375" actId="1076"/>
          <ac:picMkLst>
            <pc:docMk/>
            <pc:sldMk cId="0" sldId="257"/>
            <ac:picMk id="4" creationId="{9D8E85F1-589A-3BFF-5D1F-1CCD1963AEC7}"/>
          </ac:picMkLst>
        </pc:picChg>
      </pc:sldChg>
      <pc:sldChg chg="addSp delSp modSp">
        <pc:chgData name="Pedro Mauritti Granjo" userId="S::p.granjo@fct.unl.pt::cc7015fd-d343-4901-b4c6-21df2d4ac7a0" providerId="AD" clId="Web-{4962CAC6-2498-CEAE-E456-174DF8766741}" dt="2023-04-13T15:59:49.631" v="384" actId="20577"/>
        <pc:sldMkLst>
          <pc:docMk/>
          <pc:sldMk cId="0" sldId="258"/>
        </pc:sldMkLst>
        <pc:spChg chg="mod">
          <ac:chgData name="Pedro Mauritti Granjo" userId="S::p.granjo@fct.unl.pt::cc7015fd-d343-4901-b4c6-21df2d4ac7a0" providerId="AD" clId="Web-{4962CAC6-2498-CEAE-E456-174DF8766741}" dt="2023-04-13T15:59:49.631" v="384" actId="20577"/>
          <ac:spMkLst>
            <pc:docMk/>
            <pc:sldMk cId="0" sldId="258"/>
            <ac:spMk id="68" creationId="{00000000-0000-0000-0000-000000000000}"/>
          </ac:spMkLst>
        </pc:spChg>
        <pc:picChg chg="del">
          <ac:chgData name="Pedro Mauritti Granjo" userId="S::p.granjo@fct.unl.pt::cc7015fd-d343-4901-b4c6-21df2d4ac7a0" providerId="AD" clId="Web-{4962CAC6-2498-CEAE-E456-174DF8766741}" dt="2023-04-13T15:42:21.236" v="376"/>
          <ac:picMkLst>
            <pc:docMk/>
            <pc:sldMk cId="0" sldId="258"/>
            <ac:picMk id="2" creationId="{536AD823-C67F-162A-02CA-CE8CB2A6FBCC}"/>
          </ac:picMkLst>
        </pc:picChg>
        <pc:picChg chg="add mod">
          <ac:chgData name="Pedro Mauritti Granjo" userId="S::p.granjo@fct.unl.pt::cc7015fd-d343-4901-b4c6-21df2d4ac7a0" providerId="AD" clId="Web-{4962CAC6-2498-CEAE-E456-174DF8766741}" dt="2023-04-13T15:42:31.502" v="382" actId="14100"/>
          <ac:picMkLst>
            <pc:docMk/>
            <pc:sldMk cId="0" sldId="258"/>
            <ac:picMk id="3" creationId="{ABAD9D7C-5736-46BC-6148-A2CB34EAE4A1}"/>
          </ac:picMkLst>
        </pc:picChg>
      </pc:sldChg>
      <pc:sldChg chg="addSp delSp modSp">
        <pc:chgData name="Pedro Mauritti Granjo" userId="S::p.granjo@fct.unl.pt::cc7015fd-d343-4901-b4c6-21df2d4ac7a0" providerId="AD" clId="Web-{4962CAC6-2498-CEAE-E456-174DF8766741}" dt="2023-04-13T15:59:55.334" v="387" actId="20577"/>
        <pc:sldMkLst>
          <pc:docMk/>
          <pc:sldMk cId="0" sldId="259"/>
        </pc:sldMkLst>
        <pc:spChg chg="mod">
          <ac:chgData name="Pedro Mauritti Granjo" userId="S::p.granjo@fct.unl.pt::cc7015fd-d343-4901-b4c6-21df2d4ac7a0" providerId="AD" clId="Web-{4962CAC6-2498-CEAE-E456-174DF8766741}" dt="2023-04-13T15:59:55.334" v="387" actId="20577"/>
          <ac:spMkLst>
            <pc:docMk/>
            <pc:sldMk cId="0" sldId="259"/>
            <ac:spMk id="74" creationId="{00000000-0000-0000-0000-000000000000}"/>
          </ac:spMkLst>
        </pc:spChg>
        <pc:picChg chg="add mod">
          <ac:chgData name="Pedro Mauritti Granjo" userId="S::p.granjo@fct.unl.pt::cc7015fd-d343-4901-b4c6-21df2d4ac7a0" providerId="AD" clId="Web-{4962CAC6-2498-CEAE-E456-174DF8766741}" dt="2023-04-13T11:42:44.017" v="133" actId="14100"/>
          <ac:picMkLst>
            <pc:docMk/>
            <pc:sldMk cId="0" sldId="259"/>
            <ac:picMk id="2" creationId="{1BB81FD1-AC54-1AA1-5231-39C2B279EE46}"/>
          </ac:picMkLst>
        </pc:picChg>
        <pc:picChg chg="del">
          <ac:chgData name="Pedro Mauritti Granjo" userId="S::p.granjo@fct.unl.pt::cc7015fd-d343-4901-b4c6-21df2d4ac7a0" providerId="AD" clId="Web-{4962CAC6-2498-CEAE-E456-174DF8766741}" dt="2023-04-13T11:41:41.249" v="116"/>
          <ac:picMkLst>
            <pc:docMk/>
            <pc:sldMk cId="0" sldId="259"/>
            <ac:picMk id="3" creationId="{838991EB-BAB0-4236-8B3E-43CB22F7FDF4}"/>
          </ac:picMkLst>
        </pc:picChg>
      </pc:sldChg>
      <pc:sldChg chg="addSp delSp modSp">
        <pc:chgData name="Pedro Mauritti Granjo" userId="S::p.granjo@fct.unl.pt::cc7015fd-d343-4901-b4c6-21df2d4ac7a0" providerId="AD" clId="Web-{4962CAC6-2498-CEAE-E456-174DF8766741}" dt="2023-04-13T15:59:58.162" v="388" actId="20577"/>
        <pc:sldMkLst>
          <pc:docMk/>
          <pc:sldMk cId="0" sldId="260"/>
        </pc:sldMkLst>
        <pc:spChg chg="mod">
          <ac:chgData name="Pedro Mauritti Granjo" userId="S::p.granjo@fct.unl.pt::cc7015fd-d343-4901-b4c6-21df2d4ac7a0" providerId="AD" clId="Web-{4962CAC6-2498-CEAE-E456-174DF8766741}" dt="2023-04-13T15:59:58.162" v="388" actId="20577"/>
          <ac:spMkLst>
            <pc:docMk/>
            <pc:sldMk cId="0" sldId="260"/>
            <ac:spMk id="80" creationId="{00000000-0000-0000-0000-000000000000}"/>
          </ac:spMkLst>
        </pc:spChg>
        <pc:picChg chg="add del mod">
          <ac:chgData name="Pedro Mauritti Granjo" userId="S::p.granjo@fct.unl.pt::cc7015fd-d343-4901-b4c6-21df2d4ac7a0" providerId="AD" clId="Web-{4962CAC6-2498-CEAE-E456-174DF8766741}" dt="2023-04-13T11:41:42.749" v="117"/>
          <ac:picMkLst>
            <pc:docMk/>
            <pc:sldMk cId="0" sldId="260"/>
            <ac:picMk id="2" creationId="{2BDD5136-70BA-14F5-6516-531778881899}"/>
          </ac:picMkLst>
        </pc:picChg>
        <pc:picChg chg="add mod">
          <ac:chgData name="Pedro Mauritti Granjo" userId="S::p.granjo@fct.unl.pt::cc7015fd-d343-4901-b4c6-21df2d4ac7a0" providerId="AD" clId="Web-{4962CAC6-2498-CEAE-E456-174DF8766741}" dt="2023-04-13T13:21:19.379" v="144" actId="1076"/>
          <ac:picMkLst>
            <pc:docMk/>
            <pc:sldMk cId="0" sldId="260"/>
            <ac:picMk id="2" creationId="{66136878-FA69-9E20-2FCE-B358F107E94B}"/>
          </ac:picMkLst>
        </pc:picChg>
        <pc:picChg chg="del">
          <ac:chgData name="Pedro Mauritti Granjo" userId="S::p.granjo@fct.unl.pt::cc7015fd-d343-4901-b4c6-21df2d4ac7a0" providerId="AD" clId="Web-{4962CAC6-2498-CEAE-E456-174DF8766741}" dt="2023-04-13T11:20:44.818" v="45"/>
          <ac:picMkLst>
            <pc:docMk/>
            <pc:sldMk cId="0" sldId="260"/>
            <ac:picMk id="3" creationId="{3B6B98F1-3581-9D77-AA3D-E79485E93143}"/>
          </ac:picMkLst>
        </pc:picChg>
        <pc:picChg chg="add del mod">
          <ac:chgData name="Pedro Mauritti Granjo" userId="S::p.granjo@fct.unl.pt::cc7015fd-d343-4901-b4c6-21df2d4ac7a0" providerId="AD" clId="Web-{4962CAC6-2498-CEAE-E456-174DF8766741}" dt="2023-04-13T11:42:06.219" v="119"/>
          <ac:picMkLst>
            <pc:docMk/>
            <pc:sldMk cId="0" sldId="260"/>
            <ac:picMk id="4" creationId="{C671AD07-D405-A1C7-4362-2D7261C2FC75}"/>
          </ac:picMkLst>
        </pc:picChg>
        <pc:picChg chg="add del mod">
          <ac:chgData name="Pedro Mauritti Granjo" userId="S::p.granjo@fct.unl.pt::cc7015fd-d343-4901-b4c6-21df2d4ac7a0" providerId="AD" clId="Web-{4962CAC6-2498-CEAE-E456-174DF8766741}" dt="2023-04-13T11:42:23.469" v="123"/>
          <ac:picMkLst>
            <pc:docMk/>
            <pc:sldMk cId="0" sldId="260"/>
            <ac:picMk id="5" creationId="{D6088BC5-E216-928B-A508-F35D5AC56742}"/>
          </ac:picMkLst>
        </pc:picChg>
        <pc:picChg chg="add del mod">
          <ac:chgData name="Pedro Mauritti Granjo" userId="S::p.granjo@fct.unl.pt::cc7015fd-d343-4901-b4c6-21df2d4ac7a0" providerId="AD" clId="Web-{4962CAC6-2498-CEAE-E456-174DF8766741}" dt="2023-04-13T13:21:08.988" v="139"/>
          <ac:picMkLst>
            <pc:docMk/>
            <pc:sldMk cId="0" sldId="260"/>
            <ac:picMk id="6" creationId="{691D7C31-0A9D-C4B1-F646-8C9A270541EA}"/>
          </ac:picMkLst>
        </pc:picChg>
      </pc:sldChg>
      <pc:sldChg chg="addSp delSp modSp">
        <pc:chgData name="Pedro Mauritti Granjo" userId="S::p.granjo@fct.unl.pt::cc7015fd-d343-4901-b4c6-21df2d4ac7a0" providerId="AD" clId="Web-{4962CAC6-2498-CEAE-E456-174DF8766741}" dt="2023-04-13T16:00:01.600" v="389" actId="20577"/>
        <pc:sldMkLst>
          <pc:docMk/>
          <pc:sldMk cId="0" sldId="261"/>
        </pc:sldMkLst>
        <pc:spChg chg="mod">
          <ac:chgData name="Pedro Mauritti Granjo" userId="S::p.granjo@fct.unl.pt::cc7015fd-d343-4901-b4c6-21df2d4ac7a0" providerId="AD" clId="Web-{4962CAC6-2498-CEAE-E456-174DF8766741}" dt="2023-04-13T16:00:01.600" v="389" actId="20577"/>
          <ac:spMkLst>
            <pc:docMk/>
            <pc:sldMk cId="0" sldId="261"/>
            <ac:spMk id="86" creationId="{00000000-0000-0000-0000-000000000000}"/>
          </ac:spMkLst>
        </pc:spChg>
        <pc:picChg chg="del">
          <ac:chgData name="Pedro Mauritti Granjo" userId="S::p.granjo@fct.unl.pt::cc7015fd-d343-4901-b4c6-21df2d4ac7a0" providerId="AD" clId="Web-{4962CAC6-2498-CEAE-E456-174DF8766741}" dt="2023-04-13T11:19:35.456" v="29"/>
          <ac:picMkLst>
            <pc:docMk/>
            <pc:sldMk cId="0" sldId="261"/>
            <ac:picMk id="2" creationId="{1B8A8E55-56E8-3DD3-0408-AF6D0A85A482}"/>
          </ac:picMkLst>
        </pc:picChg>
        <pc:picChg chg="add del mod">
          <ac:chgData name="Pedro Mauritti Granjo" userId="S::p.granjo@fct.unl.pt::cc7015fd-d343-4901-b4c6-21df2d4ac7a0" providerId="AD" clId="Web-{4962CAC6-2498-CEAE-E456-174DF8766741}" dt="2023-04-13T15:40:46.795" v="360"/>
          <ac:picMkLst>
            <pc:docMk/>
            <pc:sldMk cId="0" sldId="261"/>
            <ac:picMk id="2" creationId="{42D4EC84-06A5-FD9D-00CA-0A486B1B64B5}"/>
          </ac:picMkLst>
        </pc:picChg>
        <pc:picChg chg="add del mod">
          <ac:chgData name="Pedro Mauritti Granjo" userId="S::p.granjo@fct.unl.pt::cc7015fd-d343-4901-b4c6-21df2d4ac7a0" providerId="AD" clId="Web-{4962CAC6-2498-CEAE-E456-174DF8766741}" dt="2023-04-13T15:26:06.312" v="336"/>
          <ac:picMkLst>
            <pc:docMk/>
            <pc:sldMk cId="0" sldId="261"/>
            <ac:picMk id="3" creationId="{1117011A-950A-E6C9-7165-F5AB6944203C}"/>
          </ac:picMkLst>
        </pc:picChg>
        <pc:picChg chg="add mod">
          <ac:chgData name="Pedro Mauritti Granjo" userId="S::p.granjo@fct.unl.pt::cc7015fd-d343-4901-b4c6-21df2d4ac7a0" providerId="AD" clId="Web-{4962CAC6-2498-CEAE-E456-174DF8766741}" dt="2023-04-13T15:41:15.593" v="368" actId="1076"/>
          <ac:picMkLst>
            <pc:docMk/>
            <pc:sldMk cId="0" sldId="261"/>
            <ac:picMk id="4" creationId="{587C36D6-FF68-CB00-36FC-A2A2EA7B1001}"/>
          </ac:picMkLst>
        </pc:picChg>
      </pc:sldChg>
      <pc:sldChg chg="delSp del">
        <pc:chgData name="Pedro Mauritti Granjo" userId="S::p.granjo@fct.unl.pt::cc7015fd-d343-4901-b4c6-21df2d4ac7a0" providerId="AD" clId="Web-{4962CAC6-2498-CEAE-E456-174DF8766741}" dt="2023-04-13T11:20:10.489" v="43"/>
        <pc:sldMkLst>
          <pc:docMk/>
          <pc:sldMk cId="0" sldId="262"/>
        </pc:sldMkLst>
        <pc:picChg chg="del">
          <ac:chgData name="Pedro Mauritti Granjo" userId="S::p.granjo@fct.unl.pt::cc7015fd-d343-4901-b4c6-21df2d4ac7a0" providerId="AD" clId="Web-{4962CAC6-2498-CEAE-E456-174DF8766741}" dt="2023-04-13T11:19:36.097" v="30"/>
          <ac:picMkLst>
            <pc:docMk/>
            <pc:sldMk cId="0" sldId="262"/>
            <ac:picMk id="2" creationId="{28697035-465E-9A2F-6AA2-A7F343F14D7D}"/>
          </ac:picMkLst>
        </pc:picChg>
      </pc:sldChg>
      <pc:sldChg chg="addSp delSp modSp">
        <pc:chgData name="Pedro Mauritti Granjo" userId="S::p.granjo@fct.unl.pt::cc7015fd-d343-4901-b4c6-21df2d4ac7a0" providerId="AD" clId="Web-{4962CAC6-2498-CEAE-E456-174DF8766741}" dt="2023-04-13T16:00:12.272" v="391" actId="20577"/>
        <pc:sldMkLst>
          <pc:docMk/>
          <pc:sldMk cId="0" sldId="263"/>
        </pc:sldMkLst>
        <pc:spChg chg="del mod">
          <ac:chgData name="Pedro Mauritti Granjo" userId="S::p.granjo@fct.unl.pt::cc7015fd-d343-4901-b4c6-21df2d4ac7a0" providerId="AD" clId="Web-{4962CAC6-2498-CEAE-E456-174DF8766741}" dt="2023-04-13T11:21:18.459" v="56"/>
          <ac:spMkLst>
            <pc:docMk/>
            <pc:sldMk cId="0" sldId="263"/>
            <ac:spMk id="100" creationId="{00000000-0000-0000-0000-000000000000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6:00:12.272" v="391" actId="20577"/>
          <ac:spMkLst>
            <pc:docMk/>
            <pc:sldMk cId="0" sldId="263"/>
            <ac:spMk id="106" creationId="{00000000-0000-0000-0000-000000000000}"/>
          </ac:spMkLst>
        </pc:spChg>
        <pc:picChg chg="del mod">
          <ac:chgData name="Pedro Mauritti Granjo" userId="S::p.granjo@fct.unl.pt::cc7015fd-d343-4901-b4c6-21df2d4ac7a0" providerId="AD" clId="Web-{4962CAC6-2498-CEAE-E456-174DF8766741}" dt="2023-04-13T11:21:47.460" v="63"/>
          <ac:picMkLst>
            <pc:docMk/>
            <pc:sldMk cId="0" sldId="263"/>
            <ac:picMk id="2" creationId="{A5952691-402F-822D-E489-86CB866DFA14}"/>
          </ac:picMkLst>
        </pc:picChg>
        <pc:picChg chg="add mod">
          <ac:chgData name="Pedro Mauritti Granjo" userId="S::p.granjo@fct.unl.pt::cc7015fd-d343-4901-b4c6-21df2d4ac7a0" providerId="AD" clId="Web-{4962CAC6-2498-CEAE-E456-174DF8766741}" dt="2023-04-13T11:24:28.497" v="68" actId="14100"/>
          <ac:picMkLst>
            <pc:docMk/>
            <pc:sldMk cId="0" sldId="263"/>
            <ac:picMk id="3" creationId="{FE627785-598B-7065-03D4-4A73D76F1D26}"/>
          </ac:picMkLst>
        </pc:picChg>
      </pc:sldChg>
      <pc:sldChg chg="delSp modSp del">
        <pc:chgData name="Pedro Mauritti Granjo" userId="S::p.granjo@fct.unl.pt::cc7015fd-d343-4901-b4c6-21df2d4ac7a0" providerId="AD" clId="Web-{4962CAC6-2498-CEAE-E456-174DF8766741}" dt="2023-04-13T13:43:06.048" v="264"/>
        <pc:sldMkLst>
          <pc:docMk/>
          <pc:sldMk cId="0" sldId="265"/>
        </pc:sldMkLst>
        <pc:spChg chg="mod">
          <ac:chgData name="Pedro Mauritti Granjo" userId="S::p.granjo@fct.unl.pt::cc7015fd-d343-4901-b4c6-21df2d4ac7a0" providerId="AD" clId="Web-{4962CAC6-2498-CEAE-E456-174DF8766741}" dt="2023-04-13T13:38:52.649" v="234"/>
          <ac:spMkLst>
            <pc:docMk/>
            <pc:sldMk cId="0" sldId="265"/>
            <ac:spMk id="23" creationId="{91FA1412-956E-BF2E-165C-78B7773F9544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2.680" v="235"/>
          <ac:spMkLst>
            <pc:docMk/>
            <pc:sldMk cId="0" sldId="265"/>
            <ac:spMk id="26" creationId="{02A73C9A-96D5-AED6-64B8-B69419E279A8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9:20.791" v="259" actId="20577"/>
          <ac:spMkLst>
            <pc:docMk/>
            <pc:sldMk cId="0" sldId="265"/>
            <ac:spMk id="27" creationId="{989DD351-E988-5682-0C43-0E48F3A3486F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2.758" v="237"/>
          <ac:spMkLst>
            <pc:docMk/>
            <pc:sldMk cId="0" sldId="265"/>
            <ac:spMk id="28" creationId="{8A713F81-28AC-5917-44EC-89C2A1CC3017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2.790" v="238"/>
          <ac:spMkLst>
            <pc:docMk/>
            <pc:sldMk cId="0" sldId="265"/>
            <ac:spMk id="29" creationId="{5D15253B-A3E3-F18F-4CC6-596E485870A9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2.821" v="239"/>
          <ac:spMkLst>
            <pc:docMk/>
            <pc:sldMk cId="0" sldId="265"/>
            <ac:spMk id="30" creationId="{35F218A9-284E-06DF-868F-C2C2FA3E04EF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2.852" v="240"/>
          <ac:spMkLst>
            <pc:docMk/>
            <pc:sldMk cId="0" sldId="265"/>
            <ac:spMk id="31" creationId="{C1495BBC-BA46-D0D7-8C0B-9DD0F795C51A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2.883" v="241"/>
          <ac:spMkLst>
            <pc:docMk/>
            <pc:sldMk cId="0" sldId="265"/>
            <ac:spMk id="32" creationId="{AEF44DD1-A5F9-6CBB-F84D-B590E0CAB1F2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2.915" v="242"/>
          <ac:spMkLst>
            <pc:docMk/>
            <pc:sldMk cId="0" sldId="265"/>
            <ac:spMk id="33" creationId="{30ECB7E9-8412-A35F-0F8A-F533DDF5A9E2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2.961" v="243"/>
          <ac:spMkLst>
            <pc:docMk/>
            <pc:sldMk cId="0" sldId="265"/>
            <ac:spMk id="34" creationId="{77370205-96FB-1232-7586-4B8D407914CD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2.993" v="244"/>
          <ac:spMkLst>
            <pc:docMk/>
            <pc:sldMk cId="0" sldId="265"/>
            <ac:spMk id="35" creationId="{761C140B-1DC1-DF5B-9D19-9AFFA8B6DC74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040" v="245"/>
          <ac:spMkLst>
            <pc:docMk/>
            <pc:sldMk cId="0" sldId="265"/>
            <ac:spMk id="36" creationId="{0A46AB5B-A297-39D1-3814-8645EF2FD414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210" v="222"/>
          <ac:spMkLst>
            <pc:docMk/>
            <pc:sldMk cId="0" sldId="265"/>
            <ac:spMk id="51" creationId="{871B6E26-BC38-A775-6433-07A12FFE8503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257" v="223"/>
          <ac:spMkLst>
            <pc:docMk/>
            <pc:sldMk cId="0" sldId="265"/>
            <ac:spMk id="52" creationId="{CC765146-A1F8-4627-751F-E399CC13DDD9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288" v="224"/>
          <ac:spMkLst>
            <pc:docMk/>
            <pc:sldMk cId="0" sldId="265"/>
            <ac:spMk id="53" creationId="{D6C1B98C-8461-3A36-6664-968ADE773914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320" v="225"/>
          <ac:spMkLst>
            <pc:docMk/>
            <pc:sldMk cId="0" sldId="265"/>
            <ac:spMk id="54" creationId="{DD78B55A-38A2-1744-7625-D78C314D0C89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351" v="226"/>
          <ac:spMkLst>
            <pc:docMk/>
            <pc:sldMk cId="0" sldId="265"/>
            <ac:spMk id="55" creationId="{B5527520-18F5-015C-481C-2A6FEFC201DA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398" v="227"/>
          <ac:spMkLst>
            <pc:docMk/>
            <pc:sldMk cId="0" sldId="265"/>
            <ac:spMk id="56" creationId="{F54322A8-875B-6708-137A-ACED275DD3E0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429" v="228"/>
          <ac:spMkLst>
            <pc:docMk/>
            <pc:sldMk cId="0" sldId="265"/>
            <ac:spMk id="57" creationId="{B12C75AC-5387-9B6D-42CE-1C8B0614938E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460" v="229"/>
          <ac:spMkLst>
            <pc:docMk/>
            <pc:sldMk cId="0" sldId="265"/>
            <ac:spMk id="58" creationId="{1676B04A-3FE0-4E8B-E82D-71DF9843A82C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507" v="230"/>
          <ac:spMkLst>
            <pc:docMk/>
            <pc:sldMk cId="0" sldId="265"/>
            <ac:spMk id="59" creationId="{BC7C89D1-BC8A-E62B-B3C5-F85BF449C7D8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538" v="231"/>
          <ac:spMkLst>
            <pc:docMk/>
            <pc:sldMk cId="0" sldId="265"/>
            <ac:spMk id="60" creationId="{0E4E8C30-7CEB-80EF-B066-C2ABD2BC8E20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570" v="232"/>
          <ac:spMkLst>
            <pc:docMk/>
            <pc:sldMk cId="0" sldId="265"/>
            <ac:spMk id="61" creationId="{DBC0D33C-2871-FF41-5E5A-EC37BA602995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071" v="246"/>
          <ac:spMkLst>
            <pc:docMk/>
            <pc:sldMk cId="0" sldId="265"/>
            <ac:spMk id="62" creationId="{76434C7B-BF17-B6B1-E76C-6F8F77C3AE3A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102" v="247"/>
          <ac:spMkLst>
            <pc:docMk/>
            <pc:sldMk cId="0" sldId="265"/>
            <ac:spMk id="63" creationId="{D5B8B13D-BA85-02CB-5FF7-295CC0990BAF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133" v="248"/>
          <ac:spMkLst>
            <pc:docMk/>
            <pc:sldMk cId="0" sldId="265"/>
            <ac:spMk id="64" creationId="{3A5D3F26-A7F8-6739-513B-EB9020466F07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180" v="249"/>
          <ac:spMkLst>
            <pc:docMk/>
            <pc:sldMk cId="0" sldId="265"/>
            <ac:spMk id="65" creationId="{23E33326-02D9-53EB-A540-07B27B3B9555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211" v="250"/>
          <ac:spMkLst>
            <pc:docMk/>
            <pc:sldMk cId="0" sldId="265"/>
            <ac:spMk id="66" creationId="{99025DE0-AE2A-E653-33A4-6E92A95D8CD2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243" v="251"/>
          <ac:spMkLst>
            <pc:docMk/>
            <pc:sldMk cId="0" sldId="265"/>
            <ac:spMk id="67" creationId="{A14D02A5-5739-683E-4501-0C960663A1FC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274" v="252"/>
          <ac:spMkLst>
            <pc:docMk/>
            <pc:sldMk cId="0" sldId="265"/>
            <ac:spMk id="68" creationId="{3850785A-14B2-E0B8-7CA7-7EF4B79B4561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305" v="253"/>
          <ac:spMkLst>
            <pc:docMk/>
            <pc:sldMk cId="0" sldId="265"/>
            <ac:spMk id="69" creationId="{25DDE376-1ADA-97A1-1CC6-543DA4AC4884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352" v="254"/>
          <ac:spMkLst>
            <pc:docMk/>
            <pc:sldMk cId="0" sldId="265"/>
            <ac:spMk id="70" creationId="{F49A20A9-AE69-8E92-F9F0-4FDF43DED050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415" v="255"/>
          <ac:spMkLst>
            <pc:docMk/>
            <pc:sldMk cId="0" sldId="265"/>
            <ac:spMk id="71" creationId="{6DEC1B90-7540-1448-B824-363848D80F11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446" v="256"/>
          <ac:spMkLst>
            <pc:docMk/>
            <pc:sldMk cId="0" sldId="265"/>
            <ac:spMk id="72" creationId="{B72C5F85-B22C-80FB-8461-F3F42DF13CA9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53.493" v="257"/>
          <ac:spMkLst>
            <pc:docMk/>
            <pc:sldMk cId="0" sldId="265"/>
            <ac:spMk id="73" creationId="{50A5647A-E819-662C-3E7F-51BB8D56BE20}"/>
          </ac:spMkLst>
        </pc:spChg>
        <pc:spChg chg="mod">
          <ac:chgData name="Pedro Mauritti Granjo" userId="S::p.granjo@fct.unl.pt::cc7015fd-d343-4901-b4c6-21df2d4ac7a0" providerId="AD" clId="Web-{4962CAC6-2498-CEAE-E456-174DF8766741}" dt="2023-04-13T13:38:14.601" v="233"/>
          <ac:spMkLst>
            <pc:docMk/>
            <pc:sldMk cId="0" sldId="265"/>
            <ac:spMk id="83" creationId="{0DB62AB2-89CA-7344-5D95-86F569247B55}"/>
          </ac:spMkLst>
        </pc:spChg>
        <pc:spChg chg="del">
          <ac:chgData name="Pedro Mauritti Granjo" userId="S::p.granjo@fct.unl.pt::cc7015fd-d343-4901-b4c6-21df2d4ac7a0" providerId="AD" clId="Web-{4962CAC6-2498-CEAE-E456-174DF8766741}" dt="2023-04-13T13:39:41.479" v="262"/>
          <ac:spMkLst>
            <pc:docMk/>
            <pc:sldMk cId="0" sldId="265"/>
            <ac:spMk id="90" creationId="{41A4D7E1-27EF-6912-6943-BB837C929744}"/>
          </ac:spMkLst>
        </pc:spChg>
        <pc:spChg chg="del">
          <ac:chgData name="Pedro Mauritti Granjo" userId="S::p.granjo@fct.unl.pt::cc7015fd-d343-4901-b4c6-21df2d4ac7a0" providerId="AD" clId="Web-{4962CAC6-2498-CEAE-E456-174DF8766741}" dt="2023-04-13T13:39:38.322" v="260"/>
          <ac:spMkLst>
            <pc:docMk/>
            <pc:sldMk cId="0" sldId="265"/>
            <ac:spMk id="91" creationId="{370FD0D3-3253-5C91-10C5-185924C47A13}"/>
          </ac:spMkLst>
        </pc:spChg>
        <pc:spChg chg="del">
          <ac:chgData name="Pedro Mauritti Granjo" userId="S::p.granjo@fct.unl.pt::cc7015fd-d343-4901-b4c6-21df2d4ac7a0" providerId="AD" clId="Web-{4962CAC6-2498-CEAE-E456-174DF8766741}" dt="2023-04-13T13:39:40.166" v="261"/>
          <ac:spMkLst>
            <pc:docMk/>
            <pc:sldMk cId="0" sldId="265"/>
            <ac:spMk id="92" creationId="{277F7493-7B86-D2E6-1719-02094AFF72AC}"/>
          </ac:spMkLst>
        </pc:spChg>
      </pc:sldChg>
      <pc:sldChg chg="modSp">
        <pc:chgData name="Pedro Mauritti Granjo" userId="S::p.granjo@fct.unl.pt::cc7015fd-d343-4901-b4c6-21df2d4ac7a0" providerId="AD" clId="Web-{4962CAC6-2498-CEAE-E456-174DF8766741}" dt="2023-04-13T13:35:18.063" v="169" actId="1076"/>
        <pc:sldMkLst>
          <pc:docMk/>
          <pc:sldMk cId="0" sldId="268"/>
        </pc:sldMkLst>
        <pc:picChg chg="mod">
          <ac:chgData name="Pedro Mauritti Granjo" userId="S::p.granjo@fct.unl.pt::cc7015fd-d343-4901-b4c6-21df2d4ac7a0" providerId="AD" clId="Web-{4962CAC6-2498-CEAE-E456-174DF8766741}" dt="2023-04-13T13:35:18.063" v="169" actId="1076"/>
          <ac:picMkLst>
            <pc:docMk/>
            <pc:sldMk cId="0" sldId="268"/>
            <ac:picMk id="2" creationId="{BB6E25D3-AA72-29F1-B0CD-A4188339AF33}"/>
          </ac:picMkLst>
        </pc:picChg>
      </pc:sldChg>
      <pc:sldChg chg="addSp delSp modSp">
        <pc:chgData name="Pedro Mauritti Granjo" userId="S::p.granjo@fct.unl.pt::cc7015fd-d343-4901-b4c6-21df2d4ac7a0" providerId="AD" clId="Web-{4962CAC6-2498-CEAE-E456-174DF8766741}" dt="2023-04-13T14:13:43.548" v="335" actId="1076"/>
        <pc:sldMkLst>
          <pc:docMk/>
          <pc:sldMk cId="0" sldId="269"/>
        </pc:sldMkLst>
        <pc:picChg chg="del">
          <ac:chgData name="Pedro Mauritti Granjo" userId="S::p.granjo@fct.unl.pt::cc7015fd-d343-4901-b4c6-21df2d4ac7a0" providerId="AD" clId="Web-{4962CAC6-2498-CEAE-E456-174DF8766741}" dt="2023-04-13T13:33:43.857" v="154"/>
          <ac:picMkLst>
            <pc:docMk/>
            <pc:sldMk cId="0" sldId="269"/>
            <ac:picMk id="2" creationId="{A7FEDB74-F47E-AF04-B389-B979C5F955BA}"/>
          </ac:picMkLst>
        </pc:picChg>
        <pc:picChg chg="add del mod">
          <ac:chgData name="Pedro Mauritti Granjo" userId="S::p.granjo@fct.unl.pt::cc7015fd-d343-4901-b4c6-21df2d4ac7a0" providerId="AD" clId="Web-{4962CAC6-2498-CEAE-E456-174DF8766741}" dt="2023-04-13T13:47:50.042" v="290"/>
          <ac:picMkLst>
            <pc:docMk/>
            <pc:sldMk cId="0" sldId="269"/>
            <ac:picMk id="3" creationId="{A554C487-D9CF-FEF1-B668-CBE4A395F0AF}"/>
          </ac:picMkLst>
        </pc:picChg>
        <pc:picChg chg="add del mod">
          <ac:chgData name="Pedro Mauritti Granjo" userId="S::p.granjo@fct.unl.pt::cc7015fd-d343-4901-b4c6-21df2d4ac7a0" providerId="AD" clId="Web-{4962CAC6-2498-CEAE-E456-174DF8766741}" dt="2023-04-13T14:13:17.844" v="330"/>
          <ac:picMkLst>
            <pc:docMk/>
            <pc:sldMk cId="0" sldId="269"/>
            <ac:picMk id="5" creationId="{27C7E468-445B-0042-FB4A-C64986319429}"/>
          </ac:picMkLst>
        </pc:picChg>
        <pc:picChg chg="add mod">
          <ac:chgData name="Pedro Mauritti Granjo" userId="S::p.granjo@fct.unl.pt::cc7015fd-d343-4901-b4c6-21df2d4ac7a0" providerId="AD" clId="Web-{4962CAC6-2498-CEAE-E456-174DF8766741}" dt="2023-04-13T14:13:43.548" v="335" actId="1076"/>
          <ac:picMkLst>
            <pc:docMk/>
            <pc:sldMk cId="0" sldId="269"/>
            <ac:picMk id="6" creationId="{968D0D9E-06F2-47BC-B15A-8A28B20656E3}"/>
          </ac:picMkLst>
        </pc:picChg>
      </pc:sldChg>
      <pc:sldChg chg="addSp delSp modSp">
        <pc:chgData name="Pedro Mauritti Granjo" userId="S::p.granjo@fct.unl.pt::cc7015fd-d343-4901-b4c6-21df2d4ac7a0" providerId="AD" clId="Web-{4962CAC6-2498-CEAE-E456-174DF8766741}" dt="2023-04-13T14:13:11.922" v="329" actId="1076"/>
        <pc:sldMkLst>
          <pc:docMk/>
          <pc:sldMk cId="3969417392" sldId="270"/>
        </pc:sldMkLst>
        <pc:picChg chg="add del mod">
          <ac:chgData name="Pedro Mauritti Granjo" userId="S::p.granjo@fct.unl.pt::cc7015fd-d343-4901-b4c6-21df2d4ac7a0" providerId="AD" clId="Web-{4962CAC6-2498-CEAE-E456-174DF8766741}" dt="2023-04-13T13:33:20.356" v="148"/>
          <ac:picMkLst>
            <pc:docMk/>
            <pc:sldMk cId="3969417392" sldId="270"/>
            <ac:picMk id="2" creationId="{167BCCC5-C749-4218-50FC-7348AD518535}"/>
          </ac:picMkLst>
        </pc:picChg>
        <pc:picChg chg="del">
          <ac:chgData name="Pedro Mauritti Granjo" userId="S::p.granjo@fct.unl.pt::cc7015fd-d343-4901-b4c6-21df2d4ac7a0" providerId="AD" clId="Web-{4962CAC6-2498-CEAE-E456-174DF8766741}" dt="2023-04-13T13:33:14.841" v="146"/>
          <ac:picMkLst>
            <pc:docMk/>
            <pc:sldMk cId="3969417392" sldId="270"/>
            <ac:picMk id="3" creationId="{50E8666B-0E29-7ECD-F0F0-D782B41D3922}"/>
          </ac:picMkLst>
        </pc:picChg>
        <pc:picChg chg="add del mod">
          <ac:chgData name="Pedro Mauritti Granjo" userId="S::p.granjo@fct.unl.pt::cc7015fd-d343-4901-b4c6-21df2d4ac7a0" providerId="AD" clId="Web-{4962CAC6-2498-CEAE-E456-174DF8766741}" dt="2023-04-13T14:12:57.781" v="318"/>
          <ac:picMkLst>
            <pc:docMk/>
            <pc:sldMk cId="3969417392" sldId="270"/>
            <ac:picMk id="4" creationId="{4170D758-A4A8-2936-3CEC-8D4636B6DF47}"/>
          </ac:picMkLst>
        </pc:picChg>
        <pc:picChg chg="add mod">
          <ac:chgData name="Pedro Mauritti Granjo" userId="S::p.granjo@fct.unl.pt::cc7015fd-d343-4901-b4c6-21df2d4ac7a0" providerId="AD" clId="Web-{4962CAC6-2498-CEAE-E456-174DF8766741}" dt="2023-04-13T14:13:11.922" v="329" actId="1076"/>
          <ac:picMkLst>
            <pc:docMk/>
            <pc:sldMk cId="3969417392" sldId="270"/>
            <ac:picMk id="5" creationId="{526E8A0C-232F-73E9-C49D-3261022F65FE}"/>
          </ac:picMkLst>
        </pc:picChg>
      </pc:sldChg>
      <pc:sldChg chg="del">
        <pc:chgData name="Pedro Mauritti Granjo" userId="S::p.granjo@fct.unl.pt::cc7015fd-d343-4901-b4c6-21df2d4ac7a0" providerId="AD" clId="Web-{4962CAC6-2498-CEAE-E456-174DF8766741}" dt="2023-04-13T15:42:57.815" v="383"/>
        <pc:sldMkLst>
          <pc:docMk/>
          <pc:sldMk cId="2191380308" sldId="271"/>
        </pc:sldMkLst>
      </pc:sldChg>
      <pc:sldChg chg="modSp ord">
        <pc:chgData name="Pedro Mauritti Granjo" userId="S::p.granjo@fct.unl.pt::cc7015fd-d343-4901-b4c6-21df2d4ac7a0" providerId="AD" clId="Web-{4962CAC6-2498-CEAE-E456-174DF8766741}" dt="2023-04-13T13:51:19.065" v="302" actId="1076"/>
        <pc:sldMkLst>
          <pc:docMk/>
          <pc:sldMk cId="746827180" sldId="274"/>
        </pc:sldMkLst>
        <pc:spChg chg="mod">
          <ac:chgData name="Pedro Mauritti Granjo" userId="S::p.granjo@fct.unl.pt::cc7015fd-d343-4901-b4c6-21df2d4ac7a0" providerId="AD" clId="Web-{4962CAC6-2498-CEAE-E456-174DF8766741}" dt="2023-04-13T13:51:19.065" v="302" actId="1076"/>
          <ac:spMkLst>
            <pc:docMk/>
            <pc:sldMk cId="746827180" sldId="274"/>
            <ac:spMk id="5" creationId="{72C59114-022A-42B5-7CE6-EE8E0DBDE43E}"/>
          </ac:spMkLst>
        </pc:spChg>
        <pc:picChg chg="mod">
          <ac:chgData name="Pedro Mauritti Granjo" userId="S::p.granjo@fct.unl.pt::cc7015fd-d343-4901-b4c6-21df2d4ac7a0" providerId="AD" clId="Web-{4962CAC6-2498-CEAE-E456-174DF8766741}" dt="2023-04-13T13:51:15.002" v="301" actId="1076"/>
          <ac:picMkLst>
            <pc:docMk/>
            <pc:sldMk cId="746827180" sldId="274"/>
            <ac:picMk id="3" creationId="{573F61E3-FBFA-634C-E4AE-FD41349E113C}"/>
          </ac:picMkLst>
        </pc:picChg>
      </pc:sldChg>
      <pc:sldChg chg="modSp">
        <pc:chgData name="Pedro Mauritti Granjo" userId="S::p.granjo@fct.unl.pt::cc7015fd-d343-4901-b4c6-21df2d4ac7a0" providerId="AD" clId="Web-{4962CAC6-2498-CEAE-E456-174DF8766741}" dt="2023-04-13T10:08:22.762" v="4" actId="20577"/>
        <pc:sldMkLst>
          <pc:docMk/>
          <pc:sldMk cId="2756113789" sldId="276"/>
        </pc:sldMkLst>
        <pc:spChg chg="mod">
          <ac:chgData name="Pedro Mauritti Granjo" userId="S::p.granjo@fct.unl.pt::cc7015fd-d343-4901-b4c6-21df2d4ac7a0" providerId="AD" clId="Web-{4962CAC6-2498-CEAE-E456-174DF8766741}" dt="2023-04-13T10:08:22.762" v="4" actId="20577"/>
          <ac:spMkLst>
            <pc:docMk/>
            <pc:sldMk cId="2756113789" sldId="276"/>
            <ac:spMk id="6" creationId="{1B3079FD-51CF-26B9-6E06-E4759DBA9CC8}"/>
          </ac:spMkLst>
        </pc:spChg>
      </pc:sldChg>
      <pc:sldChg chg="modSp del">
        <pc:chgData name="Pedro Mauritti Granjo" userId="S::p.granjo@fct.unl.pt::cc7015fd-d343-4901-b4c6-21df2d4ac7a0" providerId="AD" clId="Web-{4962CAC6-2498-CEAE-E456-174DF8766741}" dt="2023-04-13T15:40:43.592" v="359"/>
        <pc:sldMkLst>
          <pc:docMk/>
          <pc:sldMk cId="2860821069" sldId="278"/>
        </pc:sldMkLst>
        <pc:spChg chg="mod">
          <ac:chgData name="Pedro Mauritti Granjo" userId="S::p.granjo@fct.unl.pt::cc7015fd-d343-4901-b4c6-21df2d4ac7a0" providerId="AD" clId="Web-{4962CAC6-2498-CEAE-E456-174DF8766741}" dt="2023-04-13T10:08:49.528" v="9" actId="20577"/>
          <ac:spMkLst>
            <pc:docMk/>
            <pc:sldMk cId="2860821069" sldId="278"/>
            <ac:spMk id="6" creationId="{12DA03D6-08FB-04E3-3596-597820281F85}"/>
          </ac:spMkLst>
        </pc:spChg>
      </pc:sldChg>
      <pc:sldChg chg="addSp delSp modSp new">
        <pc:chgData name="Pedro Mauritti Granjo" userId="S::p.granjo@fct.unl.pt::cc7015fd-d343-4901-b4c6-21df2d4ac7a0" providerId="AD" clId="Web-{4962CAC6-2498-CEAE-E456-174DF8766741}" dt="2023-04-13T13:51:09.565" v="299" actId="1076"/>
        <pc:sldMkLst>
          <pc:docMk/>
          <pc:sldMk cId="2986738929" sldId="280"/>
        </pc:sldMkLst>
        <pc:spChg chg="del mod">
          <ac:chgData name="Pedro Mauritti Granjo" userId="S::p.granjo@fct.unl.pt::cc7015fd-d343-4901-b4c6-21df2d4ac7a0" providerId="AD" clId="Web-{4962CAC6-2498-CEAE-E456-174DF8766741}" dt="2023-04-13T13:43:09.298" v="266"/>
          <ac:spMkLst>
            <pc:docMk/>
            <pc:sldMk cId="2986738929" sldId="280"/>
            <ac:spMk id="2" creationId="{98D9822B-645F-E5AF-7FA7-FFB6532FE3CB}"/>
          </ac:spMkLst>
        </pc:spChg>
        <pc:picChg chg="add del mod">
          <ac:chgData name="Pedro Mauritti Granjo" userId="S::p.granjo@fct.unl.pt::cc7015fd-d343-4901-b4c6-21df2d4ac7a0" providerId="AD" clId="Web-{4962CAC6-2498-CEAE-E456-174DF8766741}" dt="2023-04-13T13:45:05.209" v="275"/>
          <ac:picMkLst>
            <pc:docMk/>
            <pc:sldMk cId="2986738929" sldId="280"/>
            <ac:picMk id="3" creationId="{CD6EAE22-B6F4-7B73-5B54-0265DABB008C}"/>
          </ac:picMkLst>
        </pc:picChg>
        <pc:picChg chg="add del mod">
          <ac:chgData name="Pedro Mauritti Granjo" userId="S::p.granjo@fct.unl.pt::cc7015fd-d343-4901-b4c6-21df2d4ac7a0" providerId="AD" clId="Web-{4962CAC6-2498-CEAE-E456-174DF8766741}" dt="2023-04-13T13:46:18.617" v="285"/>
          <ac:picMkLst>
            <pc:docMk/>
            <pc:sldMk cId="2986738929" sldId="280"/>
            <ac:picMk id="4" creationId="{4ECF7D8F-5C6E-1088-0096-53341FE801BE}"/>
          </ac:picMkLst>
        </pc:picChg>
        <pc:picChg chg="add mod">
          <ac:chgData name="Pedro Mauritti Granjo" userId="S::p.granjo@fct.unl.pt::cc7015fd-d343-4901-b4c6-21df2d4ac7a0" providerId="AD" clId="Web-{4962CAC6-2498-CEAE-E456-174DF8766741}" dt="2023-04-13T13:51:09.565" v="299" actId="1076"/>
          <ac:picMkLst>
            <pc:docMk/>
            <pc:sldMk cId="2986738929" sldId="280"/>
            <ac:picMk id="5" creationId="{DE2062F8-880D-DF94-D801-2CE6FB2BD201}"/>
          </ac:picMkLst>
        </pc:picChg>
      </pc:sldChg>
    </pc:docChg>
  </pc:docChgLst>
  <pc:docChgLst>
    <pc:chgData name="Pedro Mauritti Granjo" userId="cc7015fd-d343-4901-b4c6-21df2d4ac7a0" providerId="ADAL" clId="{C2DC0B18-55E4-4365-BFA2-6CFA500E1748}"/>
    <pc:docChg chg="undo custSel modSld">
      <pc:chgData name="Pedro Mauritti Granjo" userId="cc7015fd-d343-4901-b4c6-21df2d4ac7a0" providerId="ADAL" clId="{C2DC0B18-55E4-4365-BFA2-6CFA500E1748}" dt="2024-08-07T08:39:05.606" v="139" actId="20577"/>
      <pc:docMkLst>
        <pc:docMk/>
      </pc:docMkLst>
      <pc:sldChg chg="addSp delSp modSp mod">
        <pc:chgData name="Pedro Mauritti Granjo" userId="cc7015fd-d343-4901-b4c6-21df2d4ac7a0" providerId="ADAL" clId="{C2DC0B18-55E4-4365-BFA2-6CFA500E1748}" dt="2024-08-07T08:39:05.606" v="139" actId="20577"/>
        <pc:sldMkLst>
          <pc:docMk/>
          <pc:sldMk cId="0" sldId="269"/>
        </pc:sldMkLst>
        <pc:spChg chg="mod">
          <ac:chgData name="Pedro Mauritti Granjo" userId="cc7015fd-d343-4901-b4c6-21df2d4ac7a0" providerId="ADAL" clId="{C2DC0B18-55E4-4365-BFA2-6CFA500E1748}" dt="2024-08-07T08:39:05.606" v="139" actId="20577"/>
          <ac:spMkLst>
            <pc:docMk/>
            <pc:sldMk cId="0" sldId="269"/>
            <ac:spMk id="3" creationId="{A29E4224-92C9-1FDC-CB5B-329F664BE36F}"/>
          </ac:spMkLst>
        </pc:spChg>
        <pc:graphicFrameChg chg="add mod">
          <ac:chgData name="Pedro Mauritti Granjo" userId="cc7015fd-d343-4901-b4c6-21df2d4ac7a0" providerId="ADAL" clId="{C2DC0B18-55E4-4365-BFA2-6CFA500E1748}" dt="2024-08-07T08:38:15.001" v="38"/>
          <ac:graphicFrameMkLst>
            <pc:docMk/>
            <pc:sldMk cId="0" sldId="269"/>
            <ac:graphicFrameMk id="6" creationId="{0091B14E-3D46-C6FC-EAD9-263CABA042FD}"/>
          </ac:graphicFrameMkLst>
        </pc:graphicFrameChg>
        <pc:picChg chg="add del mod">
          <ac:chgData name="Pedro Mauritti Granjo" userId="cc7015fd-d343-4901-b4c6-21df2d4ac7a0" providerId="ADAL" clId="{C2DC0B18-55E4-4365-BFA2-6CFA500E1748}" dt="2024-08-07T08:37:10.626" v="12" actId="478"/>
          <ac:picMkLst>
            <pc:docMk/>
            <pc:sldMk cId="0" sldId="269"/>
            <ac:picMk id="4" creationId="{4B8CFF59-89D0-3281-ABAA-81408FD6FF0D}"/>
          </ac:picMkLst>
        </pc:picChg>
        <pc:picChg chg="add mod">
          <ac:chgData name="Pedro Mauritti Granjo" userId="cc7015fd-d343-4901-b4c6-21df2d4ac7a0" providerId="ADAL" clId="{C2DC0B18-55E4-4365-BFA2-6CFA500E1748}" dt="2024-08-07T08:37:30.002" v="18" actId="1076"/>
          <ac:picMkLst>
            <pc:docMk/>
            <pc:sldMk cId="0" sldId="269"/>
            <ac:picMk id="5" creationId="{716F41E9-AFFE-7259-4C56-1DEFE697B3CF}"/>
          </ac:picMkLst>
        </pc:picChg>
        <pc:picChg chg="del">
          <ac:chgData name="Pedro Mauritti Granjo" userId="cc7015fd-d343-4901-b4c6-21df2d4ac7a0" providerId="ADAL" clId="{C2DC0B18-55E4-4365-BFA2-6CFA500E1748}" dt="2024-08-06T08:02:27.738" v="0" actId="478"/>
          <ac:picMkLst>
            <pc:docMk/>
            <pc:sldMk cId="0" sldId="269"/>
            <ac:picMk id="6" creationId="{968D0D9E-06F2-47BC-B15A-8A28B20656E3}"/>
          </ac:picMkLst>
        </pc:picChg>
      </pc:sldChg>
    </pc:docChg>
  </pc:docChgLst>
  <pc:docChgLst>
    <pc:chgData name="Pedro Mauritti Granjo" userId="S::p.granjo@fct.unl.pt::cc7015fd-d343-4901-b4c6-21df2d4ac7a0" providerId="AD" clId="Web-{903ACDC1-63F0-3525-E363-E4D2173544C9}"/>
    <pc:docChg chg="modSld">
      <pc:chgData name="Pedro Mauritti Granjo" userId="S::p.granjo@fct.unl.pt::cc7015fd-d343-4901-b4c6-21df2d4ac7a0" providerId="AD" clId="Web-{903ACDC1-63F0-3525-E363-E4D2173544C9}" dt="2023-04-12T16:47:22.594" v="382"/>
      <pc:docMkLst>
        <pc:docMk/>
      </pc:docMkLst>
      <pc:sldChg chg="modSp">
        <pc:chgData name="Pedro Mauritti Granjo" userId="S::p.granjo@fct.unl.pt::cc7015fd-d343-4901-b4c6-21df2d4ac7a0" providerId="AD" clId="Web-{903ACDC1-63F0-3525-E363-E4D2173544C9}" dt="2023-04-12T10:46:58.137" v="136" actId="20577"/>
        <pc:sldMkLst>
          <pc:docMk/>
          <pc:sldMk cId="0" sldId="257"/>
        </pc:sldMkLst>
        <pc:spChg chg="mod">
          <ac:chgData name="Pedro Mauritti Granjo" userId="S::p.granjo@fct.unl.pt::cc7015fd-d343-4901-b4c6-21df2d4ac7a0" providerId="AD" clId="Web-{903ACDC1-63F0-3525-E363-E4D2173544C9}" dt="2023-04-12T10:46:58.137" v="136" actId="20577"/>
          <ac:spMkLst>
            <pc:docMk/>
            <pc:sldMk cId="0" sldId="257"/>
            <ac:spMk id="62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903ACDC1-63F0-3525-E363-E4D2173544C9}" dt="2023-04-12T10:55:46.010" v="279" actId="20577"/>
        <pc:sldMkLst>
          <pc:docMk/>
          <pc:sldMk cId="0" sldId="258"/>
        </pc:sldMkLst>
        <pc:spChg chg="mod">
          <ac:chgData name="Pedro Mauritti Granjo" userId="S::p.granjo@fct.unl.pt::cc7015fd-d343-4901-b4c6-21df2d4ac7a0" providerId="AD" clId="Web-{903ACDC1-63F0-3525-E363-E4D2173544C9}" dt="2023-04-12T10:55:46.010" v="279" actId="20577"/>
          <ac:spMkLst>
            <pc:docMk/>
            <pc:sldMk cId="0" sldId="258"/>
            <ac:spMk id="68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903ACDC1-63F0-3525-E363-E4D2173544C9}" dt="2023-04-12T10:34:57.133" v="45" actId="20577"/>
        <pc:sldMkLst>
          <pc:docMk/>
          <pc:sldMk cId="0" sldId="259"/>
        </pc:sldMkLst>
        <pc:spChg chg="mod">
          <ac:chgData name="Pedro Mauritti Granjo" userId="S::p.granjo@fct.unl.pt::cc7015fd-d343-4901-b4c6-21df2d4ac7a0" providerId="AD" clId="Web-{903ACDC1-63F0-3525-E363-E4D2173544C9}" dt="2023-04-12T10:34:57.133" v="45" actId="20577"/>
          <ac:spMkLst>
            <pc:docMk/>
            <pc:sldMk cId="0" sldId="259"/>
            <ac:spMk id="74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903ACDC1-63F0-3525-E363-E4D2173544C9}" dt="2023-04-12T11:07:37.201" v="285" actId="20577"/>
        <pc:sldMkLst>
          <pc:docMk/>
          <pc:sldMk cId="0" sldId="261"/>
        </pc:sldMkLst>
        <pc:spChg chg="mod">
          <ac:chgData name="Pedro Mauritti Granjo" userId="S::p.granjo@fct.unl.pt::cc7015fd-d343-4901-b4c6-21df2d4ac7a0" providerId="AD" clId="Web-{903ACDC1-63F0-3525-E363-E4D2173544C9}" dt="2023-04-12T11:07:37.201" v="285" actId="20577"/>
          <ac:spMkLst>
            <pc:docMk/>
            <pc:sldMk cId="0" sldId="261"/>
            <ac:spMk id="86" creationId="{00000000-0000-0000-0000-000000000000}"/>
          </ac:spMkLst>
        </pc:spChg>
      </pc:sldChg>
      <pc:sldChg chg="addSp modSp">
        <pc:chgData name="Pedro Mauritti Granjo" userId="S::p.granjo@fct.unl.pt::cc7015fd-d343-4901-b4c6-21df2d4ac7a0" providerId="AD" clId="Web-{903ACDC1-63F0-3525-E363-E4D2173544C9}" dt="2023-04-12T10:44:23.883" v="99" actId="20577"/>
        <pc:sldMkLst>
          <pc:docMk/>
          <pc:sldMk cId="0" sldId="269"/>
        </pc:sldMkLst>
        <pc:spChg chg="add mod">
          <ac:chgData name="Pedro Mauritti Granjo" userId="S::p.granjo@fct.unl.pt::cc7015fd-d343-4901-b4c6-21df2d4ac7a0" providerId="AD" clId="Web-{903ACDC1-63F0-3525-E363-E4D2173544C9}" dt="2023-04-12T10:44:23.883" v="99" actId="20577"/>
          <ac:spMkLst>
            <pc:docMk/>
            <pc:sldMk cId="0" sldId="269"/>
            <ac:spMk id="4" creationId="{79DE6C02-1434-3F8D-8864-98C0D4B9495F}"/>
          </ac:spMkLst>
        </pc:spChg>
      </pc:sldChg>
      <pc:sldChg chg="modSp">
        <pc:chgData name="Pedro Mauritti Granjo" userId="S::p.granjo@fct.unl.pt::cc7015fd-d343-4901-b4c6-21df2d4ac7a0" providerId="AD" clId="Web-{903ACDC1-63F0-3525-E363-E4D2173544C9}" dt="2023-04-12T10:45:23.431" v="109" actId="20577"/>
        <pc:sldMkLst>
          <pc:docMk/>
          <pc:sldMk cId="2756113789" sldId="276"/>
        </pc:sldMkLst>
        <pc:spChg chg="mod">
          <ac:chgData name="Pedro Mauritti Granjo" userId="S::p.granjo@fct.unl.pt::cc7015fd-d343-4901-b4c6-21df2d4ac7a0" providerId="AD" clId="Web-{903ACDC1-63F0-3525-E363-E4D2173544C9}" dt="2023-04-12T10:45:23.431" v="109" actId="20577"/>
          <ac:spMkLst>
            <pc:docMk/>
            <pc:sldMk cId="2756113789" sldId="276"/>
            <ac:spMk id="6" creationId="{1B3079FD-51CF-26B9-6E06-E4759DBA9CC8}"/>
          </ac:spMkLst>
        </pc:spChg>
      </pc:sldChg>
      <pc:sldChg chg="modSp">
        <pc:chgData name="Pedro Mauritti Granjo" userId="S::p.granjo@fct.unl.pt::cc7015fd-d343-4901-b4c6-21df2d4ac7a0" providerId="AD" clId="Web-{903ACDC1-63F0-3525-E363-E4D2173544C9}" dt="2023-04-12T10:52:51.177" v="254" actId="20577"/>
        <pc:sldMkLst>
          <pc:docMk/>
          <pc:sldMk cId="2860821069" sldId="278"/>
        </pc:sldMkLst>
        <pc:spChg chg="mod">
          <ac:chgData name="Pedro Mauritti Granjo" userId="S::p.granjo@fct.unl.pt::cc7015fd-d343-4901-b4c6-21df2d4ac7a0" providerId="AD" clId="Web-{903ACDC1-63F0-3525-E363-E4D2173544C9}" dt="2023-04-12T10:52:51.177" v="254" actId="20577"/>
          <ac:spMkLst>
            <pc:docMk/>
            <pc:sldMk cId="2860821069" sldId="278"/>
            <ac:spMk id="6" creationId="{12DA03D6-08FB-04E3-3596-597820281F85}"/>
          </ac:spMkLst>
        </pc:spChg>
      </pc:sldChg>
      <pc:sldChg chg="modSp">
        <pc:chgData name="Pedro Mauritti Granjo" userId="S::p.granjo@fct.unl.pt::cc7015fd-d343-4901-b4c6-21df2d4ac7a0" providerId="AD" clId="Web-{903ACDC1-63F0-3525-E363-E4D2173544C9}" dt="2023-04-12T16:47:22.594" v="382"/>
        <pc:sldMkLst>
          <pc:docMk/>
          <pc:sldMk cId="120033746" sldId="279"/>
        </pc:sldMkLst>
        <pc:spChg chg="mod">
          <ac:chgData name="Pedro Mauritti Granjo" userId="S::p.granjo@fct.unl.pt::cc7015fd-d343-4901-b4c6-21df2d4ac7a0" providerId="AD" clId="Web-{903ACDC1-63F0-3525-E363-E4D2173544C9}" dt="2023-04-12T15:53:27.466" v="343" actId="20577"/>
          <ac:spMkLst>
            <pc:docMk/>
            <pc:sldMk cId="120033746" sldId="279"/>
            <ac:spMk id="7" creationId="{CCA8EBAF-6819-ABAE-6141-40945D50709F}"/>
          </ac:spMkLst>
        </pc:spChg>
        <pc:graphicFrameChg chg="mod modGraphic">
          <ac:chgData name="Pedro Mauritti Granjo" userId="S::p.granjo@fct.unl.pt::cc7015fd-d343-4901-b4c6-21df2d4ac7a0" providerId="AD" clId="Web-{903ACDC1-63F0-3525-E363-E4D2173544C9}" dt="2023-04-12T16:47:22.594" v="382"/>
          <ac:graphicFrameMkLst>
            <pc:docMk/>
            <pc:sldMk cId="120033746" sldId="279"/>
            <ac:graphicFrameMk id="5" creationId="{90CA37FC-97AF-2170-4009-B24B8E3576CB}"/>
          </ac:graphicFrameMkLst>
        </pc:graphicFrameChg>
      </pc:sldChg>
    </pc:docChg>
  </pc:docChgLst>
  <pc:docChgLst>
    <pc:chgData name="Pedro Mauritti Granjo" userId="S::p.granjo@fct.unl.pt::cc7015fd-d343-4901-b4c6-21df2d4ac7a0" providerId="AD" clId="Web-{E295B1E6-D309-3B32-89DF-B97EA94AF2AC}"/>
    <pc:docChg chg="modSld">
      <pc:chgData name="Pedro Mauritti Granjo" userId="S::p.granjo@fct.unl.pt::cc7015fd-d343-4901-b4c6-21df2d4ac7a0" providerId="AD" clId="Web-{E295B1E6-D309-3B32-89DF-B97EA94AF2AC}" dt="2023-04-10T22:13:06.861" v="242"/>
      <pc:docMkLst>
        <pc:docMk/>
      </pc:docMkLst>
      <pc:sldChg chg="modSp">
        <pc:chgData name="Pedro Mauritti Granjo" userId="S::p.granjo@fct.unl.pt::cc7015fd-d343-4901-b4c6-21df2d4ac7a0" providerId="AD" clId="Web-{E295B1E6-D309-3B32-89DF-B97EA94AF2AC}" dt="2023-04-10T22:13:06.861" v="242"/>
        <pc:sldMkLst>
          <pc:docMk/>
          <pc:sldMk cId="120033746" sldId="279"/>
        </pc:sldMkLst>
        <pc:spChg chg="mod">
          <ac:chgData name="Pedro Mauritti Granjo" userId="S::p.granjo@fct.unl.pt::cc7015fd-d343-4901-b4c6-21df2d4ac7a0" providerId="AD" clId="Web-{E295B1E6-D309-3B32-89DF-B97EA94AF2AC}" dt="2023-04-10T22:09:25.648" v="116" actId="1076"/>
          <ac:spMkLst>
            <pc:docMk/>
            <pc:sldMk cId="120033746" sldId="279"/>
            <ac:spMk id="7" creationId="{CCA8EBAF-6819-ABAE-6141-40945D50709F}"/>
          </ac:spMkLst>
        </pc:spChg>
        <pc:graphicFrameChg chg="mod modGraphic">
          <ac:chgData name="Pedro Mauritti Granjo" userId="S::p.granjo@fct.unl.pt::cc7015fd-d343-4901-b4c6-21df2d4ac7a0" providerId="AD" clId="Web-{E295B1E6-D309-3B32-89DF-B97EA94AF2AC}" dt="2023-04-10T22:13:06.861" v="242"/>
          <ac:graphicFrameMkLst>
            <pc:docMk/>
            <pc:sldMk cId="120033746" sldId="279"/>
            <ac:graphicFrameMk id="5" creationId="{90CA37FC-97AF-2170-4009-B24B8E3576CB}"/>
          </ac:graphicFrameMkLst>
        </pc:graphicFrameChg>
      </pc:sldChg>
    </pc:docChg>
  </pc:docChgLst>
  <pc:docChgLst>
    <pc:chgData name="Pedro Mauritti Granjo" userId="S::p.granjo@fct.unl.pt::cc7015fd-d343-4901-b4c6-21df2d4ac7a0" providerId="AD" clId="Web-{AF7CB4B2-F607-7683-9CD9-0507A4C90672}"/>
    <pc:docChg chg="modSld">
      <pc:chgData name="Pedro Mauritti Granjo" userId="S::p.granjo@fct.unl.pt::cc7015fd-d343-4901-b4c6-21df2d4ac7a0" providerId="AD" clId="Web-{AF7CB4B2-F607-7683-9CD9-0507A4C90672}" dt="2023-04-14T11:10:09.487" v="82"/>
      <pc:docMkLst>
        <pc:docMk/>
      </pc:docMkLst>
      <pc:sldChg chg="modSp">
        <pc:chgData name="Pedro Mauritti Granjo" userId="S::p.granjo@fct.unl.pt::cc7015fd-d343-4901-b4c6-21df2d4ac7a0" providerId="AD" clId="Web-{AF7CB4B2-F607-7683-9CD9-0507A4C90672}" dt="2023-04-14T11:10:09.487" v="82"/>
        <pc:sldMkLst>
          <pc:docMk/>
          <pc:sldMk cId="3746764528" sldId="281"/>
        </pc:sldMkLst>
        <pc:graphicFrameChg chg="mod modGraphic">
          <ac:chgData name="Pedro Mauritti Granjo" userId="S::p.granjo@fct.unl.pt::cc7015fd-d343-4901-b4c6-21df2d4ac7a0" providerId="AD" clId="Web-{AF7CB4B2-F607-7683-9CD9-0507A4C90672}" dt="2023-04-14T11:10:09.487" v="82"/>
          <ac:graphicFrameMkLst>
            <pc:docMk/>
            <pc:sldMk cId="3746764528" sldId="281"/>
            <ac:graphicFrameMk id="5" creationId="{90CA37FC-97AF-2170-4009-B24B8E3576CB}"/>
          </ac:graphicFrameMkLst>
        </pc:graphicFrameChg>
      </pc:sldChg>
    </pc:docChg>
  </pc:docChgLst>
  <pc:docChgLst>
    <pc:chgData name="Pedro Mauritti Granjo" userId="S::p.granjo@fct.unl.pt::cc7015fd-d343-4901-b4c6-21df2d4ac7a0" providerId="AD" clId="Web-{F311B018-656C-5B0F-922A-08DF909322EB}"/>
    <pc:docChg chg="delSld modSld">
      <pc:chgData name="Pedro Mauritti Granjo" userId="S::p.granjo@fct.unl.pt::cc7015fd-d343-4901-b4c6-21df2d4ac7a0" providerId="AD" clId="Web-{F311B018-656C-5B0F-922A-08DF909322EB}" dt="2023-04-04T18:38:49.906" v="3"/>
      <pc:docMkLst>
        <pc:docMk/>
      </pc:docMkLst>
      <pc:sldChg chg="del">
        <pc:chgData name="Pedro Mauritti Granjo" userId="S::p.granjo@fct.unl.pt::cc7015fd-d343-4901-b4c6-21df2d4ac7a0" providerId="AD" clId="Web-{F311B018-656C-5B0F-922A-08DF909322EB}" dt="2023-04-04T18:38:49.094" v="2"/>
        <pc:sldMkLst>
          <pc:docMk/>
          <pc:sldMk cId="3093739534" sldId="272"/>
        </pc:sldMkLst>
      </pc:sldChg>
      <pc:sldChg chg="del">
        <pc:chgData name="Pedro Mauritti Granjo" userId="S::p.granjo@fct.unl.pt::cc7015fd-d343-4901-b4c6-21df2d4ac7a0" providerId="AD" clId="Web-{F311B018-656C-5B0F-922A-08DF909322EB}" dt="2023-04-04T17:20:28.680" v="0"/>
        <pc:sldMkLst>
          <pc:docMk/>
          <pc:sldMk cId="4168802406" sldId="275"/>
        </pc:sldMkLst>
      </pc:sldChg>
      <pc:sldChg chg="modSp del">
        <pc:chgData name="Pedro Mauritti Granjo" userId="S::p.granjo@fct.unl.pt::cc7015fd-d343-4901-b4c6-21df2d4ac7a0" providerId="AD" clId="Web-{F311B018-656C-5B0F-922A-08DF909322EB}" dt="2023-04-04T18:38:49.906" v="3"/>
        <pc:sldMkLst>
          <pc:docMk/>
          <pc:sldMk cId="3858522254" sldId="277"/>
        </pc:sldMkLst>
        <pc:spChg chg="mod">
          <ac:chgData name="Pedro Mauritti Granjo" userId="S::p.granjo@fct.unl.pt::cc7015fd-d343-4901-b4c6-21df2d4ac7a0" providerId="AD" clId="Web-{F311B018-656C-5B0F-922A-08DF909322EB}" dt="2023-04-04T17:20:57.150" v="1" actId="1076"/>
          <ac:spMkLst>
            <pc:docMk/>
            <pc:sldMk cId="3858522254" sldId="277"/>
            <ac:spMk id="6" creationId="{C22693B8-F560-C544-C8C0-FABB2C8C83D3}"/>
          </ac:spMkLst>
        </pc:spChg>
      </pc:sldChg>
    </pc:docChg>
  </pc:docChgLst>
  <pc:docChgLst>
    <pc:chgData name="Pedro Mauritti Granjo" userId="cc7015fd-d343-4901-b4c6-21df2d4ac7a0" providerId="ADAL" clId="{D20F7ADE-8282-412C-9995-BF87394831AC}"/>
    <pc:docChg chg="undo custSel modSld">
      <pc:chgData name="Pedro Mauritti Granjo" userId="cc7015fd-d343-4901-b4c6-21df2d4ac7a0" providerId="ADAL" clId="{D20F7ADE-8282-412C-9995-BF87394831AC}" dt="2023-11-19T12:44:37.240" v="1098" actId="20577"/>
      <pc:docMkLst>
        <pc:docMk/>
      </pc:docMkLst>
      <pc:sldChg chg="modSp mod">
        <pc:chgData name="Pedro Mauritti Granjo" userId="cc7015fd-d343-4901-b4c6-21df2d4ac7a0" providerId="ADAL" clId="{D20F7ADE-8282-412C-9995-BF87394831AC}" dt="2023-11-17T19:58:16.754" v="926"/>
        <pc:sldMkLst>
          <pc:docMk/>
          <pc:sldMk cId="0" sldId="268"/>
        </pc:sldMkLst>
        <pc:spChg chg="mod">
          <ac:chgData name="Pedro Mauritti Granjo" userId="cc7015fd-d343-4901-b4c6-21df2d4ac7a0" providerId="ADAL" clId="{D20F7ADE-8282-412C-9995-BF87394831AC}" dt="2023-11-17T19:58:16.754" v="926"/>
          <ac:spMkLst>
            <pc:docMk/>
            <pc:sldMk cId="0" sldId="268"/>
            <ac:spMk id="4" creationId="{88BE49BC-7650-F1C7-8FD3-0BBABADD6A04}"/>
          </ac:spMkLst>
        </pc:spChg>
      </pc:sldChg>
      <pc:sldChg chg="addSp delSp modSp mod">
        <pc:chgData name="Pedro Mauritti Granjo" userId="cc7015fd-d343-4901-b4c6-21df2d4ac7a0" providerId="ADAL" clId="{D20F7ADE-8282-412C-9995-BF87394831AC}" dt="2023-11-19T12:39:20.146" v="930" actId="20577"/>
        <pc:sldMkLst>
          <pc:docMk/>
          <pc:sldMk cId="0" sldId="269"/>
        </pc:sldMkLst>
        <pc:spChg chg="add del mod">
          <ac:chgData name="Pedro Mauritti Granjo" userId="cc7015fd-d343-4901-b4c6-21df2d4ac7a0" providerId="ADAL" clId="{D20F7ADE-8282-412C-9995-BF87394831AC}" dt="2023-11-17T19:31:34.693" v="463" actId="478"/>
          <ac:spMkLst>
            <pc:docMk/>
            <pc:sldMk cId="0" sldId="269"/>
            <ac:spMk id="2" creationId="{22E33C14-3E96-7022-CC03-E21531372295}"/>
          </ac:spMkLst>
        </pc:spChg>
        <pc:spChg chg="add mod">
          <ac:chgData name="Pedro Mauritti Granjo" userId="cc7015fd-d343-4901-b4c6-21df2d4ac7a0" providerId="ADAL" clId="{D20F7ADE-8282-412C-9995-BF87394831AC}" dt="2023-11-19T12:39:20.146" v="930" actId="20577"/>
          <ac:spMkLst>
            <pc:docMk/>
            <pc:sldMk cId="0" sldId="269"/>
            <ac:spMk id="3" creationId="{A29E4224-92C9-1FDC-CB5B-329F664BE36F}"/>
          </ac:spMkLst>
        </pc:spChg>
        <pc:spChg chg="del mod">
          <ac:chgData name="Pedro Mauritti Granjo" userId="cc7015fd-d343-4901-b4c6-21df2d4ac7a0" providerId="ADAL" clId="{D20F7ADE-8282-412C-9995-BF87394831AC}" dt="2023-11-17T19:31:29.402" v="461" actId="478"/>
          <ac:spMkLst>
            <pc:docMk/>
            <pc:sldMk cId="0" sldId="269"/>
            <ac:spMk id="4" creationId="{79DE6C02-1434-3F8D-8864-98C0D4B9495F}"/>
          </ac:spMkLst>
        </pc:spChg>
      </pc:sldChg>
      <pc:sldChg chg="addSp delSp modSp mod">
        <pc:chgData name="Pedro Mauritti Granjo" userId="cc7015fd-d343-4901-b4c6-21df2d4ac7a0" providerId="ADAL" clId="{D20F7ADE-8282-412C-9995-BF87394831AC}" dt="2023-11-19T12:39:29.348" v="935" actId="113"/>
        <pc:sldMkLst>
          <pc:docMk/>
          <pc:sldMk cId="3969417392" sldId="270"/>
        </pc:sldMkLst>
        <pc:spChg chg="add mod">
          <ac:chgData name="Pedro Mauritti Granjo" userId="cc7015fd-d343-4901-b4c6-21df2d4ac7a0" providerId="ADAL" clId="{D20F7ADE-8282-412C-9995-BF87394831AC}" dt="2023-11-19T12:39:29.348" v="935" actId="113"/>
          <ac:spMkLst>
            <pc:docMk/>
            <pc:sldMk cId="3969417392" sldId="270"/>
            <ac:spMk id="2" creationId="{D98677BE-18B6-4915-F821-A3F75D35EAB2}"/>
          </ac:spMkLst>
        </pc:spChg>
        <pc:spChg chg="del">
          <ac:chgData name="Pedro Mauritti Granjo" userId="cc7015fd-d343-4901-b4c6-21df2d4ac7a0" providerId="ADAL" clId="{D20F7ADE-8282-412C-9995-BF87394831AC}" dt="2023-11-17T19:44:26.372" v="885" actId="478"/>
          <ac:spMkLst>
            <pc:docMk/>
            <pc:sldMk cId="3969417392" sldId="270"/>
            <ac:spMk id="3" creationId="{91024E88-419C-94D2-7F26-98D7B07B4005}"/>
          </ac:spMkLst>
        </pc:spChg>
      </pc:sldChg>
      <pc:sldChg chg="addSp delSp modSp mod">
        <pc:chgData name="Pedro Mauritti Granjo" userId="cc7015fd-d343-4901-b4c6-21df2d4ac7a0" providerId="ADAL" clId="{D20F7ADE-8282-412C-9995-BF87394831AC}" dt="2023-11-19T12:44:37.240" v="1098" actId="20577"/>
        <pc:sldMkLst>
          <pc:docMk/>
          <pc:sldMk cId="2986738929" sldId="280"/>
        </pc:sldMkLst>
        <pc:spChg chg="del mod">
          <ac:chgData name="Pedro Mauritti Granjo" userId="cc7015fd-d343-4901-b4c6-21df2d4ac7a0" providerId="ADAL" clId="{D20F7ADE-8282-412C-9995-BF87394831AC}" dt="2023-11-19T12:43:51.575" v="1092" actId="478"/>
          <ac:spMkLst>
            <pc:docMk/>
            <pc:sldMk cId="2986738929" sldId="280"/>
            <ac:spMk id="2" creationId="{8988E7D2-8B47-80A3-5CFD-C03A76C9AABE}"/>
          </ac:spMkLst>
        </pc:spChg>
        <pc:spChg chg="mod">
          <ac:chgData name="Pedro Mauritti Granjo" userId="cc7015fd-d343-4901-b4c6-21df2d4ac7a0" providerId="ADAL" clId="{D20F7ADE-8282-412C-9995-BF87394831AC}" dt="2023-11-19T12:44:37.240" v="1098" actId="20577"/>
          <ac:spMkLst>
            <pc:docMk/>
            <pc:sldMk cId="2986738929" sldId="280"/>
            <ac:spMk id="3" creationId="{F75852C7-E70E-2BDC-0B24-DA113B485EC0}"/>
          </ac:spMkLst>
        </pc:spChg>
        <pc:spChg chg="add del mod">
          <ac:chgData name="Pedro Mauritti Granjo" userId="cc7015fd-d343-4901-b4c6-21df2d4ac7a0" providerId="ADAL" clId="{D20F7ADE-8282-412C-9995-BF87394831AC}" dt="2023-11-19T12:43:51.575" v="1092" actId="478"/>
          <ac:spMkLst>
            <pc:docMk/>
            <pc:sldMk cId="2986738929" sldId="280"/>
            <ac:spMk id="4" creationId="{1C277C25-0D0D-2A08-ED8F-F49D8F3C3B8A}"/>
          </ac:spMkLst>
        </pc:spChg>
        <pc:spChg chg="add del mod">
          <ac:chgData name="Pedro Mauritti Granjo" userId="cc7015fd-d343-4901-b4c6-21df2d4ac7a0" providerId="ADAL" clId="{D20F7ADE-8282-412C-9995-BF87394831AC}" dt="2023-11-19T12:43:51.575" v="1092" actId="478"/>
          <ac:spMkLst>
            <pc:docMk/>
            <pc:sldMk cId="2986738929" sldId="280"/>
            <ac:spMk id="5" creationId="{55709FE8-0778-9518-90A4-2B4385FE5684}"/>
          </ac:spMkLst>
        </pc:spChg>
        <pc:spChg chg="add del mod ord">
          <ac:chgData name="Pedro Mauritti Granjo" userId="cc7015fd-d343-4901-b4c6-21df2d4ac7a0" providerId="ADAL" clId="{D20F7ADE-8282-412C-9995-BF87394831AC}" dt="2023-11-19T12:43:51.575" v="1092" actId="478"/>
          <ac:spMkLst>
            <pc:docMk/>
            <pc:sldMk cId="2986738929" sldId="280"/>
            <ac:spMk id="6" creationId="{B0A80A54-9924-A5B7-138E-1FDE63F1CEE8}"/>
          </ac:spMkLst>
        </pc:spChg>
        <pc:picChg chg="add del mod">
          <ac:chgData name="Pedro Mauritti Granjo" userId="cc7015fd-d343-4901-b4c6-21df2d4ac7a0" providerId="ADAL" clId="{D20F7ADE-8282-412C-9995-BF87394831AC}" dt="2023-11-19T12:42:49.170" v="1085"/>
          <ac:picMkLst>
            <pc:docMk/>
            <pc:sldMk cId="2986738929" sldId="280"/>
            <ac:picMk id="8" creationId="{ACB7B023-F949-FCB3-5D2C-5C5CF96D5D0F}"/>
          </ac:picMkLst>
        </pc:picChg>
        <pc:picChg chg="add del mod">
          <ac:chgData name="Pedro Mauritti Granjo" userId="cc7015fd-d343-4901-b4c6-21df2d4ac7a0" providerId="ADAL" clId="{D20F7ADE-8282-412C-9995-BF87394831AC}" dt="2023-11-19T12:43:51.575" v="1092" actId="478"/>
          <ac:picMkLst>
            <pc:docMk/>
            <pc:sldMk cId="2986738929" sldId="280"/>
            <ac:picMk id="9" creationId="{D2D9384F-8DF5-33B4-AF89-A34AEA6F4D0B}"/>
          </ac:picMkLst>
        </pc:picChg>
        <pc:picChg chg="add mod">
          <ac:chgData name="Pedro Mauritti Granjo" userId="cc7015fd-d343-4901-b4c6-21df2d4ac7a0" providerId="ADAL" clId="{D20F7ADE-8282-412C-9995-BF87394831AC}" dt="2023-11-19T12:44:04.277" v="1096" actId="1076"/>
          <ac:picMkLst>
            <pc:docMk/>
            <pc:sldMk cId="2986738929" sldId="280"/>
            <ac:picMk id="11" creationId="{62145F63-D2F3-6D73-9A8C-202BA3780965}"/>
          </ac:picMkLst>
        </pc:picChg>
      </pc:sldChg>
    </pc:docChg>
  </pc:docChgLst>
  <pc:docChgLst>
    <pc:chgData name="Utilizador Convidado" userId="S::urn:spo:anon#63c0a400633f20858f6cea94e22ea20bb071b664995b1c6873b1a49520641ff1::" providerId="AD" clId="Web-{84D9B2D9-5446-0C1A-3E95-B8CD46C00E8F}"/>
    <pc:docChg chg="modSld">
      <pc:chgData name="Utilizador Convidado" userId="S::urn:spo:anon#63c0a400633f20858f6cea94e22ea20bb071b664995b1c6873b1a49520641ff1::" providerId="AD" clId="Web-{84D9B2D9-5446-0C1A-3E95-B8CD46C00E8F}" dt="2023-03-22T16:42:43.744" v="6"/>
      <pc:docMkLst>
        <pc:docMk/>
      </pc:docMkLst>
      <pc:sldChg chg="modSp">
        <pc:chgData name="Utilizador Convidado" userId="S::urn:spo:anon#63c0a400633f20858f6cea94e22ea20bb071b664995b1c6873b1a49520641ff1::" providerId="AD" clId="Web-{84D9B2D9-5446-0C1A-3E95-B8CD46C00E8F}" dt="2023-03-22T16:42:43.744" v="6"/>
        <pc:sldMkLst>
          <pc:docMk/>
          <pc:sldMk cId="0" sldId="258"/>
        </pc:sldMkLst>
        <pc:spChg chg="mod">
          <ac:chgData name="Utilizador Convidado" userId="S::urn:spo:anon#63c0a400633f20858f6cea94e22ea20bb071b664995b1c6873b1a49520641ff1::" providerId="AD" clId="Web-{84D9B2D9-5446-0C1A-3E95-B8CD46C00E8F}" dt="2023-03-22T16:42:43.744" v="6"/>
          <ac:spMkLst>
            <pc:docMk/>
            <pc:sldMk cId="0" sldId="258"/>
            <ac:spMk id="68" creationId="{00000000-0000-0000-0000-000000000000}"/>
          </ac:spMkLst>
        </pc:spChg>
      </pc:sldChg>
    </pc:docChg>
  </pc:docChgLst>
  <pc:docChgLst>
    <pc:chgData name="Pedro Mauritti Granjo" userId="S::p.granjo@fct.unl.pt::cc7015fd-d343-4901-b4c6-21df2d4ac7a0" providerId="AD" clId="Web-{2A4E96B9-DCC8-1CC9-AA70-532B8DC8B8A2}"/>
    <pc:docChg chg="modSld">
      <pc:chgData name="Pedro Mauritti Granjo" userId="S::p.granjo@fct.unl.pt::cc7015fd-d343-4901-b4c6-21df2d4ac7a0" providerId="AD" clId="Web-{2A4E96B9-DCC8-1CC9-AA70-532B8DC8B8A2}" dt="2023-04-10T15:11:12.664" v="5" actId="1076"/>
      <pc:docMkLst>
        <pc:docMk/>
      </pc:docMkLst>
      <pc:sldChg chg="addSp delSp modSp">
        <pc:chgData name="Pedro Mauritti Granjo" userId="S::p.granjo@fct.unl.pt::cc7015fd-d343-4901-b4c6-21df2d4ac7a0" providerId="AD" clId="Web-{2A4E96B9-DCC8-1CC9-AA70-532B8DC8B8A2}" dt="2023-04-10T15:11:12.664" v="5" actId="1076"/>
        <pc:sldMkLst>
          <pc:docMk/>
          <pc:sldMk cId="3969417392" sldId="270"/>
        </pc:sldMkLst>
        <pc:picChg chg="del">
          <ac:chgData name="Pedro Mauritti Granjo" userId="S::p.granjo@fct.unl.pt::cc7015fd-d343-4901-b4c6-21df2d4ac7a0" providerId="AD" clId="Web-{2A4E96B9-DCC8-1CC9-AA70-532B8DC8B8A2}" dt="2023-04-10T15:11:08.383" v="0"/>
          <ac:picMkLst>
            <pc:docMk/>
            <pc:sldMk cId="3969417392" sldId="270"/>
            <ac:picMk id="2" creationId="{8006C2B0-DE39-1EB0-DCE6-1EFB157A6F62}"/>
          </ac:picMkLst>
        </pc:picChg>
        <pc:picChg chg="add mod">
          <ac:chgData name="Pedro Mauritti Granjo" userId="S::p.granjo@fct.unl.pt::cc7015fd-d343-4901-b4c6-21df2d4ac7a0" providerId="AD" clId="Web-{2A4E96B9-DCC8-1CC9-AA70-532B8DC8B8A2}" dt="2023-04-10T15:11:12.664" v="5" actId="1076"/>
          <ac:picMkLst>
            <pc:docMk/>
            <pc:sldMk cId="3969417392" sldId="270"/>
            <ac:picMk id="3" creationId="{50E8666B-0E29-7ECD-F0F0-D782B41D3922}"/>
          </ac:picMkLst>
        </pc:picChg>
      </pc:sldChg>
    </pc:docChg>
  </pc:docChgLst>
  <pc:docChgLst>
    <pc:chgData name="Pedro Mauritti Granjo" userId="S::p.granjo@fct.unl.pt::cc7015fd-d343-4901-b4c6-21df2d4ac7a0" providerId="AD" clId="Web-{23858365-E1FD-AF67-B800-9DECDA7D7CDB}"/>
    <pc:docChg chg="modSld">
      <pc:chgData name="Pedro Mauritti Granjo" userId="S::p.granjo@fct.unl.pt::cc7015fd-d343-4901-b4c6-21df2d4ac7a0" providerId="AD" clId="Web-{23858365-E1FD-AF67-B800-9DECDA7D7CDB}" dt="2023-04-06T15:35:11.342" v="4" actId="20577"/>
      <pc:docMkLst>
        <pc:docMk/>
      </pc:docMkLst>
      <pc:sldChg chg="modSp">
        <pc:chgData name="Pedro Mauritti Granjo" userId="S::p.granjo@fct.unl.pt::cc7015fd-d343-4901-b4c6-21df2d4ac7a0" providerId="AD" clId="Web-{23858365-E1FD-AF67-B800-9DECDA7D7CDB}" dt="2023-04-06T15:35:11.342" v="4" actId="20577"/>
        <pc:sldMkLst>
          <pc:docMk/>
          <pc:sldMk cId="2860821069" sldId="278"/>
        </pc:sldMkLst>
        <pc:spChg chg="mod">
          <ac:chgData name="Pedro Mauritti Granjo" userId="S::p.granjo@fct.unl.pt::cc7015fd-d343-4901-b4c6-21df2d4ac7a0" providerId="AD" clId="Web-{23858365-E1FD-AF67-B800-9DECDA7D7CDB}" dt="2023-04-06T15:35:11.342" v="4" actId="20577"/>
          <ac:spMkLst>
            <pc:docMk/>
            <pc:sldMk cId="2860821069" sldId="278"/>
            <ac:spMk id="6" creationId="{12DA03D6-08FB-04E3-3596-597820281F85}"/>
          </ac:spMkLst>
        </pc:spChg>
      </pc:sldChg>
      <pc:sldChg chg="modSp">
        <pc:chgData name="Pedro Mauritti Granjo" userId="S::p.granjo@fct.unl.pt::cc7015fd-d343-4901-b4c6-21df2d4ac7a0" providerId="AD" clId="Web-{23858365-E1FD-AF67-B800-9DECDA7D7CDB}" dt="2023-04-06T15:29:04.745" v="3"/>
        <pc:sldMkLst>
          <pc:docMk/>
          <pc:sldMk cId="120033746" sldId="279"/>
        </pc:sldMkLst>
        <pc:graphicFrameChg chg="mod modGraphic">
          <ac:chgData name="Pedro Mauritti Granjo" userId="S::p.granjo@fct.unl.pt::cc7015fd-d343-4901-b4c6-21df2d4ac7a0" providerId="AD" clId="Web-{23858365-E1FD-AF67-B800-9DECDA7D7CDB}" dt="2023-04-06T15:29:04.745" v="3"/>
          <ac:graphicFrameMkLst>
            <pc:docMk/>
            <pc:sldMk cId="120033746" sldId="279"/>
            <ac:graphicFrameMk id="5" creationId="{90CA37FC-97AF-2170-4009-B24B8E3576CB}"/>
          </ac:graphicFrameMkLst>
        </pc:graphicFrameChg>
      </pc:sldChg>
    </pc:docChg>
  </pc:docChgLst>
  <pc:docChgLst>
    <pc:chgData name="Pedro Mauritti Granjo" userId="S::p.granjo@fct.unl.pt::cc7015fd-d343-4901-b4c6-21df2d4ac7a0" providerId="AD" clId="Web-{0E41470F-8851-0378-EBDA-D679E4516AA9}"/>
    <pc:docChg chg="delSld modSld">
      <pc:chgData name="Pedro Mauritti Granjo" userId="S::p.granjo@fct.unl.pt::cc7015fd-d343-4901-b4c6-21df2d4ac7a0" providerId="AD" clId="Web-{0E41470F-8851-0378-EBDA-D679E4516AA9}" dt="2023-03-31T21:56:48.270" v="28"/>
      <pc:docMkLst>
        <pc:docMk/>
      </pc:docMkLst>
      <pc:sldChg chg="del">
        <pc:chgData name="Pedro Mauritti Granjo" userId="S::p.granjo@fct.unl.pt::cc7015fd-d343-4901-b4c6-21df2d4ac7a0" providerId="AD" clId="Web-{0E41470F-8851-0378-EBDA-D679E4516AA9}" dt="2023-03-31T21:56:48.270" v="28"/>
        <pc:sldMkLst>
          <pc:docMk/>
          <pc:sldMk cId="0" sldId="266"/>
        </pc:sldMkLst>
      </pc:sldChg>
      <pc:sldChg chg="addSp delSp modSp">
        <pc:chgData name="Pedro Mauritti Granjo" userId="S::p.granjo@fct.unl.pt::cc7015fd-d343-4901-b4c6-21df2d4ac7a0" providerId="AD" clId="Web-{0E41470F-8851-0378-EBDA-D679E4516AA9}" dt="2023-03-31T21:56:33.317" v="27" actId="14100"/>
        <pc:sldMkLst>
          <pc:docMk/>
          <pc:sldMk cId="0" sldId="269"/>
        </pc:sldMkLst>
        <pc:picChg chg="add del mod">
          <ac:chgData name="Pedro Mauritti Granjo" userId="S::p.granjo@fct.unl.pt::cc7015fd-d343-4901-b4c6-21df2d4ac7a0" providerId="AD" clId="Web-{0E41470F-8851-0378-EBDA-D679E4516AA9}" dt="2023-03-31T21:55:36.925" v="13"/>
          <ac:picMkLst>
            <pc:docMk/>
            <pc:sldMk cId="0" sldId="269"/>
            <ac:picMk id="2" creationId="{D50B19A8-A0ED-1F84-1F5F-36405A939BBF}"/>
          </ac:picMkLst>
        </pc:picChg>
        <pc:picChg chg="add mod">
          <ac:chgData name="Pedro Mauritti Granjo" userId="S::p.granjo@fct.unl.pt::cc7015fd-d343-4901-b4c6-21df2d4ac7a0" providerId="AD" clId="Web-{0E41470F-8851-0378-EBDA-D679E4516AA9}" dt="2023-03-31T21:56:33.317" v="27" actId="14100"/>
          <ac:picMkLst>
            <pc:docMk/>
            <pc:sldMk cId="0" sldId="269"/>
            <ac:picMk id="3" creationId="{4694CD79-4D8C-DD3E-898A-13B0217B1149}"/>
          </ac:picMkLst>
        </pc:picChg>
        <pc:picChg chg="del">
          <ac:chgData name="Pedro Mauritti Granjo" userId="S::p.granjo@fct.unl.pt::cc7015fd-d343-4901-b4c6-21df2d4ac7a0" providerId="AD" clId="Web-{0E41470F-8851-0378-EBDA-D679E4516AA9}" dt="2023-03-31T21:54:42.971" v="6"/>
          <ac:picMkLst>
            <pc:docMk/>
            <pc:sldMk cId="0" sldId="269"/>
            <ac:picMk id="5" creationId="{50B709C0-0565-0A97-C46C-50C36B3B33B4}"/>
          </ac:picMkLst>
        </pc:picChg>
      </pc:sldChg>
      <pc:sldChg chg="addSp delSp modSp">
        <pc:chgData name="Pedro Mauritti Granjo" userId="S::p.granjo@fct.unl.pt::cc7015fd-d343-4901-b4c6-21df2d4ac7a0" providerId="AD" clId="Web-{0E41470F-8851-0378-EBDA-D679E4516AA9}" dt="2023-03-31T21:55:43.925" v="15"/>
        <pc:sldMkLst>
          <pc:docMk/>
          <pc:sldMk cId="3969417392" sldId="270"/>
        </pc:sldMkLst>
        <pc:picChg chg="add mod">
          <ac:chgData name="Pedro Mauritti Granjo" userId="S::p.granjo@fct.unl.pt::cc7015fd-d343-4901-b4c6-21df2d4ac7a0" providerId="AD" clId="Web-{0E41470F-8851-0378-EBDA-D679E4516AA9}" dt="2023-03-31T21:54:38.939" v="5" actId="1076"/>
          <ac:picMkLst>
            <pc:docMk/>
            <pc:sldMk cId="3969417392" sldId="270"/>
            <ac:picMk id="2" creationId="{8006C2B0-DE39-1EB0-DCE6-1EFB157A6F62}"/>
          </ac:picMkLst>
        </pc:picChg>
        <pc:picChg chg="add del mod">
          <ac:chgData name="Pedro Mauritti Granjo" userId="S::p.granjo@fct.unl.pt::cc7015fd-d343-4901-b4c6-21df2d4ac7a0" providerId="AD" clId="Web-{0E41470F-8851-0378-EBDA-D679E4516AA9}" dt="2023-03-31T21:55:43.925" v="15"/>
          <ac:picMkLst>
            <pc:docMk/>
            <pc:sldMk cId="3969417392" sldId="270"/>
            <ac:picMk id="3" creationId="{323B30D9-CAE7-564F-FB64-3B3745D148B7}"/>
          </ac:picMkLst>
        </pc:picChg>
        <pc:picChg chg="del">
          <ac:chgData name="Pedro Mauritti Granjo" userId="S::p.granjo@fct.unl.pt::cc7015fd-d343-4901-b4c6-21df2d4ac7a0" providerId="AD" clId="Web-{0E41470F-8851-0378-EBDA-D679E4516AA9}" dt="2023-03-31T21:54:17.986" v="0"/>
          <ac:picMkLst>
            <pc:docMk/>
            <pc:sldMk cId="3969417392" sldId="270"/>
            <ac:picMk id="4" creationId="{0E2599FF-8F54-06BD-33A8-3B0B0F314782}"/>
          </ac:picMkLst>
        </pc:picChg>
      </pc:sldChg>
    </pc:docChg>
  </pc:docChgLst>
  <pc:docChgLst>
    <pc:chgData name="Utilizador Convidado" userId="S::urn:spo:anon#63c0a400633f20858f6cea94e22ea20bb071b664995b1c6873b1a49520641ff1::" providerId="AD" clId="Web-{F9BB3B38-0F6A-8AB7-DD4D-4C75613BF300}"/>
    <pc:docChg chg="modSld">
      <pc:chgData name="Utilizador Convidado" userId="S::urn:spo:anon#63c0a400633f20858f6cea94e22ea20bb071b664995b1c6873b1a49520641ff1::" providerId="AD" clId="Web-{F9BB3B38-0F6A-8AB7-DD4D-4C75613BF300}" dt="2023-03-22T16:26:37.053" v="0"/>
      <pc:docMkLst>
        <pc:docMk/>
      </pc:docMkLst>
      <pc:sldChg chg="modSp">
        <pc:chgData name="Utilizador Convidado" userId="S::urn:spo:anon#63c0a400633f20858f6cea94e22ea20bb071b664995b1c6873b1a49520641ff1::" providerId="AD" clId="Web-{F9BB3B38-0F6A-8AB7-DD4D-4C75613BF300}" dt="2023-03-22T16:26:37.053" v="0"/>
        <pc:sldMkLst>
          <pc:docMk/>
          <pc:sldMk cId="0" sldId="258"/>
        </pc:sldMkLst>
        <pc:spChg chg="mod">
          <ac:chgData name="Utilizador Convidado" userId="S::urn:spo:anon#63c0a400633f20858f6cea94e22ea20bb071b664995b1c6873b1a49520641ff1::" providerId="AD" clId="Web-{F9BB3B38-0F6A-8AB7-DD4D-4C75613BF300}" dt="2023-03-22T16:26:37.053" v="0"/>
          <ac:spMkLst>
            <pc:docMk/>
            <pc:sldMk cId="0" sldId="258"/>
            <ac:spMk id="68" creationId="{00000000-0000-0000-0000-000000000000}"/>
          </ac:spMkLst>
        </pc:spChg>
      </pc:sldChg>
    </pc:docChg>
  </pc:docChgLst>
  <pc:docChgLst>
    <pc:chgData name="Pedro Mauritti Granjo" userId="S::p.granjo@fct.unl.pt::cc7015fd-d343-4901-b4c6-21df2d4ac7a0" providerId="AD" clId="Web-{63971FBC-599A-0F19-0218-2F26BE97CF92}"/>
    <pc:docChg chg="modSld">
      <pc:chgData name="Pedro Mauritti Granjo" userId="S::p.granjo@fct.unl.pt::cc7015fd-d343-4901-b4c6-21df2d4ac7a0" providerId="AD" clId="Web-{63971FBC-599A-0F19-0218-2F26BE97CF92}" dt="2023-04-11T14:57:14.456" v="252"/>
      <pc:docMkLst>
        <pc:docMk/>
      </pc:docMkLst>
      <pc:sldChg chg="modSp">
        <pc:chgData name="Pedro Mauritti Granjo" userId="S::p.granjo@fct.unl.pt::cc7015fd-d343-4901-b4c6-21df2d4ac7a0" providerId="AD" clId="Web-{63971FBC-599A-0F19-0218-2F26BE97CF92}" dt="2023-04-11T14:57:14.456" v="252"/>
        <pc:sldMkLst>
          <pc:docMk/>
          <pc:sldMk cId="120033746" sldId="279"/>
        </pc:sldMkLst>
        <pc:spChg chg="mod">
          <ac:chgData name="Pedro Mauritti Granjo" userId="S::p.granjo@fct.unl.pt::cc7015fd-d343-4901-b4c6-21df2d4ac7a0" providerId="AD" clId="Web-{63971FBC-599A-0F19-0218-2F26BE97CF92}" dt="2023-04-11T11:09:55.639" v="25" actId="20577"/>
          <ac:spMkLst>
            <pc:docMk/>
            <pc:sldMk cId="120033746" sldId="279"/>
            <ac:spMk id="7" creationId="{CCA8EBAF-6819-ABAE-6141-40945D50709F}"/>
          </ac:spMkLst>
        </pc:spChg>
        <pc:graphicFrameChg chg="mod modGraphic">
          <ac:chgData name="Pedro Mauritti Granjo" userId="S::p.granjo@fct.unl.pt::cc7015fd-d343-4901-b4c6-21df2d4ac7a0" providerId="AD" clId="Web-{63971FBC-599A-0F19-0218-2F26BE97CF92}" dt="2023-04-11T14:57:14.456" v="252"/>
          <ac:graphicFrameMkLst>
            <pc:docMk/>
            <pc:sldMk cId="120033746" sldId="279"/>
            <ac:graphicFrameMk id="5" creationId="{90CA37FC-97AF-2170-4009-B24B8E3576CB}"/>
          </ac:graphicFrameMkLst>
        </pc:graphicFrameChg>
      </pc:sldChg>
    </pc:docChg>
  </pc:docChgLst>
  <pc:docChgLst>
    <pc:chgData name="Pedro Mauritti Granjo" userId="S::p.granjo@fct.unl.pt::cc7015fd-d343-4901-b4c6-21df2d4ac7a0" providerId="AD" clId="Web-{8E64E77B-1F41-306D-81B7-0CFF242D1771}"/>
    <pc:docChg chg="addSld delSld modSld">
      <pc:chgData name="Pedro Mauritti Granjo" userId="S::p.granjo@fct.unl.pt::cc7015fd-d343-4901-b4c6-21df2d4ac7a0" providerId="AD" clId="Web-{8E64E77B-1F41-306D-81B7-0CFF242D1771}" dt="2023-03-28T17:38:59.812" v="2250" actId="20577"/>
      <pc:docMkLst>
        <pc:docMk/>
      </pc:docMkLst>
      <pc:sldChg chg="del">
        <pc:chgData name="Pedro Mauritti Granjo" userId="S::p.granjo@fct.unl.pt::cc7015fd-d343-4901-b4c6-21df2d4ac7a0" providerId="AD" clId="Web-{8E64E77B-1F41-306D-81B7-0CFF242D1771}" dt="2023-03-28T16:22:53.550" v="2133"/>
        <pc:sldMkLst>
          <pc:docMk/>
          <pc:sldMk cId="0" sldId="256"/>
        </pc:sldMkLst>
      </pc:sldChg>
      <pc:sldChg chg="modSp">
        <pc:chgData name="Pedro Mauritti Granjo" userId="S::p.granjo@fct.unl.pt::cc7015fd-d343-4901-b4c6-21df2d4ac7a0" providerId="AD" clId="Web-{8E64E77B-1F41-306D-81B7-0CFF242D1771}" dt="2023-03-28T14:44:18.262" v="2" actId="1076"/>
        <pc:sldMkLst>
          <pc:docMk/>
          <pc:sldMk cId="0" sldId="264"/>
        </pc:sldMkLst>
        <pc:spChg chg="mod">
          <ac:chgData name="Pedro Mauritti Granjo" userId="S::p.granjo@fct.unl.pt::cc7015fd-d343-4901-b4c6-21df2d4ac7a0" providerId="AD" clId="Web-{8E64E77B-1F41-306D-81B7-0CFF242D1771}" dt="2023-03-28T14:44:18.262" v="2" actId="1076"/>
          <ac:spMkLst>
            <pc:docMk/>
            <pc:sldMk cId="0" sldId="264"/>
            <ac:spMk id="111" creationId="{00000000-0000-0000-0000-000000000000}"/>
          </ac:spMkLst>
        </pc:spChg>
      </pc:sldChg>
      <pc:sldChg chg="modSp">
        <pc:chgData name="Pedro Mauritti Granjo" userId="S::p.granjo@fct.unl.pt::cc7015fd-d343-4901-b4c6-21df2d4ac7a0" providerId="AD" clId="Web-{8E64E77B-1F41-306D-81B7-0CFF242D1771}" dt="2023-03-28T16:05:28.975" v="2132" actId="1076"/>
        <pc:sldMkLst>
          <pc:docMk/>
          <pc:sldMk cId="3093739534" sldId="272"/>
        </pc:sldMkLst>
        <pc:picChg chg="mod">
          <ac:chgData name="Pedro Mauritti Granjo" userId="S::p.granjo@fct.unl.pt::cc7015fd-d343-4901-b4c6-21df2d4ac7a0" providerId="AD" clId="Web-{8E64E77B-1F41-306D-81B7-0CFF242D1771}" dt="2023-03-28T16:05:28.975" v="2132" actId="1076"/>
          <ac:picMkLst>
            <pc:docMk/>
            <pc:sldMk cId="3093739534" sldId="272"/>
            <ac:picMk id="5" creationId="{27735426-A8A9-597C-6C85-99057911985B}"/>
          </ac:picMkLst>
        </pc:picChg>
      </pc:sldChg>
      <pc:sldChg chg="del">
        <pc:chgData name="Pedro Mauritti Granjo" userId="S::p.granjo@fct.unl.pt::cc7015fd-d343-4901-b4c6-21df2d4ac7a0" providerId="AD" clId="Web-{8E64E77B-1F41-306D-81B7-0CFF242D1771}" dt="2023-03-28T14:44:06.230" v="0"/>
        <pc:sldMkLst>
          <pc:docMk/>
          <pc:sldMk cId="1302607818" sldId="273"/>
        </pc:sldMkLst>
      </pc:sldChg>
      <pc:sldChg chg="addSp delSp modSp new mod modShow">
        <pc:chgData name="Pedro Mauritti Granjo" userId="S::p.granjo@fct.unl.pt::cc7015fd-d343-4901-b4c6-21df2d4ac7a0" providerId="AD" clId="Web-{8E64E77B-1F41-306D-81B7-0CFF242D1771}" dt="2023-03-28T16:03:21.346" v="2128" actId="1076"/>
        <pc:sldMkLst>
          <pc:docMk/>
          <pc:sldMk cId="4168802406" sldId="275"/>
        </pc:sldMkLst>
        <pc:spChg chg="del">
          <ac:chgData name="Pedro Mauritti Granjo" userId="S::p.granjo@fct.unl.pt::cc7015fd-d343-4901-b4c6-21df2d4ac7a0" providerId="AD" clId="Web-{8E64E77B-1F41-306D-81B7-0CFF242D1771}" dt="2023-03-28T14:44:22.996" v="5"/>
          <ac:spMkLst>
            <pc:docMk/>
            <pc:sldMk cId="4168802406" sldId="275"/>
            <ac:spMk id="2" creationId="{10DA4581-0CD9-FDE3-436B-8EF12887D83A}"/>
          </ac:spMkLst>
        </pc:spChg>
        <pc:spChg chg="add mod">
          <ac:chgData name="Pedro Mauritti Granjo" userId="S::p.granjo@fct.unl.pt::cc7015fd-d343-4901-b4c6-21df2d4ac7a0" providerId="AD" clId="Web-{8E64E77B-1F41-306D-81B7-0CFF242D1771}" dt="2023-03-28T16:03:21.346" v="2128" actId="1076"/>
          <ac:spMkLst>
            <pc:docMk/>
            <pc:sldMk cId="4168802406" sldId="275"/>
            <ac:spMk id="3" creationId="{9D9CEDA6-6D47-0BEF-C0CE-9CA89CAA2FA1}"/>
          </ac:spMkLst>
        </pc:spChg>
        <pc:spChg chg="del">
          <ac:chgData name="Pedro Mauritti Granjo" userId="S::p.granjo@fct.unl.pt::cc7015fd-d343-4901-b4c6-21df2d4ac7a0" providerId="AD" clId="Web-{8E64E77B-1F41-306D-81B7-0CFF242D1771}" dt="2023-03-28T14:44:22.246" v="4"/>
          <ac:spMkLst>
            <pc:docMk/>
            <pc:sldMk cId="4168802406" sldId="275"/>
            <ac:spMk id="3" creationId="{BA45BA84-D2AE-AEAF-1AE7-B99E8DC712F9}"/>
          </ac:spMkLst>
        </pc:spChg>
        <pc:spChg chg="add del">
          <ac:chgData name="Pedro Mauritti Granjo" userId="S::p.granjo@fct.unl.pt::cc7015fd-d343-4901-b4c6-21df2d4ac7a0" providerId="AD" clId="Web-{8E64E77B-1F41-306D-81B7-0CFF242D1771}" dt="2023-03-28T14:46:27.828" v="61"/>
          <ac:spMkLst>
            <pc:docMk/>
            <pc:sldMk cId="4168802406" sldId="275"/>
            <ac:spMk id="5" creationId="{55BD45DB-35C5-1F0E-0398-4D87BB94CD7C}"/>
          </ac:spMkLst>
        </pc:spChg>
        <pc:spChg chg="add del mod">
          <ac:chgData name="Pedro Mauritti Granjo" userId="S::p.granjo@fct.unl.pt::cc7015fd-d343-4901-b4c6-21df2d4ac7a0" providerId="AD" clId="Web-{8E64E77B-1F41-306D-81B7-0CFF242D1771}" dt="2023-03-28T14:53:54.107" v="249"/>
          <ac:spMkLst>
            <pc:docMk/>
            <pc:sldMk cId="4168802406" sldId="275"/>
            <ac:spMk id="6" creationId="{70E0C85D-6E75-6126-F374-5F20E217BC32}"/>
          </ac:spMkLst>
        </pc:spChg>
        <pc:spChg chg="add del mod">
          <ac:chgData name="Pedro Mauritti Granjo" userId="S::p.granjo@fct.unl.pt::cc7015fd-d343-4901-b4c6-21df2d4ac7a0" providerId="AD" clId="Web-{8E64E77B-1F41-306D-81B7-0CFF242D1771}" dt="2023-03-28T14:57:20.910" v="356"/>
          <ac:spMkLst>
            <pc:docMk/>
            <pc:sldMk cId="4168802406" sldId="275"/>
            <ac:spMk id="7" creationId="{D4F66C84-B323-DF1A-D180-C7AACBF7D787}"/>
          </ac:spMkLst>
        </pc:spChg>
        <pc:spChg chg="add mod">
          <ac:chgData name="Pedro Mauritti Granjo" userId="S::p.granjo@fct.unl.pt::cc7015fd-d343-4901-b4c6-21df2d4ac7a0" providerId="AD" clId="Web-{8E64E77B-1F41-306D-81B7-0CFF242D1771}" dt="2023-03-28T15:49:19.504" v="1948" actId="1076"/>
          <ac:spMkLst>
            <pc:docMk/>
            <pc:sldMk cId="4168802406" sldId="275"/>
            <ac:spMk id="8" creationId="{526865A6-50A8-2890-32FE-FB20E7B2BF05}"/>
          </ac:spMkLst>
        </pc:spChg>
        <pc:spChg chg="add mod">
          <ac:chgData name="Pedro Mauritti Granjo" userId="S::p.granjo@fct.unl.pt::cc7015fd-d343-4901-b4c6-21df2d4ac7a0" providerId="AD" clId="Web-{8E64E77B-1F41-306D-81B7-0CFF242D1771}" dt="2023-03-28T15:49:19.551" v="1949" actId="1076"/>
          <ac:spMkLst>
            <pc:docMk/>
            <pc:sldMk cId="4168802406" sldId="275"/>
            <ac:spMk id="9" creationId="{5F01B3A1-636F-1C4E-40DF-4DB8AB9EF0E5}"/>
          </ac:spMkLst>
        </pc:spChg>
        <pc:graphicFrameChg chg="add mod modGraphic">
          <ac:chgData name="Pedro Mauritti Granjo" userId="S::p.granjo@fct.unl.pt::cc7015fd-d343-4901-b4c6-21df2d4ac7a0" providerId="AD" clId="Web-{8E64E77B-1F41-306D-81B7-0CFF242D1771}" dt="2023-03-28T16:01:12.779" v="2079"/>
          <ac:graphicFrameMkLst>
            <pc:docMk/>
            <pc:sldMk cId="4168802406" sldId="275"/>
            <ac:graphicFrameMk id="4" creationId="{6219EE75-22EE-98E7-6DBC-AB1724A09DAE}"/>
          </ac:graphicFrameMkLst>
        </pc:graphicFrameChg>
        <pc:cxnChg chg="add mod">
          <ac:chgData name="Pedro Mauritti Granjo" userId="S::p.granjo@fct.unl.pt::cc7015fd-d343-4901-b4c6-21df2d4ac7a0" providerId="AD" clId="Web-{8E64E77B-1F41-306D-81B7-0CFF242D1771}" dt="2023-03-28T15:49:19.582" v="1950" actId="1076"/>
          <ac:cxnSpMkLst>
            <pc:docMk/>
            <pc:sldMk cId="4168802406" sldId="275"/>
            <ac:cxnSpMk id="10" creationId="{939517C7-C20D-35DC-4D26-8CC6CE48D63A}"/>
          </ac:cxnSpMkLst>
        </pc:cxnChg>
      </pc:sldChg>
      <pc:sldChg chg="new del">
        <pc:chgData name="Pedro Mauritti Granjo" userId="S::p.granjo@fct.unl.pt::cc7015fd-d343-4901-b4c6-21df2d4ac7a0" providerId="AD" clId="Web-{8E64E77B-1F41-306D-81B7-0CFF242D1771}" dt="2023-03-28T14:46:06.093" v="22"/>
        <pc:sldMkLst>
          <pc:docMk/>
          <pc:sldMk cId="2556520881" sldId="276"/>
        </pc:sldMkLst>
      </pc:sldChg>
      <pc:sldChg chg="addSp delSp modSp new">
        <pc:chgData name="Pedro Mauritti Granjo" userId="S::p.granjo@fct.unl.pt::cc7015fd-d343-4901-b4c6-21df2d4ac7a0" providerId="AD" clId="Web-{8E64E77B-1F41-306D-81B7-0CFF242D1771}" dt="2023-03-28T16:24:55.101" v="2164" actId="20577"/>
        <pc:sldMkLst>
          <pc:docMk/>
          <pc:sldMk cId="2756113789" sldId="276"/>
        </pc:sldMkLst>
        <pc:spChg chg="del">
          <ac:chgData name="Pedro Mauritti Granjo" userId="S::p.granjo@fct.unl.pt::cc7015fd-d343-4901-b4c6-21df2d4ac7a0" providerId="AD" clId="Web-{8E64E77B-1F41-306D-81B7-0CFF242D1771}" dt="2023-03-28T16:23:11.597" v="2135"/>
          <ac:spMkLst>
            <pc:docMk/>
            <pc:sldMk cId="2756113789" sldId="276"/>
            <ac:spMk id="2" creationId="{0B28B444-6FFB-722F-1032-8FEA95DCF069}"/>
          </ac:spMkLst>
        </pc:spChg>
        <pc:spChg chg="add mod">
          <ac:chgData name="Pedro Mauritti Granjo" userId="S::p.granjo@fct.unl.pt::cc7015fd-d343-4901-b4c6-21df2d4ac7a0" providerId="AD" clId="Web-{8E64E77B-1F41-306D-81B7-0CFF242D1771}" dt="2023-03-28T16:24:55.101" v="2164" actId="20577"/>
          <ac:spMkLst>
            <pc:docMk/>
            <pc:sldMk cId="2756113789" sldId="276"/>
            <ac:spMk id="6" creationId="{1B3079FD-51CF-26B9-6E06-E4759DBA9CC8}"/>
          </ac:spMkLst>
        </pc:spChg>
        <pc:picChg chg="add del mod">
          <ac:chgData name="Pedro Mauritti Granjo" userId="S::p.granjo@fct.unl.pt::cc7015fd-d343-4901-b4c6-21df2d4ac7a0" providerId="AD" clId="Web-{8E64E77B-1F41-306D-81B7-0CFF242D1771}" dt="2023-03-28T16:23:21.473" v="2140"/>
          <ac:picMkLst>
            <pc:docMk/>
            <pc:sldMk cId="2756113789" sldId="276"/>
            <ac:picMk id="3" creationId="{D6A307FB-0503-B2EA-5028-7F55081F7FA4}"/>
          </ac:picMkLst>
        </pc:picChg>
        <pc:picChg chg="add mod">
          <ac:chgData name="Pedro Mauritti Granjo" userId="S::p.granjo@fct.unl.pt::cc7015fd-d343-4901-b4c6-21df2d4ac7a0" providerId="AD" clId="Web-{8E64E77B-1F41-306D-81B7-0CFF242D1771}" dt="2023-03-28T16:23:35.364" v="2147" actId="1076"/>
          <ac:picMkLst>
            <pc:docMk/>
            <pc:sldMk cId="2756113789" sldId="276"/>
            <ac:picMk id="4" creationId="{92A97926-EA02-D064-965B-88B7DCDE693C}"/>
          </ac:picMkLst>
        </pc:picChg>
      </pc:sldChg>
      <pc:sldChg chg="addSp delSp modSp new">
        <pc:chgData name="Pedro Mauritti Granjo" userId="S::p.granjo@fct.unl.pt::cc7015fd-d343-4901-b4c6-21df2d4ac7a0" providerId="AD" clId="Web-{8E64E77B-1F41-306D-81B7-0CFF242D1771}" dt="2023-03-28T17:38:59.812" v="2250" actId="20577"/>
        <pc:sldMkLst>
          <pc:docMk/>
          <pc:sldMk cId="3858522254" sldId="277"/>
        </pc:sldMkLst>
        <pc:spChg chg="del">
          <ac:chgData name="Pedro Mauritti Granjo" userId="S::p.granjo@fct.unl.pt::cc7015fd-d343-4901-b4c6-21df2d4ac7a0" providerId="AD" clId="Web-{8E64E77B-1F41-306D-81B7-0CFF242D1771}" dt="2023-03-28T17:37:25.309" v="2167"/>
          <ac:spMkLst>
            <pc:docMk/>
            <pc:sldMk cId="3858522254" sldId="277"/>
            <ac:spMk id="2" creationId="{9EE19BE0-346F-CC6B-DFCE-A6926D5FDB9E}"/>
          </ac:spMkLst>
        </pc:spChg>
        <pc:spChg chg="del">
          <ac:chgData name="Pedro Mauritti Granjo" userId="S::p.granjo@fct.unl.pt::cc7015fd-d343-4901-b4c6-21df2d4ac7a0" providerId="AD" clId="Web-{8E64E77B-1F41-306D-81B7-0CFF242D1771}" dt="2023-03-28T17:37:25.918" v="2168"/>
          <ac:spMkLst>
            <pc:docMk/>
            <pc:sldMk cId="3858522254" sldId="277"/>
            <ac:spMk id="3" creationId="{3E9375E0-AEBE-E053-717C-AECCFD3E252F}"/>
          </ac:spMkLst>
        </pc:spChg>
        <pc:spChg chg="add mod">
          <ac:chgData name="Pedro Mauritti Granjo" userId="S::p.granjo@fct.unl.pt::cc7015fd-d343-4901-b4c6-21df2d4ac7a0" providerId="AD" clId="Web-{8E64E77B-1F41-306D-81B7-0CFF242D1771}" dt="2023-03-28T17:38:59.812" v="2250" actId="20577"/>
          <ac:spMkLst>
            <pc:docMk/>
            <pc:sldMk cId="3858522254" sldId="277"/>
            <ac:spMk id="6" creationId="{C22693B8-F560-C544-C8C0-FABB2C8C83D3}"/>
          </ac:spMkLst>
        </pc:spChg>
        <pc:picChg chg="add mod">
          <ac:chgData name="Pedro Mauritti Granjo" userId="S::p.granjo@fct.unl.pt::cc7015fd-d343-4901-b4c6-21df2d4ac7a0" providerId="AD" clId="Web-{8E64E77B-1F41-306D-81B7-0CFF242D1771}" dt="2023-03-28T17:37:31.184" v="2173" actId="14100"/>
          <ac:picMkLst>
            <pc:docMk/>
            <pc:sldMk cId="3858522254" sldId="277"/>
            <ac:picMk id="4" creationId="{A6181853-F0A6-FF37-14DE-A013D6D40993}"/>
          </ac:picMkLst>
        </pc:picChg>
      </pc:sldChg>
    </pc:docChg>
  </pc:docChgLst>
  <pc:docChgLst>
    <pc:chgData name="Pedro Mauritti Granjo" userId="S::p.granjo@fct.unl.pt::cc7015fd-d343-4901-b4c6-21df2d4ac7a0" providerId="AD" clId="Web-{BEBC2DFB-2510-3093-379E-71C54D083DDD}"/>
    <pc:docChg chg="delSld">
      <pc:chgData name="Pedro Mauritti Granjo" userId="S::p.granjo@fct.unl.pt::cc7015fd-d343-4901-b4c6-21df2d4ac7a0" providerId="AD" clId="Web-{BEBC2DFB-2510-3093-379E-71C54D083DDD}" dt="2023-04-14T11:28:08.151" v="8"/>
      <pc:docMkLst>
        <pc:docMk/>
      </pc:docMkLst>
      <pc:sldChg chg="del">
        <pc:chgData name="Pedro Mauritti Granjo" userId="S::p.granjo@fct.unl.pt::cc7015fd-d343-4901-b4c6-21df2d4ac7a0" providerId="AD" clId="Web-{BEBC2DFB-2510-3093-379E-71C54D083DDD}" dt="2023-04-14T11:28:04.229" v="1"/>
        <pc:sldMkLst>
          <pc:docMk/>
          <pc:sldMk cId="0" sldId="257"/>
        </pc:sldMkLst>
      </pc:sldChg>
      <pc:sldChg chg="del">
        <pc:chgData name="Pedro Mauritti Granjo" userId="S::p.granjo@fct.unl.pt::cc7015fd-d343-4901-b4c6-21df2d4ac7a0" providerId="AD" clId="Web-{BEBC2DFB-2510-3093-379E-71C54D083DDD}" dt="2023-04-14T11:28:05.339" v="3"/>
        <pc:sldMkLst>
          <pc:docMk/>
          <pc:sldMk cId="0" sldId="258"/>
        </pc:sldMkLst>
      </pc:sldChg>
      <pc:sldChg chg="del">
        <pc:chgData name="Pedro Mauritti Granjo" userId="S::p.granjo@fct.unl.pt::cc7015fd-d343-4901-b4c6-21df2d4ac7a0" providerId="AD" clId="Web-{BEBC2DFB-2510-3093-379E-71C54D083DDD}" dt="2023-04-14T11:28:05.870" v="4"/>
        <pc:sldMkLst>
          <pc:docMk/>
          <pc:sldMk cId="0" sldId="259"/>
        </pc:sldMkLst>
      </pc:sldChg>
      <pc:sldChg chg="del">
        <pc:chgData name="Pedro Mauritti Granjo" userId="S::p.granjo@fct.unl.pt::cc7015fd-d343-4901-b4c6-21df2d4ac7a0" providerId="AD" clId="Web-{BEBC2DFB-2510-3093-379E-71C54D083DDD}" dt="2023-04-14T11:28:06.510" v="5"/>
        <pc:sldMkLst>
          <pc:docMk/>
          <pc:sldMk cId="0" sldId="260"/>
        </pc:sldMkLst>
      </pc:sldChg>
      <pc:sldChg chg="del">
        <pc:chgData name="Pedro Mauritti Granjo" userId="S::p.granjo@fct.unl.pt::cc7015fd-d343-4901-b4c6-21df2d4ac7a0" providerId="AD" clId="Web-{BEBC2DFB-2510-3093-379E-71C54D083DDD}" dt="2023-04-14T11:28:06.948" v="6"/>
        <pc:sldMkLst>
          <pc:docMk/>
          <pc:sldMk cId="0" sldId="261"/>
        </pc:sldMkLst>
      </pc:sldChg>
      <pc:sldChg chg="del">
        <pc:chgData name="Pedro Mauritti Granjo" userId="S::p.granjo@fct.unl.pt::cc7015fd-d343-4901-b4c6-21df2d4ac7a0" providerId="AD" clId="Web-{BEBC2DFB-2510-3093-379E-71C54D083DDD}" dt="2023-04-14T11:28:07.432" v="7"/>
        <pc:sldMkLst>
          <pc:docMk/>
          <pc:sldMk cId="0" sldId="263"/>
        </pc:sldMkLst>
      </pc:sldChg>
      <pc:sldChg chg="del">
        <pc:chgData name="Pedro Mauritti Granjo" userId="S::p.granjo@fct.unl.pt::cc7015fd-d343-4901-b4c6-21df2d4ac7a0" providerId="AD" clId="Web-{BEBC2DFB-2510-3093-379E-71C54D083DDD}" dt="2023-04-14T11:28:08.151" v="8"/>
        <pc:sldMkLst>
          <pc:docMk/>
          <pc:sldMk cId="0" sldId="264"/>
        </pc:sldMkLst>
      </pc:sldChg>
      <pc:sldChg chg="del">
        <pc:chgData name="Pedro Mauritti Granjo" userId="S::p.granjo@fct.unl.pt::cc7015fd-d343-4901-b4c6-21df2d4ac7a0" providerId="AD" clId="Web-{BEBC2DFB-2510-3093-379E-71C54D083DDD}" dt="2023-04-14T11:28:02.870" v="0"/>
        <pc:sldMkLst>
          <pc:docMk/>
          <pc:sldMk cId="2756113789" sldId="276"/>
        </pc:sldMkLst>
      </pc:sldChg>
      <pc:sldChg chg="del">
        <pc:chgData name="Pedro Mauritti Granjo" userId="S::p.granjo@fct.unl.pt::cc7015fd-d343-4901-b4c6-21df2d4ac7a0" providerId="AD" clId="Web-{BEBC2DFB-2510-3093-379E-71C54D083DDD}" dt="2023-04-14T11:28:04.854" v="2"/>
        <pc:sldMkLst>
          <pc:docMk/>
          <pc:sldMk cId="3746764528" sldId="281"/>
        </pc:sldMkLst>
      </pc:sldChg>
    </pc:docChg>
  </pc:docChgLst>
  <pc:docChgLst>
    <pc:chgData name="Pedro Mauritti Granjo" userId="S::p.granjo@fct.unl.pt::cc7015fd-d343-4901-b4c6-21df2d4ac7a0" providerId="AD" clId="Web-{E270D960-38F2-A89C-BF0B-6F3906B17FE0}"/>
    <pc:docChg chg="modSld">
      <pc:chgData name="Pedro Mauritti Granjo" userId="S::p.granjo@fct.unl.pt::cc7015fd-d343-4901-b4c6-21df2d4ac7a0" providerId="AD" clId="Web-{E270D960-38F2-A89C-BF0B-6F3906B17FE0}" dt="2023-03-31T20:59:40.920" v="3" actId="1076"/>
      <pc:docMkLst>
        <pc:docMk/>
      </pc:docMkLst>
      <pc:sldChg chg="modSp">
        <pc:chgData name="Pedro Mauritti Granjo" userId="S::p.granjo@fct.unl.pt::cc7015fd-d343-4901-b4c6-21df2d4ac7a0" providerId="AD" clId="Web-{E270D960-38F2-A89C-BF0B-6F3906B17FE0}" dt="2023-03-31T20:59:40.920" v="3" actId="1076"/>
        <pc:sldMkLst>
          <pc:docMk/>
          <pc:sldMk cId="120033746" sldId="279"/>
        </pc:sldMkLst>
        <pc:graphicFrameChg chg="mod modGraphic">
          <ac:chgData name="Pedro Mauritti Granjo" userId="S::p.granjo@fct.unl.pt::cc7015fd-d343-4901-b4c6-21df2d4ac7a0" providerId="AD" clId="Web-{E270D960-38F2-A89C-BF0B-6F3906B17FE0}" dt="2023-03-31T20:59:40.920" v="3" actId="1076"/>
          <ac:graphicFrameMkLst>
            <pc:docMk/>
            <pc:sldMk cId="120033746" sldId="279"/>
            <ac:graphicFrameMk id="5" creationId="{90CA37FC-97AF-2170-4009-B24B8E3576CB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643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g1dc4ee23736_0_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7" name="Google Shape;137;g1dc4ee23736_0_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pt-PT" dirty="0"/>
              <a:t>Countries</a:t>
            </a:r>
            <a:endParaRPr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58750" indent="0">
              <a:buNone/>
            </a:pPr>
            <a:r>
              <a:rPr lang="pt-PT"/>
              <a:t>TIEF</a:t>
            </a:r>
            <a:endParaRPr lang="en-150"/>
          </a:p>
        </p:txBody>
      </p:sp>
    </p:spTree>
    <p:extLst>
      <p:ext uri="{BB962C8B-B14F-4D97-AF65-F5344CB8AC3E}">
        <p14:creationId xmlns:p14="http://schemas.microsoft.com/office/powerpoint/2010/main" val="18709601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g1c2276b30a0_0_4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1" name="Google Shape;131;g1c2276b30a0_0_4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233781" y="1433997"/>
            <a:ext cx="6390450" cy="3953156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36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233775" y="5458314"/>
            <a:ext cx="6390450" cy="1526489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1938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1938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1938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1938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1938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1938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1938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1938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1938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33775" y="2130314"/>
            <a:ext cx="6390450" cy="3781556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8308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8308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8308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8308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8308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8308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8308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8308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8308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33775" y="6070953"/>
            <a:ext cx="6390450" cy="2505244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316520" lvl="0" indent="-23739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633039" lvl="1" indent="-219805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949559" lvl="2" indent="-219805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266078" lvl="3" indent="-219805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1582598" lvl="4" indent="-219805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1899117" lvl="5" indent="-219805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2215637" lvl="6" indent="-219805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2532156" lvl="7" indent="-219805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2848676" lvl="8" indent="-219805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33775" y="4142378"/>
            <a:ext cx="6390450" cy="16212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2492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2492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2492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2492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2492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2492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2492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2492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2492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33775" y="857086"/>
            <a:ext cx="6390450" cy="1102978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33775" y="2219581"/>
            <a:ext cx="6390450" cy="6579733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316520" lvl="0" indent="-23739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633039" lvl="1" indent="-219805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949559" lvl="2" indent="-219805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266078" lvl="3" indent="-219805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1582598" lvl="4" indent="-219805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1899117" lvl="5" indent="-219805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2215637" lvl="6" indent="-219805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2532156" lvl="7" indent="-219805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2848676" lvl="8" indent="-219805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33775" y="857086"/>
            <a:ext cx="6390450" cy="1102978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33775" y="2219581"/>
            <a:ext cx="2999925" cy="6579733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316520" lvl="0" indent="-219805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969"/>
            </a:lvl1pPr>
            <a:lvl2pPr marL="633039" lvl="1" indent="-211013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831"/>
            </a:lvl2pPr>
            <a:lvl3pPr marL="949559" lvl="2" indent="-211013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831"/>
            </a:lvl3pPr>
            <a:lvl4pPr marL="1266078" lvl="3" indent="-211013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831"/>
            </a:lvl4pPr>
            <a:lvl5pPr marL="1582598" lvl="4" indent="-211013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831"/>
            </a:lvl5pPr>
            <a:lvl6pPr marL="1899117" lvl="5" indent="-211013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831"/>
            </a:lvl6pPr>
            <a:lvl7pPr marL="2215637" lvl="6" indent="-211013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831"/>
            </a:lvl7pPr>
            <a:lvl8pPr marL="2532156" lvl="7" indent="-211013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831"/>
            </a:lvl8pPr>
            <a:lvl9pPr marL="2848676" lvl="8" indent="-211013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831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3624300" y="2219581"/>
            <a:ext cx="2999925" cy="6579733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316520" lvl="0" indent="-219805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969"/>
            </a:lvl1pPr>
            <a:lvl2pPr marL="633039" lvl="1" indent="-211013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831"/>
            </a:lvl2pPr>
            <a:lvl3pPr marL="949559" lvl="2" indent="-211013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831"/>
            </a:lvl3pPr>
            <a:lvl4pPr marL="1266078" lvl="3" indent="-211013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831"/>
            </a:lvl4pPr>
            <a:lvl5pPr marL="1582598" lvl="4" indent="-211013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831"/>
            </a:lvl5pPr>
            <a:lvl6pPr marL="1899117" lvl="5" indent="-211013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831"/>
            </a:lvl6pPr>
            <a:lvl7pPr marL="2215637" lvl="6" indent="-211013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831"/>
            </a:lvl7pPr>
            <a:lvl8pPr marL="2532156" lvl="7" indent="-211013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831"/>
            </a:lvl8pPr>
            <a:lvl9pPr marL="2848676" lvl="8" indent="-211013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831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33775" y="857086"/>
            <a:ext cx="6390450" cy="1102978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33775" y="1070045"/>
            <a:ext cx="2106000" cy="1455422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1662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1662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1662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1662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1662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1662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1662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1662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1662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33775" y="2676267"/>
            <a:ext cx="2106000" cy="6123289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316520" lvl="0" indent="-211013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831"/>
            </a:lvl1pPr>
            <a:lvl2pPr marL="633039" lvl="1" indent="-211013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831"/>
            </a:lvl2pPr>
            <a:lvl3pPr marL="949559" lvl="2" indent="-211013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831"/>
            </a:lvl3pPr>
            <a:lvl4pPr marL="1266078" lvl="3" indent="-211013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831"/>
            </a:lvl4pPr>
            <a:lvl5pPr marL="1582598" lvl="4" indent="-211013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831"/>
            </a:lvl5pPr>
            <a:lvl6pPr marL="1899117" lvl="5" indent="-211013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831"/>
            </a:lvl6pPr>
            <a:lvl7pPr marL="2215637" lvl="6" indent="-211013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831"/>
            </a:lvl7pPr>
            <a:lvl8pPr marL="2532156" lvl="7" indent="-211013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831"/>
            </a:lvl8pPr>
            <a:lvl9pPr marL="2848676" lvl="8" indent="-211013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831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367687" y="866955"/>
            <a:ext cx="4775850" cy="7878578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3323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3323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3323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3323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3323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3323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3323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3323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3323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429000" y="-241"/>
            <a:ext cx="3429000" cy="99060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63294" tIns="63294" rIns="63294" bIns="63294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137"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199125" y="2375003"/>
            <a:ext cx="3033900" cy="28548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2908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2908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2908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2908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2908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2908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2908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2908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2908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199125" y="5398514"/>
            <a:ext cx="3033900" cy="2378711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1454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1454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1454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1454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1454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1454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1454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1454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1454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3704625" y="1394514"/>
            <a:ext cx="2877750" cy="7116489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316520" lvl="0" indent="-23739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633039" lvl="1" indent="-219805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949559" lvl="2" indent="-219805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266078" lvl="3" indent="-219805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1582598" lvl="4" indent="-219805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1899117" lvl="5" indent="-219805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2215637" lvl="6" indent="-219805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2532156" lvl="7" indent="-219805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2848676" lvl="8" indent="-219805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33775" y="8147774"/>
            <a:ext cx="4499100" cy="1165378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316520" lvl="0" indent="-15826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33775" y="857086"/>
            <a:ext cx="6390450" cy="110297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33775" y="2219581"/>
            <a:ext cx="6390450" cy="65797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6354344" y="8981011"/>
            <a:ext cx="411525" cy="7580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692">
                <a:solidFill>
                  <a:schemeClr val="dk2"/>
                </a:solidFill>
              </a:defRPr>
            </a:lvl1pPr>
            <a:lvl2pPr lvl="1" algn="r">
              <a:buNone/>
              <a:defRPr sz="692">
                <a:solidFill>
                  <a:schemeClr val="dk2"/>
                </a:solidFill>
              </a:defRPr>
            </a:lvl2pPr>
            <a:lvl3pPr lvl="2" algn="r">
              <a:buNone/>
              <a:defRPr sz="692">
                <a:solidFill>
                  <a:schemeClr val="dk2"/>
                </a:solidFill>
              </a:defRPr>
            </a:lvl3pPr>
            <a:lvl4pPr lvl="3" algn="r">
              <a:buNone/>
              <a:defRPr sz="692">
                <a:solidFill>
                  <a:schemeClr val="dk2"/>
                </a:solidFill>
              </a:defRPr>
            </a:lvl4pPr>
            <a:lvl5pPr lvl="4" algn="r">
              <a:buNone/>
              <a:defRPr sz="692">
                <a:solidFill>
                  <a:schemeClr val="dk2"/>
                </a:solidFill>
              </a:defRPr>
            </a:lvl5pPr>
            <a:lvl6pPr lvl="5" algn="r">
              <a:buNone/>
              <a:defRPr sz="692">
                <a:solidFill>
                  <a:schemeClr val="dk2"/>
                </a:solidFill>
              </a:defRPr>
            </a:lvl6pPr>
            <a:lvl7pPr lvl="6" algn="r">
              <a:buNone/>
              <a:defRPr sz="692">
                <a:solidFill>
                  <a:schemeClr val="dk2"/>
                </a:solidFill>
              </a:defRPr>
            </a:lvl7pPr>
            <a:lvl8pPr lvl="7" algn="r">
              <a:buNone/>
              <a:defRPr sz="692">
                <a:solidFill>
                  <a:schemeClr val="dk2"/>
                </a:solidFill>
              </a:defRPr>
            </a:lvl8pPr>
            <a:lvl9pPr lvl="8" algn="r">
              <a:buNone/>
              <a:defRPr sz="692">
                <a:solidFill>
                  <a:schemeClr val="dk2"/>
                </a:solidFill>
              </a:defRPr>
            </a:lvl9pPr>
          </a:lstStyle>
          <a:p>
            <a:fld id="{00000000-1234-1234-1234-123412341234}" type="slidenum">
              <a:rPr lang="pt-PT" smtClean="0"/>
              <a:pPr/>
              <a:t>‹#›</a:t>
            </a:fld>
            <a:endParaRPr lang="pt-PT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969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54;p13">
            <a:extLst>
              <a:ext uri="{FF2B5EF4-FFF2-40B4-BE49-F238E27FC236}">
                <a16:creationId xmlns:a16="http://schemas.microsoft.com/office/drawing/2014/main" id="{F75852C7-E70E-2BDC-0B24-DA113B485EC0}"/>
              </a:ext>
            </a:extLst>
          </p:cNvPr>
          <p:cNvSpPr txBox="1"/>
          <p:nvPr/>
        </p:nvSpPr>
        <p:spPr>
          <a:xfrm>
            <a:off x="113519" y="7846986"/>
            <a:ext cx="6584392" cy="4971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3294" tIns="63294" rIns="63294" bIns="63294" anchor="t" anchorCtr="0">
            <a:spAutoFit/>
          </a:bodyPr>
          <a:lstStyle/>
          <a:p>
            <a:pPr algn="just"/>
            <a:r>
              <a:rPr lang="en-US" sz="800" b="1" dirty="0">
                <a:solidFill>
                  <a:schemeClr val="tx1"/>
                </a:solidFill>
              </a:rPr>
              <a:t>Figure 1 – Visualization of the relationships among primary identified onset symptoms in All-CDG, PMM2-CDG, and non-PMM2-CDG groups using Multiple Correspondence Analysis. </a:t>
            </a:r>
            <a:r>
              <a:rPr lang="en-US" sz="800" dirty="0">
                <a:solidFill>
                  <a:schemeClr val="tx1"/>
                </a:solidFill>
              </a:rPr>
              <a:t>The dimensions of each plot account for the amount of explained variation in each dataset. </a:t>
            </a:r>
            <a:r>
              <a:rPr lang="pt-PT" sz="800" dirty="0">
                <a:solidFill>
                  <a:schemeClr val="tx1"/>
                </a:solidFill>
              </a:rPr>
              <a:t>Abbreviations: FP – Feeding Problems, Str – Strabismus, Ata – Ataxia, DD - Developmental Disability, H – Hypotonia, Sz - Seizures.</a:t>
            </a:r>
            <a:endParaRPr lang="en-US" sz="800" dirty="0">
              <a:solidFill>
                <a:schemeClr val="tx1"/>
              </a:solidFill>
            </a:endParaRPr>
          </a:p>
        </p:txBody>
      </p:sp>
      <p:pic>
        <p:nvPicPr>
          <p:cNvPr id="11" name="Picture 10" descr="A diagram of a number of data&#10;&#10;Description automatically generated with medium confidence">
            <a:extLst>
              <a:ext uri="{FF2B5EF4-FFF2-40B4-BE49-F238E27FC236}">
                <a16:creationId xmlns:a16="http://schemas.microsoft.com/office/drawing/2014/main" id="{62145F63-D2F3-6D73-9A8C-202BA37809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044" y="247479"/>
            <a:ext cx="6697911" cy="68785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67389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29E4224-92C9-1FDC-CB5B-329F664BE36F}"/>
              </a:ext>
            </a:extLst>
          </p:cNvPr>
          <p:cNvSpPr txBox="1"/>
          <p:nvPr/>
        </p:nvSpPr>
        <p:spPr>
          <a:xfrm>
            <a:off x="218497" y="8235824"/>
            <a:ext cx="627687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PT" sz="800" b="1" dirty="0"/>
              <a:t>Figure 2</a:t>
            </a:r>
            <a:r>
              <a:rPr lang="en-US" sz="800" b="1" dirty="0">
                <a:solidFill>
                  <a:schemeClr val="tx1"/>
                </a:solidFill>
              </a:rPr>
              <a:t> –</a:t>
            </a:r>
            <a:r>
              <a:rPr lang="pt-PT" sz="800" b="1" dirty="0"/>
              <a:t> Stratification of the cohort by country: Number of doctors that families consulted to raise the possibility of a CDG and between this first possibility and the definitive diagnosis. (A) </a:t>
            </a:r>
            <a:r>
              <a:rPr lang="pt-PT" sz="800" dirty="0"/>
              <a:t>Symptoms onset to raise the possibility,</a:t>
            </a:r>
            <a:r>
              <a:rPr lang="pt-PT" sz="800" b="1" dirty="0"/>
              <a:t> (B) </a:t>
            </a:r>
            <a:r>
              <a:rPr lang="pt-PT" sz="800" dirty="0"/>
              <a:t>Time from suspicion to definitive diagnosis, </a:t>
            </a:r>
            <a:r>
              <a:rPr lang="pt-PT" sz="800" b="1" dirty="0"/>
              <a:t>(C) </a:t>
            </a:r>
            <a:r>
              <a:rPr lang="pt-PT" sz="800" dirty="0"/>
              <a:t>Estimated time to definitive diagnosis, and </a:t>
            </a:r>
            <a:r>
              <a:rPr lang="pt-PT" sz="800" b="1" dirty="0"/>
              <a:t>(D) </a:t>
            </a:r>
            <a:r>
              <a:rPr lang="pt-PT" sz="800" dirty="0"/>
              <a:t>Misdiagnosis (FDR = 0.025, V = 0.24).</a:t>
            </a:r>
          </a:p>
          <a:p>
            <a:pPr algn="just"/>
            <a:r>
              <a:rPr lang="pt-PT" sz="800" dirty="0"/>
              <a:t>*Sampling Distribuition: Europe (n  = 66), North America (n = 49), Latin America (n = 34), Other Countries (n = 11).</a:t>
            </a:r>
            <a:endParaRPr lang="en-US" sz="800" dirty="0"/>
          </a:p>
        </p:txBody>
      </p:sp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716F41E9-AFFE-7259-4C56-1DEFE697B3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689392"/>
            <a:ext cx="6858000" cy="7038049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5" descr="Chart, bar chart&#10;&#10;Description automatically generated">
            <a:extLst>
              <a:ext uri="{FF2B5EF4-FFF2-40B4-BE49-F238E27FC236}">
                <a16:creationId xmlns:a16="http://schemas.microsoft.com/office/drawing/2014/main" id="{526E8A0C-232F-73E9-C49D-3261022F65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" y="933707"/>
            <a:ext cx="6748302" cy="744952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98677BE-18B6-4915-F821-A3F75D35EAB2}"/>
              </a:ext>
            </a:extLst>
          </p:cNvPr>
          <p:cNvSpPr txBox="1"/>
          <p:nvPr/>
        </p:nvSpPr>
        <p:spPr>
          <a:xfrm>
            <a:off x="151802" y="8972293"/>
            <a:ext cx="65967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PT" sz="800" b="1" dirty="0"/>
              <a:t>Figure 3</a:t>
            </a:r>
            <a:r>
              <a:rPr lang="en-US" sz="800" b="1" dirty="0">
                <a:solidFill>
                  <a:schemeClr val="tx1"/>
                </a:solidFill>
              </a:rPr>
              <a:t> –</a:t>
            </a:r>
            <a:r>
              <a:rPr lang="pt-PT" sz="800" b="1" dirty="0"/>
              <a:t> Stratification of the cohort based on normal and abnormal TIEF: Number of doctors that families consulted to raise the possibility of a CDG and between this first possibility and the definitive diagnosis. (A)</a:t>
            </a:r>
            <a:r>
              <a:rPr lang="pt-PT" sz="800" dirty="0"/>
              <a:t> Symptoms onset to raise the possibility, </a:t>
            </a:r>
            <a:r>
              <a:rPr lang="pt-PT" sz="800" b="1" dirty="0"/>
              <a:t>(B) </a:t>
            </a:r>
            <a:r>
              <a:rPr lang="pt-PT" sz="800" dirty="0"/>
              <a:t>Time from suspicion to definitive diagnosis, </a:t>
            </a:r>
            <a:r>
              <a:rPr lang="pt-PT" sz="800" b="1" dirty="0"/>
              <a:t>(C) </a:t>
            </a:r>
            <a:r>
              <a:rPr lang="pt-PT" sz="800" dirty="0"/>
              <a:t>Estimated time to definitive diagnosis,</a:t>
            </a:r>
            <a:r>
              <a:rPr lang="pt-PT" sz="800" b="1" dirty="0"/>
              <a:t> </a:t>
            </a:r>
            <a:r>
              <a:rPr lang="pt-PT" sz="800" dirty="0"/>
              <a:t>and</a:t>
            </a:r>
            <a:r>
              <a:rPr lang="pt-PT" sz="800" b="1" dirty="0"/>
              <a:t> (D) </a:t>
            </a:r>
            <a:r>
              <a:rPr lang="pt-PT" sz="800" dirty="0"/>
              <a:t>Misdiagnosis.</a:t>
            </a:r>
            <a:endParaRPr lang="en-US" sz="800" b="1" dirty="0"/>
          </a:p>
        </p:txBody>
      </p:sp>
    </p:spTree>
    <p:extLst>
      <p:ext uri="{BB962C8B-B14F-4D97-AF65-F5344CB8AC3E}">
        <p14:creationId xmlns:p14="http://schemas.microsoft.com/office/powerpoint/2010/main" val="39694173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p25"/>
          <p:cNvSpPr txBox="1"/>
          <p:nvPr/>
        </p:nvSpPr>
        <p:spPr>
          <a:xfrm>
            <a:off x="826258" y="8031256"/>
            <a:ext cx="5016693" cy="2236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3294" tIns="63294" rIns="63294" bIns="63294" anchor="t" anchorCtr="0">
            <a:spAutoFit/>
          </a:bodyPr>
          <a:lstStyle/>
          <a:p>
            <a:endParaRPr lang="pt-PT" sz="600" dirty="0"/>
          </a:p>
        </p:txBody>
      </p:sp>
      <p:pic>
        <p:nvPicPr>
          <p:cNvPr id="2" name="Picture 2" descr="Chart&#10;&#10;Description automatically generated">
            <a:extLst>
              <a:ext uri="{FF2B5EF4-FFF2-40B4-BE49-F238E27FC236}">
                <a16:creationId xmlns:a16="http://schemas.microsoft.com/office/drawing/2014/main" id="{BB6E25D3-AA72-29F1-B0CD-A4188339AF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2808" y="2041640"/>
            <a:ext cx="4486960" cy="5308249"/>
          </a:xfrm>
          <a:prstGeom prst="rect">
            <a:avLst/>
          </a:prstGeom>
        </p:spPr>
      </p:pic>
      <p:sp>
        <p:nvSpPr>
          <p:cNvPr id="4" name="Google Shape;74;p16">
            <a:extLst>
              <a:ext uri="{FF2B5EF4-FFF2-40B4-BE49-F238E27FC236}">
                <a16:creationId xmlns:a16="http://schemas.microsoft.com/office/drawing/2014/main" id="{88BE49BC-7650-F1C7-8FD3-0BBABADD6A04}"/>
              </a:ext>
            </a:extLst>
          </p:cNvPr>
          <p:cNvSpPr txBox="1"/>
          <p:nvPr/>
        </p:nvSpPr>
        <p:spPr>
          <a:xfrm>
            <a:off x="191246" y="8885200"/>
            <a:ext cx="6556323" cy="2509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3294" tIns="63294" rIns="63294" bIns="63294" anchor="t" anchorCtr="0">
            <a:spAutoFit/>
          </a:bodyPr>
          <a:lstStyle/>
          <a:p>
            <a:pPr algn="just"/>
            <a:r>
              <a:rPr lang="pt-PT" sz="800" b="1" dirty="0"/>
              <a:t>Figure 4</a:t>
            </a:r>
            <a:r>
              <a:rPr lang="en-US" sz="800" b="1" dirty="0">
                <a:solidFill>
                  <a:schemeClr val="tx1"/>
                </a:solidFill>
              </a:rPr>
              <a:t> –</a:t>
            </a:r>
            <a:r>
              <a:rPr lang="pt-PT" sz="800" b="1" dirty="0"/>
              <a:t> Main potentials of Social Media to enhance the CDG  community's quality of life. </a:t>
            </a:r>
            <a:r>
              <a:rPr lang="pt-PT" sz="800" dirty="0"/>
              <a:t>(A) Families, (B) Professionals.</a:t>
            </a:r>
            <a:endParaRPr lang="en-US" sz="8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8c6cc380-b998-4e48-8bbf-9d94856b2fd8" xsi:nil="true"/>
    <lcf76f155ced4ddcb4097134ff3c332f xmlns="2737afdf-5116-40d8-a8dd-394d6942de65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FD431AF4A72638459B1AB340E65E7CA1" ma:contentTypeVersion="15" ma:contentTypeDescription="Criar um novo documento." ma:contentTypeScope="" ma:versionID="e4a55a3466950cb8b791d0833032a75c">
  <xsd:schema xmlns:xsd="http://www.w3.org/2001/XMLSchema" xmlns:xs="http://www.w3.org/2001/XMLSchema" xmlns:p="http://schemas.microsoft.com/office/2006/metadata/properties" xmlns:ns2="2737afdf-5116-40d8-a8dd-394d6942de65" xmlns:ns3="8c6cc380-b998-4e48-8bbf-9d94856b2fd8" targetNamespace="http://schemas.microsoft.com/office/2006/metadata/properties" ma:root="true" ma:fieldsID="004b305d787db8f8f26f36f84fb3f5e2" ns2:_="" ns3:_="">
    <xsd:import namespace="2737afdf-5116-40d8-a8dd-394d6942de65"/>
    <xsd:import namespace="8c6cc380-b998-4e48-8bbf-9d94856b2fd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LengthInSeconds" minOccurs="0"/>
                <xsd:element ref="ns2:MediaServiceDateTaken" minOccurs="0"/>
                <xsd:element ref="ns2:lcf76f155ced4ddcb4097134ff3c332f" minOccurs="0"/>
                <xsd:element ref="ns3:TaxCatchAll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Location" minOccurs="0"/>
                <xsd:element ref="ns3:SharedWithUsers" minOccurs="0"/>
                <xsd:element ref="ns3:SharedWithDetail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737afdf-5116-40d8-a8dd-394d6942de6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Etiquetas de Imagem" ma:readOnly="false" ma:fieldId="{5cf76f15-5ced-4ddc-b409-7134ff3c332f}" ma:taxonomyMulti="true" ma:sspId="1fd1d16e-496a-4fbf-920e-221102f536e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9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ObjectDetectorVersions" ma:index="22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c6cc380-b998-4e48-8bbf-9d94856b2fd8" elementFormDefault="qualified">
    <xsd:import namespace="http://schemas.microsoft.com/office/2006/documentManagement/types"/>
    <xsd:import namespace="http://schemas.microsoft.com/office/infopath/2007/PartnerControls"/>
    <xsd:element name="TaxCatchAll" ma:index="15" nillable="true" ma:displayName="Taxonomy Catch All Column" ma:hidden="true" ma:list="{9546d9af-c47f-48b6-b70f-5fb2ffb94e21}" ma:internalName="TaxCatchAll" ma:showField="CatchAllData" ma:web="8c6cc380-b998-4e48-8bbf-9d94856b2fd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0" nillable="true" ma:displayName="Partilhado Com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Detalhes de Partilhado Com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ú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6581F42-5C01-4C60-ADE2-9AF6161C206C}">
  <ds:schemaRefs>
    <ds:schemaRef ds:uri="http://schemas.microsoft.com/office/2006/metadata/properties"/>
    <ds:schemaRef ds:uri="http://schemas.microsoft.com/office/infopath/2007/PartnerControls"/>
    <ds:schemaRef ds:uri="8c6cc380-b998-4e48-8bbf-9d94856b2fd8"/>
    <ds:schemaRef ds:uri="2737afdf-5116-40d8-a8dd-394d6942de65"/>
  </ds:schemaRefs>
</ds:datastoreItem>
</file>

<file path=customXml/itemProps2.xml><?xml version="1.0" encoding="utf-8"?>
<ds:datastoreItem xmlns:ds="http://schemas.openxmlformats.org/officeDocument/2006/customXml" ds:itemID="{DE759C61-E9C5-4415-844E-4CF4C4B472C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8D5B8BC-1ED0-45D9-A06F-99F5B5F3A6F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737afdf-5116-40d8-a8dd-394d6942de65"/>
    <ds:schemaRef ds:uri="8c6cc380-b998-4e48-8bbf-9d94856b2fd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277</Words>
  <Application>Microsoft Office PowerPoint</Application>
  <PresentationFormat>A4 Paper (210x297 mm)</PresentationFormat>
  <Paragraphs>7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Arial</vt:lpstr>
      <vt:lpstr>Simple Light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Pedro Mauritti Granjo</cp:lastModifiedBy>
  <cp:revision>86</cp:revision>
  <dcterms:modified xsi:type="dcterms:W3CDTF">2024-08-07T08:39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D431AF4A72638459B1AB340E65E7CA1</vt:lpwstr>
  </property>
  <property fmtid="{D5CDD505-2E9C-101B-9397-08002B2CF9AE}" pid="3" name="MediaServiceImageTags">
    <vt:lpwstr/>
  </property>
</Properties>
</file>